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92" autoAdjust="0"/>
    <p:restoredTop sz="94660"/>
  </p:normalViewPr>
  <p:slideViewPr>
    <p:cSldViewPr snapToGrid="0">
      <p:cViewPr varScale="1">
        <p:scale>
          <a:sx n="56" d="100"/>
          <a:sy n="56" d="100"/>
        </p:scale>
        <p:origin x="36" y="47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AC14E4-05FB-4645-9AD5-15BF41E04F41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F0C8C1-932A-4E5A-B95F-73A2B9D095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10683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1DA17E8B-A51E-43AB-B935-C00C24D5BE11}" type="slidenum">
              <a:rPr lang="it-IT" altLang="en-US"/>
              <a:pPr/>
              <a:t>1</a:t>
            </a:fld>
            <a:endParaRPr lang="it-IT" altLang="en-US"/>
          </a:p>
        </p:txBody>
      </p:sp>
      <p:sp>
        <p:nvSpPr>
          <p:cNvPr id="7270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879725" y="857250"/>
            <a:ext cx="4113213" cy="2314575"/>
          </a:xfrm>
          <a:ln/>
        </p:spPr>
      </p:sp>
      <p:sp>
        <p:nvSpPr>
          <p:cNvPr id="72707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291817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9A8A6D-D1FA-4C3A-B999-689CB709EB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E269E3-4CEE-46E4-8DEA-3305E53D9E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E98256-F131-4F44-A7C0-23297F785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0F2EB1-5C13-497A-87BD-4BF0D7A98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E90F25-8C84-4256-AA95-2D0E20141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5302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51D85-43D9-425E-A4AE-730366B63D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6AAA76-49B2-4339-943A-A00FA722C4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F82764-0D85-4319-88F4-51D652AC9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983F03-38BB-410B-AE2D-00A5E0E29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01C053-4C10-4889-ADC0-64171CCC1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3956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6EF0ABB-3169-4D9B-9183-BC39CCD54B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251DCD-0160-40B0-A521-672B22C5D9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8FDFFF-FD43-48A8-BCC9-10E962423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BC0DD-5665-4950-A90F-B59515E04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502CBE-80C8-40D9-AD28-793EBDF639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152511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u="sng">
                <a:latin typeface="+mn-lt"/>
              </a:defRPr>
            </a:lvl1pPr>
          </a:lstStyle>
          <a:p>
            <a:r>
              <a:rPr lang="en-US" dirty="0"/>
              <a:t>CC-BY-NC-ND Roberto Merletti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B363E4B2-0888-47DE-8A88-D22F6862BD51}" type="slidenum">
              <a:rPr lang="en-US" smtClean="0"/>
              <a:pPr/>
              <a:t>‹#›</a:t>
            </a:fld>
            <a:r>
              <a:rPr lang="en-US" dirty="0"/>
              <a:t> of 49</a:t>
            </a:r>
          </a:p>
        </p:txBody>
      </p:sp>
      <p:sp>
        <p:nvSpPr>
          <p:cNvPr id="9" name="TextBox 8"/>
          <p:cNvSpPr txBox="1"/>
          <p:nvPr userDrawn="1"/>
        </p:nvSpPr>
        <p:spPr>
          <a:xfrm>
            <a:off x="89210" y="6388071"/>
            <a:ext cx="15463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363E4B2-0888-47DE-8A88-D22F6862BD51}" type="slidenum">
              <a:rPr lang="en-US" sz="160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52</a:t>
            </a:r>
          </a:p>
        </p:txBody>
      </p:sp>
    </p:spTree>
    <p:extLst>
      <p:ext uri="{BB962C8B-B14F-4D97-AF65-F5344CB8AC3E}">
        <p14:creationId xmlns:p14="http://schemas.microsoft.com/office/powerpoint/2010/main" val="876332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7B8F63-15BC-459D-A090-F0466134EB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1549F6-EE49-4D80-B029-3F818403DD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1BDAEF-54F2-4BD1-8182-C1F9A05B4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2C0653-F4C1-40A4-A8C9-80B9FB1A6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D82576-CA74-4DDA-845F-FF6FBF8C5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3493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D21123-E8A4-4081-9EA8-2E4B5B024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4A88EB-935C-448A-A525-6FD1E79BB3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71AF7C-DA15-41A0-B59B-B4F1F7253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01CD96-7D79-4039-A066-5A52FDF95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E6B36A-3147-4C8B-8027-05AD24F8E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816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D8A3B-C27B-4B74-8FC0-5EEEA39D7D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92E359-542B-4E79-B5A6-B3D8A16EAF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BD083E-2455-4A30-872D-ABBFCB584B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DC96C4-725D-4C62-9A83-4C91050C0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8E2154-526F-4CCD-A046-9BDFE20E4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48C4A3-2F27-4C84-92E6-4898B665A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6087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DCCF96-C2AE-4DA6-8463-659D83F7B9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027F2D-F59C-45CB-9842-C859F583F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3A201F-056B-4743-9581-83C4FF85C5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9E0154-FEAB-4BD8-AC70-D1F8AFF601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02B1F2-68CB-47E3-9906-70A4B987D4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16F4214-3B7B-4FDC-B9F3-A221A415A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BDAB2B-3128-45EB-91D6-307862080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009076-9FE6-4DB2-A5D1-9FC319484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8280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30EA8-A5B5-45CC-8FED-E0C9B8DA5A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30F609-E569-4D7D-AD06-01A680243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D21FBC1-1F42-470C-AC2A-0833ECE0B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CBDE02E-DBC9-49D9-82AB-8FA468CB0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775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DF6B38F-BB7E-457D-AB5A-C413CDE61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C50CC9-6E75-43D4-84EB-470572CA8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6CCE77-F646-4E92-ABA6-53BCFFEDB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4107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7591EF-7C7B-40CF-A387-356ED4E02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4A6DB5-D206-4E07-B91B-73197FBDDA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96A205-13C0-4926-BD47-D064ABFDAF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32548F-D829-432D-9631-0DB54A304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116B86-DDF1-4F8B-AD1A-40A77F254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F800B6-37A4-4CC0-81AF-25D202E06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4895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E139BF-6A06-4AB6-853D-C52ABDB59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409483-169B-421F-9D06-AC8BCD5B4E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36B4E4-AACB-4F2B-82E0-5065D9EA9A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8FDA96-1802-49A4-94BD-A75539CCC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0A5309-3DD9-493F-A090-92C9DC9E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2088C1-8ABC-4861-84FA-118F67B7A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305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57671F-AF87-46EB-A665-A36E9216AD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8B453E-C3F6-4DE4-A355-D590FF7E81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88C83F-AD54-4BF2-8E68-3F2F49BEEC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1E99C9-E8AF-4E5D-B3FF-DE3093A0B448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98DB8D-B21F-4286-B0B2-CC909A53C9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1F4B32-CA86-4421-B11B-C82C19CC64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44F39-809F-4037-B40A-F8F182B012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9478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682" name="Group 2"/>
          <p:cNvGrpSpPr>
            <a:grpSpLocks/>
          </p:cNvGrpSpPr>
          <p:nvPr/>
        </p:nvGrpSpPr>
        <p:grpSpPr bwMode="auto">
          <a:xfrm>
            <a:off x="7329489" y="538163"/>
            <a:ext cx="1419225" cy="1039812"/>
            <a:chOff x="761" y="342"/>
            <a:chExt cx="1013" cy="794"/>
          </a:xfrm>
        </p:grpSpPr>
        <p:sp>
          <p:nvSpPr>
            <p:cNvPr id="71683" name="Freeform 3"/>
            <p:cNvSpPr>
              <a:spLocks/>
            </p:cNvSpPr>
            <p:nvPr/>
          </p:nvSpPr>
          <p:spPr bwMode="auto">
            <a:xfrm>
              <a:off x="761" y="342"/>
              <a:ext cx="1013" cy="794"/>
            </a:xfrm>
            <a:custGeom>
              <a:avLst/>
              <a:gdLst>
                <a:gd name="T0" fmla="*/ 401 w 1013"/>
                <a:gd name="T1" fmla="*/ 206 h 794"/>
                <a:gd name="T2" fmla="*/ 363 w 1013"/>
                <a:gd name="T3" fmla="*/ 251 h 794"/>
                <a:gd name="T4" fmla="*/ 327 w 1013"/>
                <a:gd name="T5" fmla="*/ 281 h 794"/>
                <a:gd name="T6" fmla="*/ 293 w 1013"/>
                <a:gd name="T7" fmla="*/ 298 h 794"/>
                <a:gd name="T8" fmla="*/ 256 w 1013"/>
                <a:gd name="T9" fmla="*/ 300 h 794"/>
                <a:gd name="T10" fmla="*/ 211 w 1013"/>
                <a:gd name="T11" fmla="*/ 293 h 794"/>
                <a:gd name="T12" fmla="*/ 0 w 1013"/>
                <a:gd name="T13" fmla="*/ 221 h 794"/>
                <a:gd name="T14" fmla="*/ 95 w 1013"/>
                <a:gd name="T15" fmla="*/ 338 h 794"/>
                <a:gd name="T16" fmla="*/ 139 w 1013"/>
                <a:gd name="T17" fmla="*/ 409 h 794"/>
                <a:gd name="T18" fmla="*/ 162 w 1013"/>
                <a:gd name="T19" fmla="*/ 460 h 794"/>
                <a:gd name="T20" fmla="*/ 176 w 1013"/>
                <a:gd name="T21" fmla="*/ 508 h 794"/>
                <a:gd name="T22" fmla="*/ 181 w 1013"/>
                <a:gd name="T23" fmla="*/ 553 h 794"/>
                <a:gd name="T24" fmla="*/ 176 w 1013"/>
                <a:gd name="T25" fmla="*/ 596 h 794"/>
                <a:gd name="T26" fmla="*/ 161 w 1013"/>
                <a:gd name="T27" fmla="*/ 637 h 794"/>
                <a:gd name="T28" fmla="*/ 136 w 1013"/>
                <a:gd name="T29" fmla="*/ 677 h 794"/>
                <a:gd name="T30" fmla="*/ 102 w 1013"/>
                <a:gd name="T31" fmla="*/ 715 h 794"/>
                <a:gd name="T32" fmla="*/ 137 w 1013"/>
                <a:gd name="T33" fmla="*/ 696 h 794"/>
                <a:gd name="T34" fmla="*/ 210 w 1013"/>
                <a:gd name="T35" fmla="*/ 662 h 794"/>
                <a:gd name="T36" fmla="*/ 281 w 1013"/>
                <a:gd name="T37" fmla="*/ 647 h 794"/>
                <a:gd name="T38" fmla="*/ 349 w 1013"/>
                <a:gd name="T39" fmla="*/ 644 h 794"/>
                <a:gd name="T40" fmla="*/ 414 w 1013"/>
                <a:gd name="T41" fmla="*/ 654 h 794"/>
                <a:gd name="T42" fmla="*/ 474 w 1013"/>
                <a:gd name="T43" fmla="*/ 671 h 794"/>
                <a:gd name="T44" fmla="*/ 529 w 1013"/>
                <a:gd name="T45" fmla="*/ 695 h 794"/>
                <a:gd name="T46" fmla="*/ 645 w 1013"/>
                <a:gd name="T47" fmla="*/ 766 h 794"/>
                <a:gd name="T48" fmla="*/ 663 w 1013"/>
                <a:gd name="T49" fmla="*/ 744 h 794"/>
                <a:gd name="T50" fmla="*/ 649 w 1013"/>
                <a:gd name="T51" fmla="*/ 678 h 794"/>
                <a:gd name="T52" fmla="*/ 652 w 1013"/>
                <a:gd name="T53" fmla="*/ 624 h 794"/>
                <a:gd name="T54" fmla="*/ 670 w 1013"/>
                <a:gd name="T55" fmla="*/ 580 h 794"/>
                <a:gd name="T56" fmla="*/ 698 w 1013"/>
                <a:gd name="T57" fmla="*/ 545 h 794"/>
                <a:gd name="T58" fmla="*/ 739 w 1013"/>
                <a:gd name="T59" fmla="*/ 515 h 794"/>
                <a:gd name="T60" fmla="*/ 787 w 1013"/>
                <a:gd name="T61" fmla="*/ 491 h 794"/>
                <a:gd name="T62" fmla="*/ 937 w 1013"/>
                <a:gd name="T63" fmla="*/ 442 h 794"/>
                <a:gd name="T64" fmla="*/ 949 w 1013"/>
                <a:gd name="T65" fmla="*/ 426 h 794"/>
                <a:gd name="T66" fmla="*/ 863 w 1013"/>
                <a:gd name="T67" fmla="*/ 427 h 794"/>
                <a:gd name="T68" fmla="*/ 788 w 1013"/>
                <a:gd name="T69" fmla="*/ 420 h 794"/>
                <a:gd name="T70" fmla="*/ 724 w 1013"/>
                <a:gd name="T71" fmla="*/ 404 h 794"/>
                <a:gd name="T72" fmla="*/ 671 w 1013"/>
                <a:gd name="T73" fmla="*/ 378 h 794"/>
                <a:gd name="T74" fmla="*/ 629 w 1013"/>
                <a:gd name="T75" fmla="*/ 343 h 794"/>
                <a:gd name="T76" fmla="*/ 595 w 1013"/>
                <a:gd name="T77" fmla="*/ 296 h 794"/>
                <a:gd name="T78" fmla="*/ 571 w 1013"/>
                <a:gd name="T79" fmla="*/ 240 h 794"/>
                <a:gd name="T80" fmla="*/ 556 w 1013"/>
                <a:gd name="T81" fmla="*/ 172 h 794"/>
                <a:gd name="T82" fmla="*/ 549 w 1013"/>
                <a:gd name="T83" fmla="*/ 91 h 794"/>
                <a:gd name="T84" fmla="*/ 551 w 1013"/>
                <a:gd name="T85" fmla="*/ 0 h 7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013" h="794">
                  <a:moveTo>
                    <a:pt x="551" y="0"/>
                  </a:moveTo>
                  <a:lnTo>
                    <a:pt x="465" y="120"/>
                  </a:lnTo>
                  <a:lnTo>
                    <a:pt x="401" y="206"/>
                  </a:lnTo>
                  <a:lnTo>
                    <a:pt x="387" y="224"/>
                  </a:lnTo>
                  <a:lnTo>
                    <a:pt x="375" y="239"/>
                  </a:lnTo>
                  <a:lnTo>
                    <a:pt x="363" y="251"/>
                  </a:lnTo>
                  <a:lnTo>
                    <a:pt x="350" y="263"/>
                  </a:lnTo>
                  <a:lnTo>
                    <a:pt x="339" y="273"/>
                  </a:lnTo>
                  <a:lnTo>
                    <a:pt x="327" y="281"/>
                  </a:lnTo>
                  <a:lnTo>
                    <a:pt x="316" y="288"/>
                  </a:lnTo>
                  <a:lnTo>
                    <a:pt x="305" y="293"/>
                  </a:lnTo>
                  <a:lnTo>
                    <a:pt x="293" y="298"/>
                  </a:lnTo>
                  <a:lnTo>
                    <a:pt x="282" y="299"/>
                  </a:lnTo>
                  <a:lnTo>
                    <a:pt x="270" y="300"/>
                  </a:lnTo>
                  <a:lnTo>
                    <a:pt x="256" y="300"/>
                  </a:lnTo>
                  <a:lnTo>
                    <a:pt x="242" y="299"/>
                  </a:lnTo>
                  <a:lnTo>
                    <a:pt x="227" y="296"/>
                  </a:lnTo>
                  <a:lnTo>
                    <a:pt x="211" y="293"/>
                  </a:lnTo>
                  <a:lnTo>
                    <a:pt x="195" y="288"/>
                  </a:lnTo>
                  <a:lnTo>
                    <a:pt x="111" y="261"/>
                  </a:lnTo>
                  <a:lnTo>
                    <a:pt x="0" y="221"/>
                  </a:lnTo>
                  <a:lnTo>
                    <a:pt x="35" y="262"/>
                  </a:lnTo>
                  <a:lnTo>
                    <a:pt x="66" y="300"/>
                  </a:lnTo>
                  <a:lnTo>
                    <a:pt x="95" y="338"/>
                  </a:lnTo>
                  <a:lnTo>
                    <a:pt x="120" y="374"/>
                  </a:lnTo>
                  <a:lnTo>
                    <a:pt x="129" y="392"/>
                  </a:lnTo>
                  <a:lnTo>
                    <a:pt x="139" y="409"/>
                  </a:lnTo>
                  <a:lnTo>
                    <a:pt x="148" y="427"/>
                  </a:lnTo>
                  <a:lnTo>
                    <a:pt x="155" y="444"/>
                  </a:lnTo>
                  <a:lnTo>
                    <a:pt x="162" y="460"/>
                  </a:lnTo>
                  <a:lnTo>
                    <a:pt x="167" y="476"/>
                  </a:lnTo>
                  <a:lnTo>
                    <a:pt x="173" y="493"/>
                  </a:lnTo>
                  <a:lnTo>
                    <a:pt x="176" y="508"/>
                  </a:lnTo>
                  <a:lnTo>
                    <a:pt x="178" y="523"/>
                  </a:lnTo>
                  <a:lnTo>
                    <a:pt x="180" y="538"/>
                  </a:lnTo>
                  <a:lnTo>
                    <a:pt x="181" y="553"/>
                  </a:lnTo>
                  <a:lnTo>
                    <a:pt x="180" y="568"/>
                  </a:lnTo>
                  <a:lnTo>
                    <a:pt x="178" y="583"/>
                  </a:lnTo>
                  <a:lnTo>
                    <a:pt x="176" y="596"/>
                  </a:lnTo>
                  <a:lnTo>
                    <a:pt x="172" y="610"/>
                  </a:lnTo>
                  <a:lnTo>
                    <a:pt x="167" y="624"/>
                  </a:lnTo>
                  <a:lnTo>
                    <a:pt x="161" y="637"/>
                  </a:lnTo>
                  <a:lnTo>
                    <a:pt x="154" y="651"/>
                  </a:lnTo>
                  <a:lnTo>
                    <a:pt x="146" y="665"/>
                  </a:lnTo>
                  <a:lnTo>
                    <a:pt x="136" y="677"/>
                  </a:lnTo>
                  <a:lnTo>
                    <a:pt x="126" y="691"/>
                  </a:lnTo>
                  <a:lnTo>
                    <a:pt x="114" y="703"/>
                  </a:lnTo>
                  <a:lnTo>
                    <a:pt x="102" y="715"/>
                  </a:lnTo>
                  <a:lnTo>
                    <a:pt x="88" y="727"/>
                  </a:lnTo>
                  <a:lnTo>
                    <a:pt x="113" y="711"/>
                  </a:lnTo>
                  <a:lnTo>
                    <a:pt x="137" y="696"/>
                  </a:lnTo>
                  <a:lnTo>
                    <a:pt x="162" y="682"/>
                  </a:lnTo>
                  <a:lnTo>
                    <a:pt x="187" y="671"/>
                  </a:lnTo>
                  <a:lnTo>
                    <a:pt x="210" y="662"/>
                  </a:lnTo>
                  <a:lnTo>
                    <a:pt x="234" y="655"/>
                  </a:lnTo>
                  <a:lnTo>
                    <a:pt x="257" y="650"/>
                  </a:lnTo>
                  <a:lnTo>
                    <a:pt x="281" y="647"/>
                  </a:lnTo>
                  <a:lnTo>
                    <a:pt x="304" y="644"/>
                  </a:lnTo>
                  <a:lnTo>
                    <a:pt x="327" y="644"/>
                  </a:lnTo>
                  <a:lnTo>
                    <a:pt x="349" y="644"/>
                  </a:lnTo>
                  <a:lnTo>
                    <a:pt x="371" y="647"/>
                  </a:lnTo>
                  <a:lnTo>
                    <a:pt x="393" y="650"/>
                  </a:lnTo>
                  <a:lnTo>
                    <a:pt x="414" y="654"/>
                  </a:lnTo>
                  <a:lnTo>
                    <a:pt x="435" y="659"/>
                  </a:lnTo>
                  <a:lnTo>
                    <a:pt x="454" y="665"/>
                  </a:lnTo>
                  <a:lnTo>
                    <a:pt x="474" y="671"/>
                  </a:lnTo>
                  <a:lnTo>
                    <a:pt x="494" y="678"/>
                  </a:lnTo>
                  <a:lnTo>
                    <a:pt x="511" y="686"/>
                  </a:lnTo>
                  <a:lnTo>
                    <a:pt x="529" y="695"/>
                  </a:lnTo>
                  <a:lnTo>
                    <a:pt x="563" y="712"/>
                  </a:lnTo>
                  <a:lnTo>
                    <a:pt x="593" y="732"/>
                  </a:lnTo>
                  <a:lnTo>
                    <a:pt x="645" y="766"/>
                  </a:lnTo>
                  <a:lnTo>
                    <a:pt x="683" y="794"/>
                  </a:lnTo>
                  <a:lnTo>
                    <a:pt x="672" y="768"/>
                  </a:lnTo>
                  <a:lnTo>
                    <a:pt x="663" y="744"/>
                  </a:lnTo>
                  <a:lnTo>
                    <a:pt x="656" y="721"/>
                  </a:lnTo>
                  <a:lnTo>
                    <a:pt x="652" y="699"/>
                  </a:lnTo>
                  <a:lnTo>
                    <a:pt x="649" y="678"/>
                  </a:lnTo>
                  <a:lnTo>
                    <a:pt x="648" y="659"/>
                  </a:lnTo>
                  <a:lnTo>
                    <a:pt x="649" y="640"/>
                  </a:lnTo>
                  <a:lnTo>
                    <a:pt x="652" y="624"/>
                  </a:lnTo>
                  <a:lnTo>
                    <a:pt x="656" y="609"/>
                  </a:lnTo>
                  <a:lnTo>
                    <a:pt x="661" y="594"/>
                  </a:lnTo>
                  <a:lnTo>
                    <a:pt x="670" y="580"/>
                  </a:lnTo>
                  <a:lnTo>
                    <a:pt x="678" y="566"/>
                  </a:lnTo>
                  <a:lnTo>
                    <a:pt x="687" y="555"/>
                  </a:lnTo>
                  <a:lnTo>
                    <a:pt x="698" y="545"/>
                  </a:lnTo>
                  <a:lnTo>
                    <a:pt x="712" y="534"/>
                  </a:lnTo>
                  <a:lnTo>
                    <a:pt x="724" y="524"/>
                  </a:lnTo>
                  <a:lnTo>
                    <a:pt x="739" y="515"/>
                  </a:lnTo>
                  <a:lnTo>
                    <a:pt x="754" y="506"/>
                  </a:lnTo>
                  <a:lnTo>
                    <a:pt x="771" y="498"/>
                  </a:lnTo>
                  <a:lnTo>
                    <a:pt x="787" y="491"/>
                  </a:lnTo>
                  <a:lnTo>
                    <a:pt x="822" y="478"/>
                  </a:lnTo>
                  <a:lnTo>
                    <a:pt x="861" y="465"/>
                  </a:lnTo>
                  <a:lnTo>
                    <a:pt x="937" y="442"/>
                  </a:lnTo>
                  <a:lnTo>
                    <a:pt x="1013" y="419"/>
                  </a:lnTo>
                  <a:lnTo>
                    <a:pt x="981" y="423"/>
                  </a:lnTo>
                  <a:lnTo>
                    <a:pt x="949" y="426"/>
                  </a:lnTo>
                  <a:lnTo>
                    <a:pt x="919" y="427"/>
                  </a:lnTo>
                  <a:lnTo>
                    <a:pt x="891" y="427"/>
                  </a:lnTo>
                  <a:lnTo>
                    <a:pt x="863" y="427"/>
                  </a:lnTo>
                  <a:lnTo>
                    <a:pt x="837" y="426"/>
                  </a:lnTo>
                  <a:lnTo>
                    <a:pt x="813" y="423"/>
                  </a:lnTo>
                  <a:lnTo>
                    <a:pt x="788" y="420"/>
                  </a:lnTo>
                  <a:lnTo>
                    <a:pt x="766" y="416"/>
                  </a:lnTo>
                  <a:lnTo>
                    <a:pt x="745" y="411"/>
                  </a:lnTo>
                  <a:lnTo>
                    <a:pt x="724" y="404"/>
                  </a:lnTo>
                  <a:lnTo>
                    <a:pt x="706" y="397"/>
                  </a:lnTo>
                  <a:lnTo>
                    <a:pt x="689" y="388"/>
                  </a:lnTo>
                  <a:lnTo>
                    <a:pt x="671" y="378"/>
                  </a:lnTo>
                  <a:lnTo>
                    <a:pt x="656" y="367"/>
                  </a:lnTo>
                  <a:lnTo>
                    <a:pt x="641" y="356"/>
                  </a:lnTo>
                  <a:lnTo>
                    <a:pt x="629" y="343"/>
                  </a:lnTo>
                  <a:lnTo>
                    <a:pt x="616" y="329"/>
                  </a:lnTo>
                  <a:lnTo>
                    <a:pt x="605" y="313"/>
                  </a:lnTo>
                  <a:lnTo>
                    <a:pt x="595" y="296"/>
                  </a:lnTo>
                  <a:lnTo>
                    <a:pt x="586" y="278"/>
                  </a:lnTo>
                  <a:lnTo>
                    <a:pt x="578" y="259"/>
                  </a:lnTo>
                  <a:lnTo>
                    <a:pt x="571" y="240"/>
                  </a:lnTo>
                  <a:lnTo>
                    <a:pt x="564" y="218"/>
                  </a:lnTo>
                  <a:lnTo>
                    <a:pt x="559" y="195"/>
                  </a:lnTo>
                  <a:lnTo>
                    <a:pt x="556" y="172"/>
                  </a:lnTo>
                  <a:lnTo>
                    <a:pt x="552" y="146"/>
                  </a:lnTo>
                  <a:lnTo>
                    <a:pt x="551" y="120"/>
                  </a:lnTo>
                  <a:lnTo>
                    <a:pt x="549" y="91"/>
                  </a:lnTo>
                  <a:lnTo>
                    <a:pt x="549" y="63"/>
                  </a:lnTo>
                  <a:lnTo>
                    <a:pt x="549" y="33"/>
                  </a:lnTo>
                  <a:lnTo>
                    <a:pt x="551" y="0"/>
                  </a:lnTo>
                  <a:close/>
                </a:path>
              </a:pathLst>
            </a:custGeom>
            <a:solidFill>
              <a:srgbClr val="FFF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it-IT"/>
            </a:p>
          </p:txBody>
        </p:sp>
        <p:sp>
          <p:nvSpPr>
            <p:cNvPr id="71684" name="Freeform 4"/>
            <p:cNvSpPr>
              <a:spLocks/>
            </p:cNvSpPr>
            <p:nvPr/>
          </p:nvSpPr>
          <p:spPr bwMode="auto">
            <a:xfrm>
              <a:off x="1110" y="721"/>
              <a:ext cx="176" cy="177"/>
            </a:xfrm>
            <a:custGeom>
              <a:avLst/>
              <a:gdLst>
                <a:gd name="T0" fmla="*/ 97 w 176"/>
                <a:gd name="T1" fmla="*/ 177 h 177"/>
                <a:gd name="T2" fmla="*/ 115 w 176"/>
                <a:gd name="T3" fmla="*/ 172 h 177"/>
                <a:gd name="T4" fmla="*/ 130 w 176"/>
                <a:gd name="T5" fmla="*/ 166 h 177"/>
                <a:gd name="T6" fmla="*/ 145 w 176"/>
                <a:gd name="T7" fmla="*/ 156 h 177"/>
                <a:gd name="T8" fmla="*/ 156 w 176"/>
                <a:gd name="T9" fmla="*/ 145 h 177"/>
                <a:gd name="T10" fmla="*/ 165 w 176"/>
                <a:gd name="T11" fmla="*/ 130 h 177"/>
                <a:gd name="T12" fmla="*/ 172 w 176"/>
                <a:gd name="T13" fmla="*/ 115 h 177"/>
                <a:gd name="T14" fmla="*/ 176 w 176"/>
                <a:gd name="T15" fmla="*/ 97 h 177"/>
                <a:gd name="T16" fmla="*/ 176 w 176"/>
                <a:gd name="T17" fmla="*/ 80 h 177"/>
                <a:gd name="T18" fmla="*/ 172 w 176"/>
                <a:gd name="T19" fmla="*/ 62 h 177"/>
                <a:gd name="T20" fmla="*/ 165 w 176"/>
                <a:gd name="T21" fmla="*/ 47 h 177"/>
                <a:gd name="T22" fmla="*/ 156 w 176"/>
                <a:gd name="T23" fmla="*/ 32 h 177"/>
                <a:gd name="T24" fmla="*/ 145 w 176"/>
                <a:gd name="T25" fmla="*/ 20 h 177"/>
                <a:gd name="T26" fmla="*/ 130 w 176"/>
                <a:gd name="T27" fmla="*/ 10 h 177"/>
                <a:gd name="T28" fmla="*/ 115 w 176"/>
                <a:gd name="T29" fmla="*/ 3 h 177"/>
                <a:gd name="T30" fmla="*/ 97 w 176"/>
                <a:gd name="T31" fmla="*/ 0 h 177"/>
                <a:gd name="T32" fmla="*/ 79 w 176"/>
                <a:gd name="T33" fmla="*/ 0 h 177"/>
                <a:gd name="T34" fmla="*/ 62 w 176"/>
                <a:gd name="T35" fmla="*/ 3 h 177"/>
                <a:gd name="T36" fmla="*/ 47 w 176"/>
                <a:gd name="T37" fmla="*/ 10 h 177"/>
                <a:gd name="T38" fmla="*/ 32 w 176"/>
                <a:gd name="T39" fmla="*/ 20 h 177"/>
                <a:gd name="T40" fmla="*/ 19 w 176"/>
                <a:gd name="T41" fmla="*/ 32 h 177"/>
                <a:gd name="T42" fmla="*/ 10 w 176"/>
                <a:gd name="T43" fmla="*/ 47 h 177"/>
                <a:gd name="T44" fmla="*/ 3 w 176"/>
                <a:gd name="T45" fmla="*/ 62 h 177"/>
                <a:gd name="T46" fmla="*/ 0 w 176"/>
                <a:gd name="T47" fmla="*/ 80 h 177"/>
                <a:gd name="T48" fmla="*/ 0 w 176"/>
                <a:gd name="T49" fmla="*/ 97 h 177"/>
                <a:gd name="T50" fmla="*/ 3 w 176"/>
                <a:gd name="T51" fmla="*/ 115 h 177"/>
                <a:gd name="T52" fmla="*/ 10 w 176"/>
                <a:gd name="T53" fmla="*/ 130 h 177"/>
                <a:gd name="T54" fmla="*/ 19 w 176"/>
                <a:gd name="T55" fmla="*/ 145 h 177"/>
                <a:gd name="T56" fmla="*/ 32 w 176"/>
                <a:gd name="T57" fmla="*/ 156 h 177"/>
                <a:gd name="T58" fmla="*/ 47 w 176"/>
                <a:gd name="T59" fmla="*/ 166 h 177"/>
                <a:gd name="T60" fmla="*/ 62 w 176"/>
                <a:gd name="T61" fmla="*/ 172 h 177"/>
                <a:gd name="T62" fmla="*/ 79 w 176"/>
                <a:gd name="T63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176" h="177">
                  <a:moveTo>
                    <a:pt x="87" y="177"/>
                  </a:moveTo>
                  <a:lnTo>
                    <a:pt x="97" y="177"/>
                  </a:lnTo>
                  <a:lnTo>
                    <a:pt x="105" y="175"/>
                  </a:lnTo>
                  <a:lnTo>
                    <a:pt x="115" y="172"/>
                  </a:lnTo>
                  <a:lnTo>
                    <a:pt x="123" y="170"/>
                  </a:lnTo>
                  <a:lnTo>
                    <a:pt x="130" y="166"/>
                  </a:lnTo>
                  <a:lnTo>
                    <a:pt x="138" y="162"/>
                  </a:lnTo>
                  <a:lnTo>
                    <a:pt x="145" y="156"/>
                  </a:lnTo>
                  <a:lnTo>
                    <a:pt x="150" y="151"/>
                  </a:lnTo>
                  <a:lnTo>
                    <a:pt x="156" y="145"/>
                  </a:lnTo>
                  <a:lnTo>
                    <a:pt x="161" y="138"/>
                  </a:lnTo>
                  <a:lnTo>
                    <a:pt x="165" y="130"/>
                  </a:lnTo>
                  <a:lnTo>
                    <a:pt x="169" y="123"/>
                  </a:lnTo>
                  <a:lnTo>
                    <a:pt x="172" y="115"/>
                  </a:lnTo>
                  <a:lnTo>
                    <a:pt x="175" y="106"/>
                  </a:lnTo>
                  <a:lnTo>
                    <a:pt x="176" y="97"/>
                  </a:lnTo>
                  <a:lnTo>
                    <a:pt x="176" y="88"/>
                  </a:lnTo>
                  <a:lnTo>
                    <a:pt x="176" y="80"/>
                  </a:lnTo>
                  <a:lnTo>
                    <a:pt x="175" y="70"/>
                  </a:lnTo>
                  <a:lnTo>
                    <a:pt x="172" y="62"/>
                  </a:lnTo>
                  <a:lnTo>
                    <a:pt x="169" y="54"/>
                  </a:lnTo>
                  <a:lnTo>
                    <a:pt x="165" y="47"/>
                  </a:lnTo>
                  <a:lnTo>
                    <a:pt x="161" y="39"/>
                  </a:lnTo>
                  <a:lnTo>
                    <a:pt x="156" y="32"/>
                  </a:lnTo>
                  <a:lnTo>
                    <a:pt x="150" y="26"/>
                  </a:lnTo>
                  <a:lnTo>
                    <a:pt x="145" y="20"/>
                  </a:lnTo>
                  <a:lnTo>
                    <a:pt x="138" y="15"/>
                  </a:lnTo>
                  <a:lnTo>
                    <a:pt x="130" y="10"/>
                  </a:lnTo>
                  <a:lnTo>
                    <a:pt x="123" y="7"/>
                  </a:lnTo>
                  <a:lnTo>
                    <a:pt x="115" y="3"/>
                  </a:lnTo>
                  <a:lnTo>
                    <a:pt x="105" y="2"/>
                  </a:lnTo>
                  <a:lnTo>
                    <a:pt x="97" y="0"/>
                  </a:lnTo>
                  <a:lnTo>
                    <a:pt x="87" y="0"/>
                  </a:lnTo>
                  <a:lnTo>
                    <a:pt x="79" y="0"/>
                  </a:lnTo>
                  <a:lnTo>
                    <a:pt x="70" y="2"/>
                  </a:lnTo>
                  <a:lnTo>
                    <a:pt x="62" y="3"/>
                  </a:lnTo>
                  <a:lnTo>
                    <a:pt x="53" y="7"/>
                  </a:lnTo>
                  <a:lnTo>
                    <a:pt x="47" y="10"/>
                  </a:lnTo>
                  <a:lnTo>
                    <a:pt x="38" y="15"/>
                  </a:lnTo>
                  <a:lnTo>
                    <a:pt x="32" y="20"/>
                  </a:lnTo>
                  <a:lnTo>
                    <a:pt x="26" y="26"/>
                  </a:lnTo>
                  <a:lnTo>
                    <a:pt x="19" y="32"/>
                  </a:lnTo>
                  <a:lnTo>
                    <a:pt x="15" y="39"/>
                  </a:lnTo>
                  <a:lnTo>
                    <a:pt x="10" y="47"/>
                  </a:lnTo>
                  <a:lnTo>
                    <a:pt x="7" y="54"/>
                  </a:lnTo>
                  <a:lnTo>
                    <a:pt x="3" y="62"/>
                  </a:lnTo>
                  <a:lnTo>
                    <a:pt x="2" y="70"/>
                  </a:lnTo>
                  <a:lnTo>
                    <a:pt x="0" y="80"/>
                  </a:lnTo>
                  <a:lnTo>
                    <a:pt x="0" y="88"/>
                  </a:lnTo>
                  <a:lnTo>
                    <a:pt x="0" y="97"/>
                  </a:lnTo>
                  <a:lnTo>
                    <a:pt x="2" y="106"/>
                  </a:lnTo>
                  <a:lnTo>
                    <a:pt x="3" y="115"/>
                  </a:lnTo>
                  <a:lnTo>
                    <a:pt x="7" y="123"/>
                  </a:lnTo>
                  <a:lnTo>
                    <a:pt x="10" y="130"/>
                  </a:lnTo>
                  <a:lnTo>
                    <a:pt x="15" y="138"/>
                  </a:lnTo>
                  <a:lnTo>
                    <a:pt x="19" y="145"/>
                  </a:lnTo>
                  <a:lnTo>
                    <a:pt x="26" y="151"/>
                  </a:lnTo>
                  <a:lnTo>
                    <a:pt x="32" y="156"/>
                  </a:lnTo>
                  <a:lnTo>
                    <a:pt x="38" y="162"/>
                  </a:lnTo>
                  <a:lnTo>
                    <a:pt x="47" y="166"/>
                  </a:lnTo>
                  <a:lnTo>
                    <a:pt x="53" y="170"/>
                  </a:lnTo>
                  <a:lnTo>
                    <a:pt x="62" y="172"/>
                  </a:lnTo>
                  <a:lnTo>
                    <a:pt x="70" y="175"/>
                  </a:lnTo>
                  <a:lnTo>
                    <a:pt x="79" y="177"/>
                  </a:lnTo>
                  <a:lnTo>
                    <a:pt x="87" y="17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it-IT"/>
            </a:p>
          </p:txBody>
        </p:sp>
      </p:grpSp>
      <p:sp>
        <p:nvSpPr>
          <p:cNvPr id="71685" name="Text Box 5"/>
          <p:cNvSpPr txBox="1">
            <a:spLocks noChangeArrowheads="1"/>
          </p:cNvSpPr>
          <p:nvPr/>
        </p:nvSpPr>
        <p:spPr bwMode="auto">
          <a:xfrm>
            <a:off x="6793946" y="1317747"/>
            <a:ext cx="60144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0" hangingPunct="0"/>
            <a:r>
              <a:rPr lang="de-DE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xon</a:t>
            </a:r>
          </a:p>
        </p:txBody>
      </p:sp>
      <p:sp>
        <p:nvSpPr>
          <p:cNvPr id="71686" name="Freeform 6"/>
          <p:cNvSpPr>
            <a:spLocks/>
          </p:cNvSpPr>
          <p:nvPr/>
        </p:nvSpPr>
        <p:spPr bwMode="auto">
          <a:xfrm>
            <a:off x="6711950" y="4210050"/>
            <a:ext cx="101600" cy="387350"/>
          </a:xfrm>
          <a:custGeom>
            <a:avLst/>
            <a:gdLst>
              <a:gd name="T0" fmla="*/ 0 w 70"/>
              <a:gd name="T1" fmla="*/ 0 h 291"/>
              <a:gd name="T2" fmla="*/ 61 w 70"/>
              <a:gd name="T3" fmla="*/ 106 h 291"/>
              <a:gd name="T4" fmla="*/ 52 w 70"/>
              <a:gd name="T5" fmla="*/ 230 h 291"/>
              <a:gd name="T6" fmla="*/ 0 w 70"/>
              <a:gd name="T7" fmla="*/ 291 h 2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291">
                <a:moveTo>
                  <a:pt x="0" y="0"/>
                </a:moveTo>
                <a:cubicBezTo>
                  <a:pt x="26" y="34"/>
                  <a:pt x="52" y="68"/>
                  <a:pt x="61" y="106"/>
                </a:cubicBezTo>
                <a:cubicBezTo>
                  <a:pt x="70" y="144"/>
                  <a:pt x="62" y="199"/>
                  <a:pt x="52" y="230"/>
                </a:cubicBezTo>
                <a:cubicBezTo>
                  <a:pt x="42" y="261"/>
                  <a:pt x="10" y="282"/>
                  <a:pt x="0" y="291"/>
                </a:cubicBezTo>
              </a:path>
            </a:pathLst>
          </a:custGeom>
          <a:noFill/>
          <a:ln w="57150" cmpd="sng">
            <a:solidFill>
              <a:srgbClr val="00FF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grpSp>
        <p:nvGrpSpPr>
          <p:cNvPr id="71687" name="Group 7"/>
          <p:cNvGrpSpPr>
            <a:grpSpLocks/>
          </p:cNvGrpSpPr>
          <p:nvPr/>
        </p:nvGrpSpPr>
        <p:grpSpPr bwMode="auto">
          <a:xfrm>
            <a:off x="6794501" y="1714500"/>
            <a:ext cx="314325" cy="420688"/>
            <a:chOff x="2265" y="700"/>
            <a:chExt cx="292" cy="447"/>
          </a:xfrm>
        </p:grpSpPr>
        <p:grpSp>
          <p:nvGrpSpPr>
            <p:cNvPr id="71688" name="Group 8"/>
            <p:cNvGrpSpPr>
              <a:grpSpLocks/>
            </p:cNvGrpSpPr>
            <p:nvPr/>
          </p:nvGrpSpPr>
          <p:grpSpPr bwMode="auto">
            <a:xfrm rot="7354836">
              <a:off x="2299" y="890"/>
              <a:ext cx="375" cy="140"/>
              <a:chOff x="477" y="3679"/>
              <a:chExt cx="1067" cy="344"/>
            </a:xfrm>
          </p:grpSpPr>
          <p:sp>
            <p:nvSpPr>
              <p:cNvPr id="71689" name="Oval 9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690" name="Rectangle 10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691" name="Group 11"/>
            <p:cNvGrpSpPr>
              <a:grpSpLocks/>
            </p:cNvGrpSpPr>
            <p:nvPr/>
          </p:nvGrpSpPr>
          <p:grpSpPr bwMode="auto">
            <a:xfrm rot="-3493529">
              <a:off x="2151" y="814"/>
              <a:ext cx="376" cy="147"/>
              <a:chOff x="477" y="3679"/>
              <a:chExt cx="1067" cy="344"/>
            </a:xfrm>
          </p:grpSpPr>
          <p:sp>
            <p:nvSpPr>
              <p:cNvPr id="71692" name="Oval 12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693" name="Rectangle 13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grpSp>
        <p:nvGrpSpPr>
          <p:cNvPr id="71694" name="Group 14"/>
          <p:cNvGrpSpPr>
            <a:grpSpLocks/>
          </p:cNvGrpSpPr>
          <p:nvPr/>
        </p:nvGrpSpPr>
        <p:grpSpPr bwMode="auto">
          <a:xfrm rot="243875">
            <a:off x="6580189" y="2187576"/>
            <a:ext cx="293687" cy="377825"/>
            <a:chOff x="2121" y="1129"/>
            <a:chExt cx="282" cy="411"/>
          </a:xfrm>
        </p:grpSpPr>
        <p:grpSp>
          <p:nvGrpSpPr>
            <p:cNvPr id="71695" name="Group 15"/>
            <p:cNvGrpSpPr>
              <a:grpSpLocks/>
            </p:cNvGrpSpPr>
            <p:nvPr/>
          </p:nvGrpSpPr>
          <p:grpSpPr bwMode="auto">
            <a:xfrm rot="5931601">
              <a:off x="2141" y="1278"/>
              <a:ext cx="379" cy="145"/>
              <a:chOff x="477" y="3679"/>
              <a:chExt cx="1067" cy="344"/>
            </a:xfrm>
          </p:grpSpPr>
          <p:sp>
            <p:nvSpPr>
              <p:cNvPr id="71696" name="Oval 16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697" name="Rectangle 17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698" name="Group 18"/>
            <p:cNvGrpSpPr>
              <a:grpSpLocks/>
            </p:cNvGrpSpPr>
            <p:nvPr/>
          </p:nvGrpSpPr>
          <p:grpSpPr bwMode="auto">
            <a:xfrm rot="-4923204">
              <a:off x="1986" y="1264"/>
              <a:ext cx="381" cy="112"/>
              <a:chOff x="477" y="3679"/>
              <a:chExt cx="1067" cy="344"/>
            </a:xfrm>
          </p:grpSpPr>
          <p:sp>
            <p:nvSpPr>
              <p:cNvPr id="71699" name="Oval 19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00" name="Rectangle 20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grpSp>
        <p:nvGrpSpPr>
          <p:cNvPr id="71701" name="Group 21"/>
          <p:cNvGrpSpPr>
            <a:grpSpLocks/>
          </p:cNvGrpSpPr>
          <p:nvPr/>
        </p:nvGrpSpPr>
        <p:grpSpPr bwMode="auto">
          <a:xfrm rot="-972552">
            <a:off x="6556376" y="2663826"/>
            <a:ext cx="277813" cy="373063"/>
            <a:chOff x="2121" y="1129"/>
            <a:chExt cx="282" cy="411"/>
          </a:xfrm>
        </p:grpSpPr>
        <p:grpSp>
          <p:nvGrpSpPr>
            <p:cNvPr id="71702" name="Group 22"/>
            <p:cNvGrpSpPr>
              <a:grpSpLocks/>
            </p:cNvGrpSpPr>
            <p:nvPr/>
          </p:nvGrpSpPr>
          <p:grpSpPr bwMode="auto">
            <a:xfrm rot="5931601">
              <a:off x="2141" y="1278"/>
              <a:ext cx="379" cy="145"/>
              <a:chOff x="477" y="3679"/>
              <a:chExt cx="1067" cy="344"/>
            </a:xfrm>
          </p:grpSpPr>
          <p:sp>
            <p:nvSpPr>
              <p:cNvPr id="71703" name="Oval 23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04" name="Rectangle 24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705" name="Group 25"/>
            <p:cNvGrpSpPr>
              <a:grpSpLocks/>
            </p:cNvGrpSpPr>
            <p:nvPr/>
          </p:nvGrpSpPr>
          <p:grpSpPr bwMode="auto">
            <a:xfrm rot="-4923204">
              <a:off x="1986" y="1264"/>
              <a:ext cx="381" cy="112"/>
              <a:chOff x="477" y="3679"/>
              <a:chExt cx="1067" cy="344"/>
            </a:xfrm>
          </p:grpSpPr>
          <p:sp>
            <p:nvSpPr>
              <p:cNvPr id="71706" name="Oval 26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07" name="Rectangle 27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grpSp>
        <p:nvGrpSpPr>
          <p:cNvPr id="71708" name="Group 28"/>
          <p:cNvGrpSpPr>
            <a:grpSpLocks/>
          </p:cNvGrpSpPr>
          <p:nvPr/>
        </p:nvGrpSpPr>
        <p:grpSpPr bwMode="auto">
          <a:xfrm rot="-1943894">
            <a:off x="6950075" y="3735388"/>
            <a:ext cx="190500" cy="341312"/>
            <a:chOff x="2121" y="1129"/>
            <a:chExt cx="282" cy="411"/>
          </a:xfrm>
        </p:grpSpPr>
        <p:grpSp>
          <p:nvGrpSpPr>
            <p:cNvPr id="71709" name="Group 29"/>
            <p:cNvGrpSpPr>
              <a:grpSpLocks/>
            </p:cNvGrpSpPr>
            <p:nvPr/>
          </p:nvGrpSpPr>
          <p:grpSpPr bwMode="auto">
            <a:xfrm rot="5931601">
              <a:off x="2141" y="1278"/>
              <a:ext cx="379" cy="145"/>
              <a:chOff x="477" y="3679"/>
              <a:chExt cx="1067" cy="344"/>
            </a:xfrm>
          </p:grpSpPr>
          <p:sp>
            <p:nvSpPr>
              <p:cNvPr id="71710" name="Oval 30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11" name="Rectangle 31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712" name="Group 32"/>
            <p:cNvGrpSpPr>
              <a:grpSpLocks/>
            </p:cNvGrpSpPr>
            <p:nvPr/>
          </p:nvGrpSpPr>
          <p:grpSpPr bwMode="auto">
            <a:xfrm rot="-4923204">
              <a:off x="1986" y="1264"/>
              <a:ext cx="381" cy="112"/>
              <a:chOff x="477" y="3679"/>
              <a:chExt cx="1067" cy="344"/>
            </a:xfrm>
          </p:grpSpPr>
          <p:sp>
            <p:nvSpPr>
              <p:cNvPr id="71713" name="Oval 33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14" name="Rectangle 34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grpSp>
        <p:nvGrpSpPr>
          <p:cNvPr id="71715" name="Group 35"/>
          <p:cNvGrpSpPr>
            <a:grpSpLocks/>
          </p:cNvGrpSpPr>
          <p:nvPr/>
        </p:nvGrpSpPr>
        <p:grpSpPr bwMode="auto">
          <a:xfrm rot="647180">
            <a:off x="6618288" y="3592513"/>
            <a:ext cx="184150" cy="279400"/>
            <a:chOff x="2121" y="1129"/>
            <a:chExt cx="282" cy="411"/>
          </a:xfrm>
        </p:grpSpPr>
        <p:grpSp>
          <p:nvGrpSpPr>
            <p:cNvPr id="71716" name="Group 36"/>
            <p:cNvGrpSpPr>
              <a:grpSpLocks/>
            </p:cNvGrpSpPr>
            <p:nvPr/>
          </p:nvGrpSpPr>
          <p:grpSpPr bwMode="auto">
            <a:xfrm rot="5931601">
              <a:off x="2141" y="1278"/>
              <a:ext cx="379" cy="145"/>
              <a:chOff x="477" y="3679"/>
              <a:chExt cx="1067" cy="344"/>
            </a:xfrm>
          </p:grpSpPr>
          <p:sp>
            <p:nvSpPr>
              <p:cNvPr id="71717" name="Oval 37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18" name="Rectangle 38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719" name="Group 39"/>
            <p:cNvGrpSpPr>
              <a:grpSpLocks/>
            </p:cNvGrpSpPr>
            <p:nvPr/>
          </p:nvGrpSpPr>
          <p:grpSpPr bwMode="auto">
            <a:xfrm rot="-4923204">
              <a:off x="1986" y="1264"/>
              <a:ext cx="381" cy="112"/>
              <a:chOff x="477" y="3679"/>
              <a:chExt cx="1067" cy="344"/>
            </a:xfrm>
          </p:grpSpPr>
          <p:sp>
            <p:nvSpPr>
              <p:cNvPr id="71720" name="Oval 40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21" name="Rectangle 41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grpSp>
        <p:nvGrpSpPr>
          <p:cNvPr id="71722" name="Group 42"/>
          <p:cNvGrpSpPr>
            <a:grpSpLocks/>
          </p:cNvGrpSpPr>
          <p:nvPr/>
        </p:nvGrpSpPr>
        <p:grpSpPr bwMode="auto">
          <a:xfrm rot="-1482945">
            <a:off x="7086601" y="4122738"/>
            <a:ext cx="188913" cy="311150"/>
            <a:chOff x="2121" y="1129"/>
            <a:chExt cx="282" cy="411"/>
          </a:xfrm>
        </p:grpSpPr>
        <p:grpSp>
          <p:nvGrpSpPr>
            <p:cNvPr id="71723" name="Group 43"/>
            <p:cNvGrpSpPr>
              <a:grpSpLocks/>
            </p:cNvGrpSpPr>
            <p:nvPr/>
          </p:nvGrpSpPr>
          <p:grpSpPr bwMode="auto">
            <a:xfrm rot="5931601">
              <a:off x="2141" y="1278"/>
              <a:ext cx="379" cy="145"/>
              <a:chOff x="477" y="3679"/>
              <a:chExt cx="1067" cy="344"/>
            </a:xfrm>
          </p:grpSpPr>
          <p:sp>
            <p:nvSpPr>
              <p:cNvPr id="71724" name="Oval 44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25" name="Rectangle 45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726" name="Group 46"/>
            <p:cNvGrpSpPr>
              <a:grpSpLocks/>
            </p:cNvGrpSpPr>
            <p:nvPr/>
          </p:nvGrpSpPr>
          <p:grpSpPr bwMode="auto">
            <a:xfrm rot="-4923204">
              <a:off x="1986" y="1264"/>
              <a:ext cx="381" cy="112"/>
              <a:chOff x="477" y="3679"/>
              <a:chExt cx="1067" cy="344"/>
            </a:xfrm>
          </p:grpSpPr>
          <p:sp>
            <p:nvSpPr>
              <p:cNvPr id="71727" name="Oval 47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28" name="Rectangle 48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grpSp>
        <p:nvGrpSpPr>
          <p:cNvPr id="71729" name="Group 49"/>
          <p:cNvGrpSpPr>
            <a:grpSpLocks/>
          </p:cNvGrpSpPr>
          <p:nvPr/>
        </p:nvGrpSpPr>
        <p:grpSpPr bwMode="auto">
          <a:xfrm rot="-1522474">
            <a:off x="6561800" y="3930651"/>
            <a:ext cx="171450" cy="328613"/>
            <a:chOff x="2121" y="1129"/>
            <a:chExt cx="282" cy="411"/>
          </a:xfrm>
        </p:grpSpPr>
        <p:grpSp>
          <p:nvGrpSpPr>
            <p:cNvPr id="71730" name="Group 50"/>
            <p:cNvGrpSpPr>
              <a:grpSpLocks/>
            </p:cNvGrpSpPr>
            <p:nvPr/>
          </p:nvGrpSpPr>
          <p:grpSpPr bwMode="auto">
            <a:xfrm rot="5931601">
              <a:off x="2141" y="1278"/>
              <a:ext cx="379" cy="145"/>
              <a:chOff x="477" y="3679"/>
              <a:chExt cx="1067" cy="344"/>
            </a:xfrm>
          </p:grpSpPr>
          <p:sp>
            <p:nvSpPr>
              <p:cNvPr id="71731" name="Oval 51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32" name="Rectangle 52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733" name="Group 53"/>
            <p:cNvGrpSpPr>
              <a:grpSpLocks/>
            </p:cNvGrpSpPr>
            <p:nvPr/>
          </p:nvGrpSpPr>
          <p:grpSpPr bwMode="auto">
            <a:xfrm rot="-4923204">
              <a:off x="1986" y="1264"/>
              <a:ext cx="381" cy="112"/>
              <a:chOff x="477" y="3679"/>
              <a:chExt cx="1067" cy="344"/>
            </a:xfrm>
          </p:grpSpPr>
          <p:sp>
            <p:nvSpPr>
              <p:cNvPr id="71734" name="Oval 54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35" name="Rectangle 55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grpSp>
        <p:nvGrpSpPr>
          <p:cNvPr id="71736" name="Group 56"/>
          <p:cNvGrpSpPr>
            <a:grpSpLocks/>
          </p:cNvGrpSpPr>
          <p:nvPr/>
        </p:nvGrpSpPr>
        <p:grpSpPr bwMode="auto">
          <a:xfrm rot="-2267603">
            <a:off x="7337425" y="4013200"/>
            <a:ext cx="179388" cy="342900"/>
            <a:chOff x="2121" y="1129"/>
            <a:chExt cx="282" cy="411"/>
          </a:xfrm>
        </p:grpSpPr>
        <p:grpSp>
          <p:nvGrpSpPr>
            <p:cNvPr id="71737" name="Group 57"/>
            <p:cNvGrpSpPr>
              <a:grpSpLocks/>
            </p:cNvGrpSpPr>
            <p:nvPr/>
          </p:nvGrpSpPr>
          <p:grpSpPr bwMode="auto">
            <a:xfrm rot="5931601">
              <a:off x="2141" y="1278"/>
              <a:ext cx="379" cy="145"/>
              <a:chOff x="477" y="3679"/>
              <a:chExt cx="1067" cy="344"/>
            </a:xfrm>
          </p:grpSpPr>
          <p:sp>
            <p:nvSpPr>
              <p:cNvPr id="71738" name="Oval 58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39" name="Rectangle 59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740" name="Group 60"/>
            <p:cNvGrpSpPr>
              <a:grpSpLocks/>
            </p:cNvGrpSpPr>
            <p:nvPr/>
          </p:nvGrpSpPr>
          <p:grpSpPr bwMode="auto">
            <a:xfrm rot="-4923204">
              <a:off x="1986" y="1264"/>
              <a:ext cx="381" cy="112"/>
              <a:chOff x="477" y="3679"/>
              <a:chExt cx="1067" cy="344"/>
            </a:xfrm>
          </p:grpSpPr>
          <p:sp>
            <p:nvSpPr>
              <p:cNvPr id="71741" name="Oval 61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42" name="Rectangle 62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grpSp>
        <p:nvGrpSpPr>
          <p:cNvPr id="71743" name="Group 63"/>
          <p:cNvGrpSpPr>
            <a:grpSpLocks/>
          </p:cNvGrpSpPr>
          <p:nvPr/>
        </p:nvGrpSpPr>
        <p:grpSpPr bwMode="auto">
          <a:xfrm rot="-1261493">
            <a:off x="6642101" y="3090864"/>
            <a:ext cx="220663" cy="350837"/>
            <a:chOff x="2121" y="1129"/>
            <a:chExt cx="282" cy="411"/>
          </a:xfrm>
        </p:grpSpPr>
        <p:grpSp>
          <p:nvGrpSpPr>
            <p:cNvPr id="71744" name="Group 64"/>
            <p:cNvGrpSpPr>
              <a:grpSpLocks/>
            </p:cNvGrpSpPr>
            <p:nvPr/>
          </p:nvGrpSpPr>
          <p:grpSpPr bwMode="auto">
            <a:xfrm rot="5931601">
              <a:off x="2141" y="1278"/>
              <a:ext cx="379" cy="145"/>
              <a:chOff x="477" y="3679"/>
              <a:chExt cx="1067" cy="344"/>
            </a:xfrm>
          </p:grpSpPr>
          <p:sp>
            <p:nvSpPr>
              <p:cNvPr id="71745" name="Oval 65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46" name="Rectangle 66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  <p:grpSp>
          <p:nvGrpSpPr>
            <p:cNvPr id="71747" name="Group 67"/>
            <p:cNvGrpSpPr>
              <a:grpSpLocks/>
            </p:cNvGrpSpPr>
            <p:nvPr/>
          </p:nvGrpSpPr>
          <p:grpSpPr bwMode="auto">
            <a:xfrm rot="-4923204">
              <a:off x="1986" y="1264"/>
              <a:ext cx="381" cy="112"/>
              <a:chOff x="477" y="3679"/>
              <a:chExt cx="1067" cy="344"/>
            </a:xfrm>
          </p:grpSpPr>
          <p:sp>
            <p:nvSpPr>
              <p:cNvPr id="71748" name="Oval 68"/>
              <p:cNvSpPr>
                <a:spLocks noChangeArrowheads="1"/>
              </p:cNvSpPr>
              <p:nvPr/>
            </p:nvSpPr>
            <p:spPr bwMode="auto">
              <a:xfrm>
                <a:off x="485" y="3679"/>
                <a:ext cx="1059" cy="300"/>
              </a:xfrm>
              <a:prstGeom prst="ellipse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71749" name="Rectangle 69"/>
              <p:cNvSpPr>
                <a:spLocks noChangeArrowheads="1"/>
              </p:cNvSpPr>
              <p:nvPr/>
            </p:nvSpPr>
            <p:spPr bwMode="auto">
              <a:xfrm>
                <a:off x="477" y="3838"/>
                <a:ext cx="1067" cy="185"/>
              </a:xfrm>
              <a:prstGeom prst="rect">
                <a:avLst/>
              </a:prstGeom>
              <a:solidFill>
                <a:schemeClr val="hlink"/>
              </a:solidFill>
              <a:ln w="9525">
                <a:solidFill>
                  <a:schemeClr val="folHlink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it-IT"/>
              </a:p>
            </p:txBody>
          </p:sp>
        </p:grpSp>
      </p:grpSp>
      <p:sp>
        <p:nvSpPr>
          <p:cNvPr id="71750" name="Freeform 70"/>
          <p:cNvSpPr>
            <a:spLocks/>
          </p:cNvSpPr>
          <p:nvPr/>
        </p:nvSpPr>
        <p:spPr bwMode="auto">
          <a:xfrm>
            <a:off x="6591301" y="1673225"/>
            <a:ext cx="1344613" cy="3614738"/>
          </a:xfrm>
          <a:custGeom>
            <a:avLst/>
            <a:gdLst>
              <a:gd name="T0" fmla="*/ 429 w 998"/>
              <a:gd name="T1" fmla="*/ 10 h 1801"/>
              <a:gd name="T2" fmla="*/ 370 w 998"/>
              <a:gd name="T3" fmla="*/ 0 h 1801"/>
              <a:gd name="T4" fmla="*/ 239 w 998"/>
              <a:gd name="T5" fmla="*/ 75 h 1801"/>
              <a:gd name="T6" fmla="*/ 128 w 998"/>
              <a:gd name="T7" fmla="*/ 176 h 1801"/>
              <a:gd name="T8" fmla="*/ 60 w 998"/>
              <a:gd name="T9" fmla="*/ 278 h 1801"/>
              <a:gd name="T10" fmla="*/ 27 w 998"/>
              <a:gd name="T11" fmla="*/ 383 h 1801"/>
              <a:gd name="T12" fmla="*/ 22 w 998"/>
              <a:gd name="T13" fmla="*/ 489 h 1801"/>
              <a:gd name="T14" fmla="*/ 38 w 998"/>
              <a:gd name="T15" fmla="*/ 599 h 1801"/>
              <a:gd name="T16" fmla="*/ 97 w 998"/>
              <a:gd name="T17" fmla="*/ 795 h 1801"/>
              <a:gd name="T18" fmla="*/ 120 w 998"/>
              <a:gd name="T19" fmla="*/ 891 h 1801"/>
              <a:gd name="T20" fmla="*/ 104 w 998"/>
              <a:gd name="T21" fmla="*/ 938 h 1801"/>
              <a:gd name="T22" fmla="*/ 23 w 998"/>
              <a:gd name="T23" fmla="*/ 1059 h 1801"/>
              <a:gd name="T24" fmla="*/ 3 w 998"/>
              <a:gd name="T25" fmla="*/ 1110 h 1801"/>
              <a:gd name="T26" fmla="*/ 4 w 998"/>
              <a:gd name="T27" fmla="*/ 1165 h 1801"/>
              <a:gd name="T28" fmla="*/ 40 w 998"/>
              <a:gd name="T29" fmla="*/ 1224 h 1801"/>
              <a:gd name="T30" fmla="*/ 138 w 998"/>
              <a:gd name="T31" fmla="*/ 1272 h 1801"/>
              <a:gd name="T32" fmla="*/ 64 w 998"/>
              <a:gd name="T33" fmla="*/ 1198 h 1801"/>
              <a:gd name="T34" fmla="*/ 47 w 998"/>
              <a:gd name="T35" fmla="*/ 1164 h 1801"/>
              <a:gd name="T36" fmla="*/ 41 w 998"/>
              <a:gd name="T37" fmla="*/ 1128 h 1801"/>
              <a:gd name="T38" fmla="*/ 51 w 998"/>
              <a:gd name="T39" fmla="*/ 1089 h 1801"/>
              <a:gd name="T40" fmla="*/ 109 w 998"/>
              <a:gd name="T41" fmla="*/ 988 h 1801"/>
              <a:gd name="T42" fmla="*/ 268 w 998"/>
              <a:gd name="T43" fmla="*/ 1046 h 1801"/>
              <a:gd name="T44" fmla="*/ 362 w 998"/>
              <a:gd name="T45" fmla="*/ 1177 h 1801"/>
              <a:gd name="T46" fmla="*/ 418 w 998"/>
              <a:gd name="T47" fmla="*/ 1291 h 1801"/>
              <a:gd name="T48" fmla="*/ 445 w 998"/>
              <a:gd name="T49" fmla="*/ 1378 h 1801"/>
              <a:gd name="T50" fmla="*/ 463 w 998"/>
              <a:gd name="T51" fmla="*/ 1480 h 1801"/>
              <a:gd name="T52" fmla="*/ 479 w 998"/>
              <a:gd name="T53" fmla="*/ 1536 h 1801"/>
              <a:gd name="T54" fmla="*/ 501 w 998"/>
              <a:gd name="T55" fmla="*/ 1536 h 1801"/>
              <a:gd name="T56" fmla="*/ 510 w 998"/>
              <a:gd name="T57" fmla="*/ 1489 h 1801"/>
              <a:gd name="T58" fmla="*/ 497 w 998"/>
              <a:gd name="T59" fmla="*/ 1397 h 1801"/>
              <a:gd name="T60" fmla="*/ 456 w 998"/>
              <a:gd name="T61" fmla="*/ 1272 h 1801"/>
              <a:gd name="T62" fmla="*/ 374 w 998"/>
              <a:gd name="T63" fmla="*/ 1123 h 1801"/>
              <a:gd name="T64" fmla="*/ 225 w 998"/>
              <a:gd name="T65" fmla="*/ 919 h 1801"/>
              <a:gd name="T66" fmla="*/ 448 w 998"/>
              <a:gd name="T67" fmla="*/ 1094 h 1801"/>
              <a:gd name="T68" fmla="*/ 647 w 998"/>
              <a:gd name="T69" fmla="*/ 1295 h 1801"/>
              <a:gd name="T70" fmla="*/ 737 w 998"/>
              <a:gd name="T71" fmla="*/ 1405 h 1801"/>
              <a:gd name="T72" fmla="*/ 817 w 998"/>
              <a:gd name="T73" fmla="*/ 1527 h 1801"/>
              <a:gd name="T74" fmla="*/ 891 w 998"/>
              <a:gd name="T75" fmla="*/ 1658 h 1801"/>
              <a:gd name="T76" fmla="*/ 954 w 998"/>
              <a:gd name="T77" fmla="*/ 1801 h 1801"/>
              <a:gd name="T78" fmla="*/ 950 w 998"/>
              <a:gd name="T79" fmla="*/ 1696 h 1801"/>
              <a:gd name="T80" fmla="*/ 877 w 998"/>
              <a:gd name="T81" fmla="*/ 1559 h 1801"/>
              <a:gd name="T82" fmla="*/ 794 w 998"/>
              <a:gd name="T83" fmla="*/ 1427 h 1801"/>
              <a:gd name="T84" fmla="*/ 700 w 998"/>
              <a:gd name="T85" fmla="*/ 1300 h 1801"/>
              <a:gd name="T86" fmla="*/ 596 w 998"/>
              <a:gd name="T87" fmla="*/ 1180 h 1801"/>
              <a:gd name="T88" fmla="*/ 485 w 998"/>
              <a:gd name="T89" fmla="*/ 1068 h 1801"/>
              <a:gd name="T90" fmla="*/ 364 w 998"/>
              <a:gd name="T91" fmla="*/ 966 h 1801"/>
              <a:gd name="T92" fmla="*/ 238 w 998"/>
              <a:gd name="T93" fmla="*/ 874 h 1801"/>
              <a:gd name="T94" fmla="*/ 156 w 998"/>
              <a:gd name="T95" fmla="*/ 727 h 1801"/>
              <a:gd name="T96" fmla="*/ 115 w 998"/>
              <a:gd name="T97" fmla="*/ 584 h 1801"/>
              <a:gd name="T98" fmla="*/ 100 w 998"/>
              <a:gd name="T99" fmla="*/ 465 h 1801"/>
              <a:gd name="T100" fmla="*/ 112 w 998"/>
              <a:gd name="T101" fmla="*/ 367 h 1801"/>
              <a:gd name="T102" fmla="*/ 149 w 998"/>
              <a:gd name="T103" fmla="*/ 279 h 1801"/>
              <a:gd name="T104" fmla="*/ 212 w 998"/>
              <a:gd name="T105" fmla="*/ 200 h 1801"/>
              <a:gd name="T106" fmla="*/ 300 w 998"/>
              <a:gd name="T107" fmla="*/ 122 h 18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998" h="1801">
                <a:moveTo>
                  <a:pt x="446" y="16"/>
                </a:moveTo>
                <a:lnTo>
                  <a:pt x="444" y="16"/>
                </a:lnTo>
                <a:lnTo>
                  <a:pt x="438" y="13"/>
                </a:lnTo>
                <a:lnTo>
                  <a:pt x="429" y="10"/>
                </a:lnTo>
                <a:lnTo>
                  <a:pt x="416" y="8"/>
                </a:lnTo>
                <a:lnTo>
                  <a:pt x="403" y="5"/>
                </a:lnTo>
                <a:lnTo>
                  <a:pt x="386" y="2"/>
                </a:lnTo>
                <a:lnTo>
                  <a:pt x="370" y="0"/>
                </a:lnTo>
                <a:lnTo>
                  <a:pt x="354" y="0"/>
                </a:lnTo>
                <a:lnTo>
                  <a:pt x="311" y="24"/>
                </a:lnTo>
                <a:lnTo>
                  <a:pt x="273" y="49"/>
                </a:lnTo>
                <a:lnTo>
                  <a:pt x="239" y="75"/>
                </a:lnTo>
                <a:lnTo>
                  <a:pt x="206" y="99"/>
                </a:lnTo>
                <a:lnTo>
                  <a:pt x="178" y="124"/>
                </a:lnTo>
                <a:lnTo>
                  <a:pt x="152" y="150"/>
                </a:lnTo>
                <a:lnTo>
                  <a:pt x="128" y="176"/>
                </a:lnTo>
                <a:lnTo>
                  <a:pt x="107" y="200"/>
                </a:lnTo>
                <a:lnTo>
                  <a:pt x="89" y="226"/>
                </a:lnTo>
                <a:lnTo>
                  <a:pt x="74" y="252"/>
                </a:lnTo>
                <a:lnTo>
                  <a:pt x="60" y="278"/>
                </a:lnTo>
                <a:lnTo>
                  <a:pt x="48" y="304"/>
                </a:lnTo>
                <a:lnTo>
                  <a:pt x="40" y="330"/>
                </a:lnTo>
                <a:lnTo>
                  <a:pt x="33" y="357"/>
                </a:lnTo>
                <a:lnTo>
                  <a:pt x="27" y="383"/>
                </a:lnTo>
                <a:lnTo>
                  <a:pt x="23" y="409"/>
                </a:lnTo>
                <a:lnTo>
                  <a:pt x="22" y="436"/>
                </a:lnTo>
                <a:lnTo>
                  <a:pt x="22" y="464"/>
                </a:lnTo>
                <a:lnTo>
                  <a:pt x="22" y="489"/>
                </a:lnTo>
                <a:lnTo>
                  <a:pt x="25" y="517"/>
                </a:lnTo>
                <a:lnTo>
                  <a:pt x="29" y="544"/>
                </a:lnTo>
                <a:lnTo>
                  <a:pt x="33" y="571"/>
                </a:lnTo>
                <a:lnTo>
                  <a:pt x="38" y="599"/>
                </a:lnTo>
                <a:lnTo>
                  <a:pt x="45" y="627"/>
                </a:lnTo>
                <a:lnTo>
                  <a:pt x="62" y="682"/>
                </a:lnTo>
                <a:lnTo>
                  <a:pt x="78" y="739"/>
                </a:lnTo>
                <a:lnTo>
                  <a:pt x="97" y="795"/>
                </a:lnTo>
                <a:lnTo>
                  <a:pt x="116" y="854"/>
                </a:lnTo>
                <a:lnTo>
                  <a:pt x="119" y="866"/>
                </a:lnTo>
                <a:lnTo>
                  <a:pt x="120" y="878"/>
                </a:lnTo>
                <a:lnTo>
                  <a:pt x="120" y="891"/>
                </a:lnTo>
                <a:lnTo>
                  <a:pt x="117" y="902"/>
                </a:lnTo>
                <a:lnTo>
                  <a:pt x="115" y="914"/>
                </a:lnTo>
                <a:lnTo>
                  <a:pt x="109" y="926"/>
                </a:lnTo>
                <a:lnTo>
                  <a:pt x="104" y="938"/>
                </a:lnTo>
                <a:lnTo>
                  <a:pt x="97" y="949"/>
                </a:lnTo>
                <a:lnTo>
                  <a:pt x="64" y="997"/>
                </a:lnTo>
                <a:lnTo>
                  <a:pt x="30" y="1046"/>
                </a:lnTo>
                <a:lnTo>
                  <a:pt x="23" y="1059"/>
                </a:lnTo>
                <a:lnTo>
                  <a:pt x="16" y="1071"/>
                </a:lnTo>
                <a:lnTo>
                  <a:pt x="11" y="1083"/>
                </a:lnTo>
                <a:lnTo>
                  <a:pt x="6" y="1097"/>
                </a:lnTo>
                <a:lnTo>
                  <a:pt x="3" y="1110"/>
                </a:lnTo>
                <a:lnTo>
                  <a:pt x="0" y="1123"/>
                </a:lnTo>
                <a:lnTo>
                  <a:pt x="0" y="1136"/>
                </a:lnTo>
                <a:lnTo>
                  <a:pt x="1" y="1150"/>
                </a:lnTo>
                <a:lnTo>
                  <a:pt x="4" y="1165"/>
                </a:lnTo>
                <a:lnTo>
                  <a:pt x="10" y="1179"/>
                </a:lnTo>
                <a:lnTo>
                  <a:pt x="16" y="1194"/>
                </a:lnTo>
                <a:lnTo>
                  <a:pt x="27" y="1209"/>
                </a:lnTo>
                <a:lnTo>
                  <a:pt x="40" y="1224"/>
                </a:lnTo>
                <a:lnTo>
                  <a:pt x="55" y="1240"/>
                </a:lnTo>
                <a:lnTo>
                  <a:pt x="72" y="1255"/>
                </a:lnTo>
                <a:lnTo>
                  <a:pt x="94" y="1272"/>
                </a:lnTo>
                <a:lnTo>
                  <a:pt x="138" y="1272"/>
                </a:lnTo>
                <a:lnTo>
                  <a:pt x="115" y="1252"/>
                </a:lnTo>
                <a:lnTo>
                  <a:pt x="94" y="1233"/>
                </a:lnTo>
                <a:lnTo>
                  <a:pt x="78" y="1216"/>
                </a:lnTo>
                <a:lnTo>
                  <a:pt x="64" y="1198"/>
                </a:lnTo>
                <a:lnTo>
                  <a:pt x="57" y="1190"/>
                </a:lnTo>
                <a:lnTo>
                  <a:pt x="53" y="1181"/>
                </a:lnTo>
                <a:lnTo>
                  <a:pt x="49" y="1173"/>
                </a:lnTo>
                <a:lnTo>
                  <a:pt x="47" y="1164"/>
                </a:lnTo>
                <a:lnTo>
                  <a:pt x="44" y="1155"/>
                </a:lnTo>
                <a:lnTo>
                  <a:pt x="42" y="1147"/>
                </a:lnTo>
                <a:lnTo>
                  <a:pt x="41" y="1138"/>
                </a:lnTo>
                <a:lnTo>
                  <a:pt x="41" y="1128"/>
                </a:lnTo>
                <a:lnTo>
                  <a:pt x="42" y="1119"/>
                </a:lnTo>
                <a:lnTo>
                  <a:pt x="44" y="1109"/>
                </a:lnTo>
                <a:lnTo>
                  <a:pt x="47" y="1100"/>
                </a:lnTo>
                <a:lnTo>
                  <a:pt x="51" y="1089"/>
                </a:lnTo>
                <a:lnTo>
                  <a:pt x="59" y="1067"/>
                </a:lnTo>
                <a:lnTo>
                  <a:pt x="72" y="1042"/>
                </a:lnTo>
                <a:lnTo>
                  <a:pt x="89" y="1016"/>
                </a:lnTo>
                <a:lnTo>
                  <a:pt x="109" y="988"/>
                </a:lnTo>
                <a:lnTo>
                  <a:pt x="132" y="955"/>
                </a:lnTo>
                <a:lnTo>
                  <a:pt x="160" y="919"/>
                </a:lnTo>
                <a:lnTo>
                  <a:pt x="216" y="984"/>
                </a:lnTo>
                <a:lnTo>
                  <a:pt x="268" y="1046"/>
                </a:lnTo>
                <a:lnTo>
                  <a:pt x="293" y="1078"/>
                </a:lnTo>
                <a:lnTo>
                  <a:pt x="318" y="1109"/>
                </a:lnTo>
                <a:lnTo>
                  <a:pt x="340" y="1142"/>
                </a:lnTo>
                <a:lnTo>
                  <a:pt x="362" y="1177"/>
                </a:lnTo>
                <a:lnTo>
                  <a:pt x="382" y="1213"/>
                </a:lnTo>
                <a:lnTo>
                  <a:pt x="401" y="1250"/>
                </a:lnTo>
                <a:lnTo>
                  <a:pt x="409" y="1270"/>
                </a:lnTo>
                <a:lnTo>
                  <a:pt x="418" y="1291"/>
                </a:lnTo>
                <a:lnTo>
                  <a:pt x="424" y="1311"/>
                </a:lnTo>
                <a:lnTo>
                  <a:pt x="433" y="1333"/>
                </a:lnTo>
                <a:lnTo>
                  <a:pt x="438" y="1355"/>
                </a:lnTo>
                <a:lnTo>
                  <a:pt x="445" y="1378"/>
                </a:lnTo>
                <a:lnTo>
                  <a:pt x="450" y="1403"/>
                </a:lnTo>
                <a:lnTo>
                  <a:pt x="454" y="1427"/>
                </a:lnTo>
                <a:lnTo>
                  <a:pt x="460" y="1453"/>
                </a:lnTo>
                <a:lnTo>
                  <a:pt x="463" y="1480"/>
                </a:lnTo>
                <a:lnTo>
                  <a:pt x="467" y="1508"/>
                </a:lnTo>
                <a:lnTo>
                  <a:pt x="468" y="1536"/>
                </a:lnTo>
                <a:lnTo>
                  <a:pt x="474" y="1536"/>
                </a:lnTo>
                <a:lnTo>
                  <a:pt x="479" y="1536"/>
                </a:lnTo>
                <a:lnTo>
                  <a:pt x="485" y="1536"/>
                </a:lnTo>
                <a:lnTo>
                  <a:pt x="490" y="1536"/>
                </a:lnTo>
                <a:lnTo>
                  <a:pt x="495" y="1536"/>
                </a:lnTo>
                <a:lnTo>
                  <a:pt x="501" y="1536"/>
                </a:lnTo>
                <a:lnTo>
                  <a:pt x="506" y="1536"/>
                </a:lnTo>
                <a:lnTo>
                  <a:pt x="512" y="1536"/>
                </a:lnTo>
                <a:lnTo>
                  <a:pt x="512" y="1512"/>
                </a:lnTo>
                <a:lnTo>
                  <a:pt x="510" y="1489"/>
                </a:lnTo>
                <a:lnTo>
                  <a:pt x="509" y="1464"/>
                </a:lnTo>
                <a:lnTo>
                  <a:pt x="505" y="1441"/>
                </a:lnTo>
                <a:lnTo>
                  <a:pt x="502" y="1419"/>
                </a:lnTo>
                <a:lnTo>
                  <a:pt x="497" y="1397"/>
                </a:lnTo>
                <a:lnTo>
                  <a:pt x="491" y="1375"/>
                </a:lnTo>
                <a:lnTo>
                  <a:pt x="486" y="1353"/>
                </a:lnTo>
                <a:lnTo>
                  <a:pt x="472" y="1311"/>
                </a:lnTo>
                <a:lnTo>
                  <a:pt x="456" y="1272"/>
                </a:lnTo>
                <a:lnTo>
                  <a:pt x="438" y="1232"/>
                </a:lnTo>
                <a:lnTo>
                  <a:pt x="419" y="1195"/>
                </a:lnTo>
                <a:lnTo>
                  <a:pt x="397" y="1158"/>
                </a:lnTo>
                <a:lnTo>
                  <a:pt x="374" y="1123"/>
                </a:lnTo>
                <a:lnTo>
                  <a:pt x="351" y="1087"/>
                </a:lnTo>
                <a:lnTo>
                  <a:pt x="326" y="1053"/>
                </a:lnTo>
                <a:lnTo>
                  <a:pt x="276" y="986"/>
                </a:lnTo>
                <a:lnTo>
                  <a:pt x="225" y="919"/>
                </a:lnTo>
                <a:lnTo>
                  <a:pt x="283" y="962"/>
                </a:lnTo>
                <a:lnTo>
                  <a:pt x="340" y="1004"/>
                </a:lnTo>
                <a:lnTo>
                  <a:pt x="394" y="1049"/>
                </a:lnTo>
                <a:lnTo>
                  <a:pt x="448" y="1094"/>
                </a:lnTo>
                <a:lnTo>
                  <a:pt x="501" y="1142"/>
                </a:lnTo>
                <a:lnTo>
                  <a:pt x="551" y="1191"/>
                </a:lnTo>
                <a:lnTo>
                  <a:pt x="601" y="1241"/>
                </a:lnTo>
                <a:lnTo>
                  <a:pt x="647" y="1295"/>
                </a:lnTo>
                <a:lnTo>
                  <a:pt x="670" y="1321"/>
                </a:lnTo>
                <a:lnTo>
                  <a:pt x="693" y="1349"/>
                </a:lnTo>
                <a:lnTo>
                  <a:pt x="715" y="1377"/>
                </a:lnTo>
                <a:lnTo>
                  <a:pt x="737" y="1405"/>
                </a:lnTo>
                <a:lnTo>
                  <a:pt x="757" y="1435"/>
                </a:lnTo>
                <a:lnTo>
                  <a:pt x="778" y="1465"/>
                </a:lnTo>
                <a:lnTo>
                  <a:pt x="798" y="1495"/>
                </a:lnTo>
                <a:lnTo>
                  <a:pt x="817" y="1527"/>
                </a:lnTo>
                <a:lnTo>
                  <a:pt x="837" y="1558"/>
                </a:lnTo>
                <a:lnTo>
                  <a:pt x="856" y="1591"/>
                </a:lnTo>
                <a:lnTo>
                  <a:pt x="873" y="1624"/>
                </a:lnTo>
                <a:lnTo>
                  <a:pt x="891" y="1658"/>
                </a:lnTo>
                <a:lnTo>
                  <a:pt x="908" y="1692"/>
                </a:lnTo>
                <a:lnTo>
                  <a:pt x="924" y="1727"/>
                </a:lnTo>
                <a:lnTo>
                  <a:pt x="939" y="1764"/>
                </a:lnTo>
                <a:lnTo>
                  <a:pt x="954" y="1801"/>
                </a:lnTo>
                <a:lnTo>
                  <a:pt x="998" y="1801"/>
                </a:lnTo>
                <a:lnTo>
                  <a:pt x="983" y="1766"/>
                </a:lnTo>
                <a:lnTo>
                  <a:pt x="966" y="1730"/>
                </a:lnTo>
                <a:lnTo>
                  <a:pt x="950" y="1696"/>
                </a:lnTo>
                <a:lnTo>
                  <a:pt x="933" y="1662"/>
                </a:lnTo>
                <a:lnTo>
                  <a:pt x="916" y="1628"/>
                </a:lnTo>
                <a:lnTo>
                  <a:pt x="897" y="1594"/>
                </a:lnTo>
                <a:lnTo>
                  <a:pt x="877" y="1559"/>
                </a:lnTo>
                <a:lnTo>
                  <a:pt x="857" y="1525"/>
                </a:lnTo>
                <a:lnTo>
                  <a:pt x="837" y="1493"/>
                </a:lnTo>
                <a:lnTo>
                  <a:pt x="816" y="1460"/>
                </a:lnTo>
                <a:lnTo>
                  <a:pt x="794" y="1427"/>
                </a:lnTo>
                <a:lnTo>
                  <a:pt x="771" y="1394"/>
                </a:lnTo>
                <a:lnTo>
                  <a:pt x="748" y="1363"/>
                </a:lnTo>
                <a:lnTo>
                  <a:pt x="725" y="1332"/>
                </a:lnTo>
                <a:lnTo>
                  <a:pt x="700" y="1300"/>
                </a:lnTo>
                <a:lnTo>
                  <a:pt x="676" y="1270"/>
                </a:lnTo>
                <a:lnTo>
                  <a:pt x="650" y="1239"/>
                </a:lnTo>
                <a:lnTo>
                  <a:pt x="624" y="1210"/>
                </a:lnTo>
                <a:lnTo>
                  <a:pt x="596" y="1180"/>
                </a:lnTo>
                <a:lnTo>
                  <a:pt x="569" y="1151"/>
                </a:lnTo>
                <a:lnTo>
                  <a:pt x="542" y="1123"/>
                </a:lnTo>
                <a:lnTo>
                  <a:pt x="513" y="1095"/>
                </a:lnTo>
                <a:lnTo>
                  <a:pt x="485" y="1068"/>
                </a:lnTo>
                <a:lnTo>
                  <a:pt x="456" y="1042"/>
                </a:lnTo>
                <a:lnTo>
                  <a:pt x="426" y="1016"/>
                </a:lnTo>
                <a:lnTo>
                  <a:pt x="396" y="990"/>
                </a:lnTo>
                <a:lnTo>
                  <a:pt x="364" y="966"/>
                </a:lnTo>
                <a:lnTo>
                  <a:pt x="333" y="943"/>
                </a:lnTo>
                <a:lnTo>
                  <a:pt x="302" y="919"/>
                </a:lnTo>
                <a:lnTo>
                  <a:pt x="270" y="896"/>
                </a:lnTo>
                <a:lnTo>
                  <a:pt x="238" y="874"/>
                </a:lnTo>
                <a:lnTo>
                  <a:pt x="205" y="854"/>
                </a:lnTo>
                <a:lnTo>
                  <a:pt x="187" y="809"/>
                </a:lnTo>
                <a:lnTo>
                  <a:pt x="171" y="767"/>
                </a:lnTo>
                <a:lnTo>
                  <a:pt x="156" y="727"/>
                </a:lnTo>
                <a:lnTo>
                  <a:pt x="143" y="689"/>
                </a:lnTo>
                <a:lnTo>
                  <a:pt x="132" y="652"/>
                </a:lnTo>
                <a:lnTo>
                  <a:pt x="123" y="616"/>
                </a:lnTo>
                <a:lnTo>
                  <a:pt x="115" y="584"/>
                </a:lnTo>
                <a:lnTo>
                  <a:pt x="108" y="552"/>
                </a:lnTo>
                <a:lnTo>
                  <a:pt x="104" y="522"/>
                </a:lnTo>
                <a:lnTo>
                  <a:pt x="101" y="494"/>
                </a:lnTo>
                <a:lnTo>
                  <a:pt x="100" y="465"/>
                </a:lnTo>
                <a:lnTo>
                  <a:pt x="101" y="439"/>
                </a:lnTo>
                <a:lnTo>
                  <a:pt x="102" y="414"/>
                </a:lnTo>
                <a:lnTo>
                  <a:pt x="107" y="390"/>
                </a:lnTo>
                <a:lnTo>
                  <a:pt x="112" y="367"/>
                </a:lnTo>
                <a:lnTo>
                  <a:pt x="119" y="343"/>
                </a:lnTo>
                <a:lnTo>
                  <a:pt x="127" y="322"/>
                </a:lnTo>
                <a:lnTo>
                  <a:pt x="137" y="301"/>
                </a:lnTo>
                <a:lnTo>
                  <a:pt x="149" y="279"/>
                </a:lnTo>
                <a:lnTo>
                  <a:pt x="162" y="259"/>
                </a:lnTo>
                <a:lnTo>
                  <a:pt x="178" y="240"/>
                </a:lnTo>
                <a:lnTo>
                  <a:pt x="194" y="219"/>
                </a:lnTo>
                <a:lnTo>
                  <a:pt x="212" y="200"/>
                </a:lnTo>
                <a:lnTo>
                  <a:pt x="232" y="181"/>
                </a:lnTo>
                <a:lnTo>
                  <a:pt x="253" y="161"/>
                </a:lnTo>
                <a:lnTo>
                  <a:pt x="276" y="141"/>
                </a:lnTo>
                <a:lnTo>
                  <a:pt x="300" y="122"/>
                </a:lnTo>
                <a:lnTo>
                  <a:pt x="326" y="102"/>
                </a:lnTo>
                <a:lnTo>
                  <a:pt x="384" y="60"/>
                </a:lnTo>
                <a:lnTo>
                  <a:pt x="446" y="16"/>
                </a:lnTo>
                <a:close/>
              </a:path>
            </a:pathLst>
          </a:custGeom>
          <a:solidFill>
            <a:srgbClr val="99CC66"/>
          </a:solidFill>
          <a:ln w="9525">
            <a:solidFill>
              <a:srgbClr val="00FF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71751" name="Line 71"/>
          <p:cNvSpPr>
            <a:spLocks noChangeShapeType="1"/>
          </p:cNvSpPr>
          <p:nvPr/>
        </p:nvSpPr>
        <p:spPr bwMode="auto">
          <a:xfrm flipV="1">
            <a:off x="7165975" y="1366839"/>
            <a:ext cx="438150" cy="352425"/>
          </a:xfrm>
          <a:prstGeom prst="line">
            <a:avLst/>
          </a:prstGeom>
          <a:noFill/>
          <a:ln w="76200">
            <a:solidFill>
              <a:srgbClr val="00CC00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752" name="Text Box 72"/>
          <p:cNvSpPr txBox="1">
            <a:spLocks noChangeArrowheads="1"/>
          </p:cNvSpPr>
          <p:nvPr/>
        </p:nvSpPr>
        <p:spPr bwMode="auto">
          <a:xfrm>
            <a:off x="7215188" y="1442681"/>
            <a:ext cx="186372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folHlink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/>
          <a:p>
            <a:pPr algn="ctr" eaLnBrk="0" hangingPunct="0"/>
            <a:r>
              <a:rPr lang="it-IT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motoneuron</a:t>
            </a:r>
          </a:p>
        </p:txBody>
      </p:sp>
      <p:sp>
        <p:nvSpPr>
          <p:cNvPr id="71753" name="Text Box 73"/>
          <p:cNvSpPr txBox="1">
            <a:spLocks noChangeArrowheads="1"/>
          </p:cNvSpPr>
          <p:nvPr/>
        </p:nvSpPr>
        <p:spPr bwMode="auto">
          <a:xfrm>
            <a:off x="5129720" y="1143730"/>
            <a:ext cx="1515825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folHlink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anchor="ctr">
            <a:spAutoFit/>
          </a:bodyPr>
          <a:lstStyle/>
          <a:p>
            <a:pPr algn="ctr" eaLnBrk="0" hangingPunct="0"/>
            <a:r>
              <a:rPr lang="it-IT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chwan cells and Ranvier nodes</a:t>
            </a:r>
            <a:endParaRPr lang="it-IT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754" name="Line 74"/>
          <p:cNvSpPr>
            <a:spLocks noChangeShapeType="1"/>
          </p:cNvSpPr>
          <p:nvPr/>
        </p:nvSpPr>
        <p:spPr bwMode="auto">
          <a:xfrm flipH="1" flipV="1">
            <a:off x="6001764" y="1913969"/>
            <a:ext cx="512136" cy="485681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triangle" w="med" len="med"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755" name="Freeform 75"/>
          <p:cNvSpPr>
            <a:spLocks/>
          </p:cNvSpPr>
          <p:nvPr/>
        </p:nvSpPr>
        <p:spPr bwMode="auto">
          <a:xfrm>
            <a:off x="2316163" y="4689476"/>
            <a:ext cx="7599362" cy="119063"/>
          </a:xfrm>
          <a:custGeom>
            <a:avLst/>
            <a:gdLst>
              <a:gd name="T0" fmla="*/ 0 w 1809"/>
              <a:gd name="T1" fmla="*/ 89 h 89"/>
              <a:gd name="T2" fmla="*/ 1764 w 1809"/>
              <a:gd name="T3" fmla="*/ 89 h 89"/>
              <a:gd name="T4" fmla="*/ 1764 w 1809"/>
              <a:gd name="T5" fmla="*/ 89 h 89"/>
              <a:gd name="T6" fmla="*/ 1764 w 1809"/>
              <a:gd name="T7" fmla="*/ 89 h 89"/>
              <a:gd name="T8" fmla="*/ 1764 w 1809"/>
              <a:gd name="T9" fmla="*/ 89 h 89"/>
              <a:gd name="T10" fmla="*/ 1764 w 1809"/>
              <a:gd name="T11" fmla="*/ 89 h 89"/>
              <a:gd name="T12" fmla="*/ 1764 w 1809"/>
              <a:gd name="T13" fmla="*/ 89 h 89"/>
              <a:gd name="T14" fmla="*/ 1764 w 1809"/>
              <a:gd name="T15" fmla="*/ 89 h 89"/>
              <a:gd name="T16" fmla="*/ 1765 w 1809"/>
              <a:gd name="T17" fmla="*/ 89 h 89"/>
              <a:gd name="T18" fmla="*/ 1765 w 1809"/>
              <a:gd name="T19" fmla="*/ 89 h 89"/>
              <a:gd name="T20" fmla="*/ 1774 w 1809"/>
              <a:gd name="T21" fmla="*/ 89 h 89"/>
              <a:gd name="T22" fmla="*/ 1782 w 1809"/>
              <a:gd name="T23" fmla="*/ 86 h 89"/>
              <a:gd name="T24" fmla="*/ 1789 w 1809"/>
              <a:gd name="T25" fmla="*/ 82 h 89"/>
              <a:gd name="T26" fmla="*/ 1795 w 1809"/>
              <a:gd name="T27" fmla="*/ 76 h 89"/>
              <a:gd name="T28" fmla="*/ 1801 w 1809"/>
              <a:gd name="T29" fmla="*/ 70 h 89"/>
              <a:gd name="T30" fmla="*/ 1805 w 1809"/>
              <a:gd name="T31" fmla="*/ 63 h 89"/>
              <a:gd name="T32" fmla="*/ 1808 w 1809"/>
              <a:gd name="T33" fmla="*/ 55 h 89"/>
              <a:gd name="T34" fmla="*/ 1809 w 1809"/>
              <a:gd name="T35" fmla="*/ 45 h 89"/>
              <a:gd name="T36" fmla="*/ 1808 w 1809"/>
              <a:gd name="T37" fmla="*/ 37 h 89"/>
              <a:gd name="T38" fmla="*/ 1805 w 1809"/>
              <a:gd name="T39" fmla="*/ 29 h 89"/>
              <a:gd name="T40" fmla="*/ 1801 w 1809"/>
              <a:gd name="T41" fmla="*/ 22 h 89"/>
              <a:gd name="T42" fmla="*/ 1795 w 1809"/>
              <a:gd name="T43" fmla="*/ 15 h 89"/>
              <a:gd name="T44" fmla="*/ 1789 w 1809"/>
              <a:gd name="T45" fmla="*/ 10 h 89"/>
              <a:gd name="T46" fmla="*/ 1780 w 1809"/>
              <a:gd name="T47" fmla="*/ 5 h 89"/>
              <a:gd name="T48" fmla="*/ 1772 w 1809"/>
              <a:gd name="T49" fmla="*/ 1 h 89"/>
              <a:gd name="T50" fmla="*/ 1764 w 1809"/>
              <a:gd name="T51" fmla="*/ 0 h 89"/>
              <a:gd name="T52" fmla="*/ 0 w 1809"/>
              <a:gd name="T53" fmla="*/ 0 h 89"/>
              <a:gd name="T54" fmla="*/ 9 w 1809"/>
              <a:gd name="T55" fmla="*/ 1 h 89"/>
              <a:gd name="T56" fmla="*/ 17 w 1809"/>
              <a:gd name="T57" fmla="*/ 4 h 89"/>
              <a:gd name="T58" fmla="*/ 26 w 1809"/>
              <a:gd name="T59" fmla="*/ 8 h 89"/>
              <a:gd name="T60" fmla="*/ 32 w 1809"/>
              <a:gd name="T61" fmla="*/ 14 h 89"/>
              <a:gd name="T62" fmla="*/ 38 w 1809"/>
              <a:gd name="T63" fmla="*/ 20 h 89"/>
              <a:gd name="T64" fmla="*/ 42 w 1809"/>
              <a:gd name="T65" fmla="*/ 27 h 89"/>
              <a:gd name="T66" fmla="*/ 45 w 1809"/>
              <a:gd name="T67" fmla="*/ 35 h 89"/>
              <a:gd name="T68" fmla="*/ 45 w 1809"/>
              <a:gd name="T69" fmla="*/ 44 h 89"/>
              <a:gd name="T70" fmla="*/ 45 w 1809"/>
              <a:gd name="T71" fmla="*/ 53 h 89"/>
              <a:gd name="T72" fmla="*/ 42 w 1809"/>
              <a:gd name="T73" fmla="*/ 61 h 89"/>
              <a:gd name="T74" fmla="*/ 38 w 1809"/>
              <a:gd name="T75" fmla="*/ 70 h 89"/>
              <a:gd name="T76" fmla="*/ 32 w 1809"/>
              <a:gd name="T77" fmla="*/ 76 h 89"/>
              <a:gd name="T78" fmla="*/ 26 w 1809"/>
              <a:gd name="T79" fmla="*/ 82 h 89"/>
              <a:gd name="T80" fmla="*/ 17 w 1809"/>
              <a:gd name="T81" fmla="*/ 86 h 89"/>
              <a:gd name="T82" fmla="*/ 9 w 1809"/>
              <a:gd name="T83" fmla="*/ 89 h 89"/>
              <a:gd name="T84" fmla="*/ 0 w 1809"/>
              <a:gd name="T85" fmla="*/ 89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1809" h="89">
                <a:moveTo>
                  <a:pt x="0" y="89"/>
                </a:moveTo>
                <a:lnTo>
                  <a:pt x="1764" y="89"/>
                </a:lnTo>
                <a:lnTo>
                  <a:pt x="1764" y="89"/>
                </a:lnTo>
                <a:lnTo>
                  <a:pt x="1764" y="89"/>
                </a:lnTo>
                <a:lnTo>
                  <a:pt x="1764" y="89"/>
                </a:lnTo>
                <a:lnTo>
                  <a:pt x="1764" y="89"/>
                </a:lnTo>
                <a:lnTo>
                  <a:pt x="1764" y="89"/>
                </a:lnTo>
                <a:lnTo>
                  <a:pt x="1764" y="89"/>
                </a:lnTo>
                <a:lnTo>
                  <a:pt x="1765" y="89"/>
                </a:lnTo>
                <a:lnTo>
                  <a:pt x="1765" y="89"/>
                </a:lnTo>
                <a:lnTo>
                  <a:pt x="1774" y="89"/>
                </a:lnTo>
                <a:lnTo>
                  <a:pt x="1782" y="86"/>
                </a:lnTo>
                <a:lnTo>
                  <a:pt x="1789" y="82"/>
                </a:lnTo>
                <a:lnTo>
                  <a:pt x="1795" y="76"/>
                </a:lnTo>
                <a:lnTo>
                  <a:pt x="1801" y="70"/>
                </a:lnTo>
                <a:lnTo>
                  <a:pt x="1805" y="63"/>
                </a:lnTo>
                <a:lnTo>
                  <a:pt x="1808" y="55"/>
                </a:lnTo>
                <a:lnTo>
                  <a:pt x="1809" y="45"/>
                </a:lnTo>
                <a:lnTo>
                  <a:pt x="1808" y="37"/>
                </a:lnTo>
                <a:lnTo>
                  <a:pt x="1805" y="29"/>
                </a:lnTo>
                <a:lnTo>
                  <a:pt x="1801" y="22"/>
                </a:lnTo>
                <a:lnTo>
                  <a:pt x="1795" y="15"/>
                </a:lnTo>
                <a:lnTo>
                  <a:pt x="1789" y="10"/>
                </a:lnTo>
                <a:lnTo>
                  <a:pt x="1780" y="5"/>
                </a:lnTo>
                <a:lnTo>
                  <a:pt x="1772" y="1"/>
                </a:lnTo>
                <a:lnTo>
                  <a:pt x="1764" y="0"/>
                </a:lnTo>
                <a:lnTo>
                  <a:pt x="0" y="0"/>
                </a:lnTo>
                <a:lnTo>
                  <a:pt x="9" y="1"/>
                </a:lnTo>
                <a:lnTo>
                  <a:pt x="17" y="4"/>
                </a:lnTo>
                <a:lnTo>
                  <a:pt x="26" y="8"/>
                </a:lnTo>
                <a:lnTo>
                  <a:pt x="32" y="14"/>
                </a:lnTo>
                <a:lnTo>
                  <a:pt x="38" y="20"/>
                </a:lnTo>
                <a:lnTo>
                  <a:pt x="42" y="27"/>
                </a:lnTo>
                <a:lnTo>
                  <a:pt x="45" y="35"/>
                </a:lnTo>
                <a:lnTo>
                  <a:pt x="45" y="44"/>
                </a:lnTo>
                <a:lnTo>
                  <a:pt x="45" y="53"/>
                </a:lnTo>
                <a:lnTo>
                  <a:pt x="42" y="61"/>
                </a:lnTo>
                <a:lnTo>
                  <a:pt x="38" y="70"/>
                </a:lnTo>
                <a:lnTo>
                  <a:pt x="32" y="76"/>
                </a:lnTo>
                <a:lnTo>
                  <a:pt x="26" y="82"/>
                </a:lnTo>
                <a:lnTo>
                  <a:pt x="17" y="86"/>
                </a:lnTo>
                <a:lnTo>
                  <a:pt x="9" y="89"/>
                </a:lnTo>
                <a:lnTo>
                  <a:pt x="0" y="89"/>
                </a:lnTo>
                <a:close/>
              </a:path>
            </a:pathLst>
          </a:custGeom>
          <a:solidFill>
            <a:srgbClr val="FFCC99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56" name="Freeform 76"/>
          <p:cNvSpPr>
            <a:spLocks/>
          </p:cNvSpPr>
          <p:nvPr/>
        </p:nvSpPr>
        <p:spPr bwMode="auto">
          <a:xfrm>
            <a:off x="2316164" y="4689476"/>
            <a:ext cx="7615237" cy="119063"/>
          </a:xfrm>
          <a:custGeom>
            <a:avLst/>
            <a:gdLst>
              <a:gd name="T0" fmla="*/ 0 w 1809"/>
              <a:gd name="T1" fmla="*/ 89 h 89"/>
              <a:gd name="T2" fmla="*/ 1764 w 1809"/>
              <a:gd name="T3" fmla="*/ 89 h 89"/>
              <a:gd name="T4" fmla="*/ 1765 w 1809"/>
              <a:gd name="T5" fmla="*/ 89 h 89"/>
              <a:gd name="T6" fmla="*/ 1774 w 1809"/>
              <a:gd name="T7" fmla="*/ 89 h 89"/>
              <a:gd name="T8" fmla="*/ 1782 w 1809"/>
              <a:gd name="T9" fmla="*/ 86 h 89"/>
              <a:gd name="T10" fmla="*/ 1789 w 1809"/>
              <a:gd name="T11" fmla="*/ 82 h 89"/>
              <a:gd name="T12" fmla="*/ 1795 w 1809"/>
              <a:gd name="T13" fmla="*/ 76 h 89"/>
              <a:gd name="T14" fmla="*/ 1801 w 1809"/>
              <a:gd name="T15" fmla="*/ 70 h 89"/>
              <a:gd name="T16" fmla="*/ 1805 w 1809"/>
              <a:gd name="T17" fmla="*/ 63 h 89"/>
              <a:gd name="T18" fmla="*/ 1808 w 1809"/>
              <a:gd name="T19" fmla="*/ 55 h 89"/>
              <a:gd name="T20" fmla="*/ 1809 w 1809"/>
              <a:gd name="T21" fmla="*/ 45 h 89"/>
              <a:gd name="T22" fmla="*/ 1808 w 1809"/>
              <a:gd name="T23" fmla="*/ 37 h 89"/>
              <a:gd name="T24" fmla="*/ 1805 w 1809"/>
              <a:gd name="T25" fmla="*/ 29 h 89"/>
              <a:gd name="T26" fmla="*/ 1801 w 1809"/>
              <a:gd name="T27" fmla="*/ 22 h 89"/>
              <a:gd name="T28" fmla="*/ 1795 w 1809"/>
              <a:gd name="T29" fmla="*/ 15 h 89"/>
              <a:gd name="T30" fmla="*/ 1789 w 1809"/>
              <a:gd name="T31" fmla="*/ 10 h 89"/>
              <a:gd name="T32" fmla="*/ 1780 w 1809"/>
              <a:gd name="T33" fmla="*/ 5 h 89"/>
              <a:gd name="T34" fmla="*/ 1772 w 1809"/>
              <a:gd name="T35" fmla="*/ 1 h 89"/>
              <a:gd name="T36" fmla="*/ 1764 w 1809"/>
              <a:gd name="T37" fmla="*/ 0 h 89"/>
              <a:gd name="T38" fmla="*/ 0 w 1809"/>
              <a:gd name="T39" fmla="*/ 0 h 89"/>
              <a:gd name="T40" fmla="*/ 9 w 1809"/>
              <a:gd name="T41" fmla="*/ 1 h 89"/>
              <a:gd name="T42" fmla="*/ 17 w 1809"/>
              <a:gd name="T43" fmla="*/ 4 h 89"/>
              <a:gd name="T44" fmla="*/ 26 w 1809"/>
              <a:gd name="T45" fmla="*/ 8 h 89"/>
              <a:gd name="T46" fmla="*/ 32 w 1809"/>
              <a:gd name="T47" fmla="*/ 14 h 89"/>
              <a:gd name="T48" fmla="*/ 38 w 1809"/>
              <a:gd name="T49" fmla="*/ 20 h 89"/>
              <a:gd name="T50" fmla="*/ 42 w 1809"/>
              <a:gd name="T51" fmla="*/ 27 h 89"/>
              <a:gd name="T52" fmla="*/ 45 w 1809"/>
              <a:gd name="T53" fmla="*/ 35 h 89"/>
              <a:gd name="T54" fmla="*/ 45 w 1809"/>
              <a:gd name="T55" fmla="*/ 44 h 89"/>
              <a:gd name="T56" fmla="*/ 45 w 1809"/>
              <a:gd name="T57" fmla="*/ 53 h 89"/>
              <a:gd name="T58" fmla="*/ 42 w 1809"/>
              <a:gd name="T59" fmla="*/ 61 h 89"/>
              <a:gd name="T60" fmla="*/ 38 w 1809"/>
              <a:gd name="T61" fmla="*/ 70 h 89"/>
              <a:gd name="T62" fmla="*/ 32 w 1809"/>
              <a:gd name="T63" fmla="*/ 76 h 89"/>
              <a:gd name="T64" fmla="*/ 26 w 1809"/>
              <a:gd name="T65" fmla="*/ 82 h 89"/>
              <a:gd name="T66" fmla="*/ 17 w 1809"/>
              <a:gd name="T67" fmla="*/ 86 h 89"/>
              <a:gd name="T68" fmla="*/ 9 w 1809"/>
              <a:gd name="T69" fmla="*/ 89 h 89"/>
              <a:gd name="T70" fmla="*/ 0 w 1809"/>
              <a:gd name="T71" fmla="*/ 89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</a:cxnLst>
            <a:rect l="0" t="0" r="r" b="b"/>
            <a:pathLst>
              <a:path w="1809" h="89">
                <a:moveTo>
                  <a:pt x="0" y="89"/>
                </a:moveTo>
                <a:lnTo>
                  <a:pt x="1764" y="89"/>
                </a:lnTo>
                <a:lnTo>
                  <a:pt x="1765" y="89"/>
                </a:lnTo>
                <a:lnTo>
                  <a:pt x="1774" y="89"/>
                </a:lnTo>
                <a:lnTo>
                  <a:pt x="1782" y="86"/>
                </a:lnTo>
                <a:lnTo>
                  <a:pt x="1789" y="82"/>
                </a:lnTo>
                <a:lnTo>
                  <a:pt x="1795" y="76"/>
                </a:lnTo>
                <a:lnTo>
                  <a:pt x="1801" y="70"/>
                </a:lnTo>
                <a:lnTo>
                  <a:pt x="1805" y="63"/>
                </a:lnTo>
                <a:lnTo>
                  <a:pt x="1808" y="55"/>
                </a:lnTo>
                <a:lnTo>
                  <a:pt x="1809" y="45"/>
                </a:lnTo>
                <a:lnTo>
                  <a:pt x="1808" y="37"/>
                </a:lnTo>
                <a:lnTo>
                  <a:pt x="1805" y="29"/>
                </a:lnTo>
                <a:lnTo>
                  <a:pt x="1801" y="22"/>
                </a:lnTo>
                <a:lnTo>
                  <a:pt x="1795" y="15"/>
                </a:lnTo>
                <a:lnTo>
                  <a:pt x="1789" y="10"/>
                </a:lnTo>
                <a:lnTo>
                  <a:pt x="1780" y="5"/>
                </a:lnTo>
                <a:lnTo>
                  <a:pt x="1772" y="1"/>
                </a:lnTo>
                <a:lnTo>
                  <a:pt x="1764" y="0"/>
                </a:lnTo>
                <a:lnTo>
                  <a:pt x="0" y="0"/>
                </a:lnTo>
                <a:lnTo>
                  <a:pt x="9" y="1"/>
                </a:lnTo>
                <a:lnTo>
                  <a:pt x="17" y="4"/>
                </a:lnTo>
                <a:lnTo>
                  <a:pt x="26" y="8"/>
                </a:lnTo>
                <a:lnTo>
                  <a:pt x="32" y="14"/>
                </a:lnTo>
                <a:lnTo>
                  <a:pt x="38" y="20"/>
                </a:lnTo>
                <a:lnTo>
                  <a:pt x="42" y="27"/>
                </a:lnTo>
                <a:lnTo>
                  <a:pt x="45" y="35"/>
                </a:lnTo>
                <a:lnTo>
                  <a:pt x="45" y="44"/>
                </a:lnTo>
                <a:lnTo>
                  <a:pt x="45" y="53"/>
                </a:lnTo>
                <a:lnTo>
                  <a:pt x="42" y="61"/>
                </a:lnTo>
                <a:lnTo>
                  <a:pt x="38" y="70"/>
                </a:lnTo>
                <a:lnTo>
                  <a:pt x="32" y="76"/>
                </a:lnTo>
                <a:lnTo>
                  <a:pt x="26" y="82"/>
                </a:lnTo>
                <a:lnTo>
                  <a:pt x="17" y="86"/>
                </a:lnTo>
                <a:lnTo>
                  <a:pt x="9" y="89"/>
                </a:lnTo>
                <a:lnTo>
                  <a:pt x="0" y="89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57" name="Freeform 77"/>
          <p:cNvSpPr>
            <a:spLocks/>
          </p:cNvSpPr>
          <p:nvPr/>
        </p:nvSpPr>
        <p:spPr bwMode="auto">
          <a:xfrm>
            <a:off x="2216517" y="4684713"/>
            <a:ext cx="284341" cy="119062"/>
          </a:xfrm>
          <a:custGeom>
            <a:avLst/>
            <a:gdLst>
              <a:gd name="T0" fmla="*/ 45 w 89"/>
              <a:gd name="T1" fmla="*/ 89 h 89"/>
              <a:gd name="T2" fmla="*/ 53 w 89"/>
              <a:gd name="T3" fmla="*/ 89 h 89"/>
              <a:gd name="T4" fmla="*/ 61 w 89"/>
              <a:gd name="T5" fmla="*/ 86 h 89"/>
              <a:gd name="T6" fmla="*/ 70 w 89"/>
              <a:gd name="T7" fmla="*/ 82 h 89"/>
              <a:gd name="T8" fmla="*/ 76 w 89"/>
              <a:gd name="T9" fmla="*/ 76 h 89"/>
              <a:gd name="T10" fmla="*/ 82 w 89"/>
              <a:gd name="T11" fmla="*/ 70 h 89"/>
              <a:gd name="T12" fmla="*/ 86 w 89"/>
              <a:gd name="T13" fmla="*/ 61 h 89"/>
              <a:gd name="T14" fmla="*/ 89 w 89"/>
              <a:gd name="T15" fmla="*/ 53 h 89"/>
              <a:gd name="T16" fmla="*/ 89 w 89"/>
              <a:gd name="T17" fmla="*/ 45 h 89"/>
              <a:gd name="T18" fmla="*/ 89 w 89"/>
              <a:gd name="T19" fmla="*/ 35 h 89"/>
              <a:gd name="T20" fmla="*/ 86 w 89"/>
              <a:gd name="T21" fmla="*/ 27 h 89"/>
              <a:gd name="T22" fmla="*/ 82 w 89"/>
              <a:gd name="T23" fmla="*/ 20 h 89"/>
              <a:gd name="T24" fmla="*/ 76 w 89"/>
              <a:gd name="T25" fmla="*/ 14 h 89"/>
              <a:gd name="T26" fmla="*/ 70 w 89"/>
              <a:gd name="T27" fmla="*/ 8 h 89"/>
              <a:gd name="T28" fmla="*/ 61 w 89"/>
              <a:gd name="T29" fmla="*/ 4 h 89"/>
              <a:gd name="T30" fmla="*/ 53 w 89"/>
              <a:gd name="T31" fmla="*/ 1 h 89"/>
              <a:gd name="T32" fmla="*/ 45 w 89"/>
              <a:gd name="T33" fmla="*/ 0 h 89"/>
              <a:gd name="T34" fmla="*/ 35 w 89"/>
              <a:gd name="T35" fmla="*/ 1 h 89"/>
              <a:gd name="T36" fmla="*/ 27 w 89"/>
              <a:gd name="T37" fmla="*/ 4 h 89"/>
              <a:gd name="T38" fmla="*/ 20 w 89"/>
              <a:gd name="T39" fmla="*/ 8 h 89"/>
              <a:gd name="T40" fmla="*/ 14 w 89"/>
              <a:gd name="T41" fmla="*/ 14 h 89"/>
              <a:gd name="T42" fmla="*/ 8 w 89"/>
              <a:gd name="T43" fmla="*/ 20 h 89"/>
              <a:gd name="T44" fmla="*/ 4 w 89"/>
              <a:gd name="T45" fmla="*/ 27 h 89"/>
              <a:gd name="T46" fmla="*/ 1 w 89"/>
              <a:gd name="T47" fmla="*/ 35 h 89"/>
              <a:gd name="T48" fmla="*/ 0 w 89"/>
              <a:gd name="T49" fmla="*/ 45 h 89"/>
              <a:gd name="T50" fmla="*/ 1 w 89"/>
              <a:gd name="T51" fmla="*/ 53 h 89"/>
              <a:gd name="T52" fmla="*/ 4 w 89"/>
              <a:gd name="T53" fmla="*/ 61 h 89"/>
              <a:gd name="T54" fmla="*/ 8 w 89"/>
              <a:gd name="T55" fmla="*/ 70 h 89"/>
              <a:gd name="T56" fmla="*/ 14 w 89"/>
              <a:gd name="T57" fmla="*/ 76 h 89"/>
              <a:gd name="T58" fmla="*/ 20 w 89"/>
              <a:gd name="T59" fmla="*/ 82 h 89"/>
              <a:gd name="T60" fmla="*/ 27 w 89"/>
              <a:gd name="T61" fmla="*/ 86 h 89"/>
              <a:gd name="T62" fmla="*/ 35 w 89"/>
              <a:gd name="T63" fmla="*/ 89 h 89"/>
              <a:gd name="T64" fmla="*/ 45 w 89"/>
              <a:gd name="T65" fmla="*/ 89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</a:cxnLst>
            <a:rect l="0" t="0" r="r" b="b"/>
            <a:pathLst>
              <a:path w="89" h="89">
                <a:moveTo>
                  <a:pt x="45" y="89"/>
                </a:moveTo>
                <a:lnTo>
                  <a:pt x="53" y="89"/>
                </a:lnTo>
                <a:lnTo>
                  <a:pt x="61" y="86"/>
                </a:lnTo>
                <a:lnTo>
                  <a:pt x="70" y="82"/>
                </a:lnTo>
                <a:lnTo>
                  <a:pt x="76" y="76"/>
                </a:lnTo>
                <a:lnTo>
                  <a:pt x="82" y="70"/>
                </a:lnTo>
                <a:lnTo>
                  <a:pt x="86" y="61"/>
                </a:lnTo>
                <a:lnTo>
                  <a:pt x="89" y="53"/>
                </a:lnTo>
                <a:lnTo>
                  <a:pt x="89" y="45"/>
                </a:lnTo>
                <a:lnTo>
                  <a:pt x="89" y="35"/>
                </a:lnTo>
                <a:lnTo>
                  <a:pt x="86" y="27"/>
                </a:lnTo>
                <a:lnTo>
                  <a:pt x="82" y="20"/>
                </a:lnTo>
                <a:lnTo>
                  <a:pt x="76" y="14"/>
                </a:lnTo>
                <a:lnTo>
                  <a:pt x="70" y="8"/>
                </a:lnTo>
                <a:lnTo>
                  <a:pt x="61" y="4"/>
                </a:lnTo>
                <a:lnTo>
                  <a:pt x="53" y="1"/>
                </a:lnTo>
                <a:lnTo>
                  <a:pt x="45" y="0"/>
                </a:lnTo>
                <a:lnTo>
                  <a:pt x="35" y="1"/>
                </a:lnTo>
                <a:lnTo>
                  <a:pt x="27" y="4"/>
                </a:lnTo>
                <a:lnTo>
                  <a:pt x="20" y="8"/>
                </a:lnTo>
                <a:lnTo>
                  <a:pt x="14" y="14"/>
                </a:lnTo>
                <a:lnTo>
                  <a:pt x="8" y="20"/>
                </a:lnTo>
                <a:lnTo>
                  <a:pt x="4" y="27"/>
                </a:lnTo>
                <a:lnTo>
                  <a:pt x="1" y="35"/>
                </a:lnTo>
                <a:lnTo>
                  <a:pt x="0" y="45"/>
                </a:lnTo>
                <a:lnTo>
                  <a:pt x="1" y="53"/>
                </a:lnTo>
                <a:lnTo>
                  <a:pt x="4" y="61"/>
                </a:lnTo>
                <a:lnTo>
                  <a:pt x="8" y="70"/>
                </a:lnTo>
                <a:lnTo>
                  <a:pt x="14" y="76"/>
                </a:lnTo>
                <a:lnTo>
                  <a:pt x="20" y="82"/>
                </a:lnTo>
                <a:lnTo>
                  <a:pt x="27" y="86"/>
                </a:lnTo>
                <a:lnTo>
                  <a:pt x="35" y="89"/>
                </a:lnTo>
                <a:lnTo>
                  <a:pt x="45" y="89"/>
                </a:lnTo>
                <a:close/>
              </a:path>
            </a:pathLst>
          </a:custGeom>
          <a:solidFill>
            <a:srgbClr val="FFCC99"/>
          </a:solidFill>
          <a:ln w="12700" cmpd="sng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71758" name="Freeform 78"/>
          <p:cNvSpPr>
            <a:spLocks/>
          </p:cNvSpPr>
          <p:nvPr/>
        </p:nvSpPr>
        <p:spPr bwMode="auto">
          <a:xfrm>
            <a:off x="2225675" y="5006975"/>
            <a:ext cx="7831138" cy="127000"/>
          </a:xfrm>
          <a:custGeom>
            <a:avLst/>
            <a:gdLst>
              <a:gd name="T0" fmla="*/ 0 w 1809"/>
              <a:gd name="T1" fmla="*/ 88 h 88"/>
              <a:gd name="T2" fmla="*/ 1764 w 1809"/>
              <a:gd name="T3" fmla="*/ 88 h 88"/>
              <a:gd name="T4" fmla="*/ 1764 w 1809"/>
              <a:gd name="T5" fmla="*/ 88 h 88"/>
              <a:gd name="T6" fmla="*/ 1764 w 1809"/>
              <a:gd name="T7" fmla="*/ 88 h 88"/>
              <a:gd name="T8" fmla="*/ 1764 w 1809"/>
              <a:gd name="T9" fmla="*/ 88 h 88"/>
              <a:gd name="T10" fmla="*/ 1764 w 1809"/>
              <a:gd name="T11" fmla="*/ 88 h 88"/>
              <a:gd name="T12" fmla="*/ 1764 w 1809"/>
              <a:gd name="T13" fmla="*/ 88 h 88"/>
              <a:gd name="T14" fmla="*/ 1764 w 1809"/>
              <a:gd name="T15" fmla="*/ 88 h 88"/>
              <a:gd name="T16" fmla="*/ 1765 w 1809"/>
              <a:gd name="T17" fmla="*/ 88 h 88"/>
              <a:gd name="T18" fmla="*/ 1765 w 1809"/>
              <a:gd name="T19" fmla="*/ 88 h 88"/>
              <a:gd name="T20" fmla="*/ 1774 w 1809"/>
              <a:gd name="T21" fmla="*/ 87 h 88"/>
              <a:gd name="T22" fmla="*/ 1782 w 1809"/>
              <a:gd name="T23" fmla="*/ 84 h 88"/>
              <a:gd name="T24" fmla="*/ 1789 w 1809"/>
              <a:gd name="T25" fmla="*/ 80 h 88"/>
              <a:gd name="T26" fmla="*/ 1795 w 1809"/>
              <a:gd name="T27" fmla="*/ 75 h 88"/>
              <a:gd name="T28" fmla="*/ 1801 w 1809"/>
              <a:gd name="T29" fmla="*/ 69 h 88"/>
              <a:gd name="T30" fmla="*/ 1805 w 1809"/>
              <a:gd name="T31" fmla="*/ 61 h 88"/>
              <a:gd name="T32" fmla="*/ 1808 w 1809"/>
              <a:gd name="T33" fmla="*/ 53 h 88"/>
              <a:gd name="T34" fmla="*/ 1809 w 1809"/>
              <a:gd name="T35" fmla="*/ 45 h 88"/>
              <a:gd name="T36" fmla="*/ 1808 w 1809"/>
              <a:gd name="T37" fmla="*/ 37 h 88"/>
              <a:gd name="T38" fmla="*/ 1805 w 1809"/>
              <a:gd name="T39" fmla="*/ 28 h 88"/>
              <a:gd name="T40" fmla="*/ 1801 w 1809"/>
              <a:gd name="T41" fmla="*/ 20 h 88"/>
              <a:gd name="T42" fmla="*/ 1795 w 1809"/>
              <a:gd name="T43" fmla="*/ 13 h 88"/>
              <a:gd name="T44" fmla="*/ 1789 w 1809"/>
              <a:gd name="T45" fmla="*/ 8 h 88"/>
              <a:gd name="T46" fmla="*/ 1780 w 1809"/>
              <a:gd name="T47" fmla="*/ 4 h 88"/>
              <a:gd name="T48" fmla="*/ 1772 w 1809"/>
              <a:gd name="T49" fmla="*/ 1 h 88"/>
              <a:gd name="T50" fmla="*/ 1764 w 1809"/>
              <a:gd name="T51" fmla="*/ 0 h 88"/>
              <a:gd name="T52" fmla="*/ 0 w 1809"/>
              <a:gd name="T53" fmla="*/ 0 h 88"/>
              <a:gd name="T54" fmla="*/ 9 w 1809"/>
              <a:gd name="T55" fmla="*/ 1 h 88"/>
              <a:gd name="T56" fmla="*/ 17 w 1809"/>
              <a:gd name="T57" fmla="*/ 4 h 88"/>
              <a:gd name="T58" fmla="*/ 26 w 1809"/>
              <a:gd name="T59" fmla="*/ 8 h 88"/>
              <a:gd name="T60" fmla="*/ 32 w 1809"/>
              <a:gd name="T61" fmla="*/ 13 h 88"/>
              <a:gd name="T62" fmla="*/ 38 w 1809"/>
              <a:gd name="T63" fmla="*/ 19 h 88"/>
              <a:gd name="T64" fmla="*/ 42 w 1809"/>
              <a:gd name="T65" fmla="*/ 27 h 88"/>
              <a:gd name="T66" fmla="*/ 45 w 1809"/>
              <a:gd name="T67" fmla="*/ 35 h 88"/>
              <a:gd name="T68" fmla="*/ 45 w 1809"/>
              <a:gd name="T69" fmla="*/ 43 h 88"/>
              <a:gd name="T70" fmla="*/ 45 w 1809"/>
              <a:gd name="T71" fmla="*/ 53 h 88"/>
              <a:gd name="T72" fmla="*/ 42 w 1809"/>
              <a:gd name="T73" fmla="*/ 61 h 88"/>
              <a:gd name="T74" fmla="*/ 38 w 1809"/>
              <a:gd name="T75" fmla="*/ 68 h 88"/>
              <a:gd name="T76" fmla="*/ 32 w 1809"/>
              <a:gd name="T77" fmla="*/ 75 h 88"/>
              <a:gd name="T78" fmla="*/ 26 w 1809"/>
              <a:gd name="T79" fmla="*/ 80 h 88"/>
              <a:gd name="T80" fmla="*/ 17 w 1809"/>
              <a:gd name="T81" fmla="*/ 84 h 88"/>
              <a:gd name="T82" fmla="*/ 9 w 1809"/>
              <a:gd name="T83" fmla="*/ 87 h 88"/>
              <a:gd name="T84" fmla="*/ 0 w 1809"/>
              <a:gd name="T85" fmla="*/ 88 h 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1809" h="88">
                <a:moveTo>
                  <a:pt x="0" y="88"/>
                </a:moveTo>
                <a:lnTo>
                  <a:pt x="1764" y="88"/>
                </a:lnTo>
                <a:lnTo>
                  <a:pt x="1764" y="88"/>
                </a:lnTo>
                <a:lnTo>
                  <a:pt x="1764" y="88"/>
                </a:lnTo>
                <a:lnTo>
                  <a:pt x="1764" y="88"/>
                </a:lnTo>
                <a:lnTo>
                  <a:pt x="1764" y="88"/>
                </a:lnTo>
                <a:lnTo>
                  <a:pt x="1764" y="88"/>
                </a:lnTo>
                <a:lnTo>
                  <a:pt x="1764" y="88"/>
                </a:lnTo>
                <a:lnTo>
                  <a:pt x="1765" y="88"/>
                </a:lnTo>
                <a:lnTo>
                  <a:pt x="1765" y="88"/>
                </a:lnTo>
                <a:lnTo>
                  <a:pt x="1774" y="87"/>
                </a:lnTo>
                <a:lnTo>
                  <a:pt x="1782" y="84"/>
                </a:lnTo>
                <a:lnTo>
                  <a:pt x="1789" y="80"/>
                </a:lnTo>
                <a:lnTo>
                  <a:pt x="1795" y="75"/>
                </a:lnTo>
                <a:lnTo>
                  <a:pt x="1801" y="69"/>
                </a:lnTo>
                <a:lnTo>
                  <a:pt x="1805" y="61"/>
                </a:lnTo>
                <a:lnTo>
                  <a:pt x="1808" y="53"/>
                </a:lnTo>
                <a:lnTo>
                  <a:pt x="1809" y="45"/>
                </a:lnTo>
                <a:lnTo>
                  <a:pt x="1808" y="37"/>
                </a:lnTo>
                <a:lnTo>
                  <a:pt x="1805" y="28"/>
                </a:lnTo>
                <a:lnTo>
                  <a:pt x="1801" y="20"/>
                </a:lnTo>
                <a:lnTo>
                  <a:pt x="1795" y="13"/>
                </a:lnTo>
                <a:lnTo>
                  <a:pt x="1789" y="8"/>
                </a:lnTo>
                <a:lnTo>
                  <a:pt x="1780" y="4"/>
                </a:lnTo>
                <a:lnTo>
                  <a:pt x="1772" y="1"/>
                </a:lnTo>
                <a:lnTo>
                  <a:pt x="1764" y="0"/>
                </a:lnTo>
                <a:lnTo>
                  <a:pt x="0" y="0"/>
                </a:lnTo>
                <a:lnTo>
                  <a:pt x="9" y="1"/>
                </a:lnTo>
                <a:lnTo>
                  <a:pt x="17" y="4"/>
                </a:lnTo>
                <a:lnTo>
                  <a:pt x="26" y="8"/>
                </a:lnTo>
                <a:lnTo>
                  <a:pt x="32" y="13"/>
                </a:lnTo>
                <a:lnTo>
                  <a:pt x="38" y="19"/>
                </a:lnTo>
                <a:lnTo>
                  <a:pt x="42" y="27"/>
                </a:lnTo>
                <a:lnTo>
                  <a:pt x="45" y="35"/>
                </a:lnTo>
                <a:lnTo>
                  <a:pt x="45" y="43"/>
                </a:lnTo>
                <a:lnTo>
                  <a:pt x="45" y="53"/>
                </a:lnTo>
                <a:lnTo>
                  <a:pt x="42" y="61"/>
                </a:lnTo>
                <a:lnTo>
                  <a:pt x="38" y="68"/>
                </a:lnTo>
                <a:lnTo>
                  <a:pt x="32" y="75"/>
                </a:lnTo>
                <a:lnTo>
                  <a:pt x="26" y="80"/>
                </a:lnTo>
                <a:lnTo>
                  <a:pt x="17" y="84"/>
                </a:lnTo>
                <a:lnTo>
                  <a:pt x="9" y="87"/>
                </a:lnTo>
                <a:lnTo>
                  <a:pt x="0" y="88"/>
                </a:lnTo>
                <a:close/>
              </a:path>
            </a:pathLst>
          </a:custGeom>
          <a:solidFill>
            <a:srgbClr val="FFCC99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59" name="Freeform 79"/>
          <p:cNvSpPr>
            <a:spLocks/>
          </p:cNvSpPr>
          <p:nvPr/>
        </p:nvSpPr>
        <p:spPr bwMode="auto">
          <a:xfrm>
            <a:off x="2298701" y="5006976"/>
            <a:ext cx="7758113" cy="117475"/>
          </a:xfrm>
          <a:custGeom>
            <a:avLst/>
            <a:gdLst>
              <a:gd name="T0" fmla="*/ 0 w 1809"/>
              <a:gd name="T1" fmla="*/ 88 h 88"/>
              <a:gd name="T2" fmla="*/ 1764 w 1809"/>
              <a:gd name="T3" fmla="*/ 88 h 88"/>
              <a:gd name="T4" fmla="*/ 1765 w 1809"/>
              <a:gd name="T5" fmla="*/ 88 h 88"/>
              <a:gd name="T6" fmla="*/ 1774 w 1809"/>
              <a:gd name="T7" fmla="*/ 87 h 88"/>
              <a:gd name="T8" fmla="*/ 1782 w 1809"/>
              <a:gd name="T9" fmla="*/ 84 h 88"/>
              <a:gd name="T10" fmla="*/ 1789 w 1809"/>
              <a:gd name="T11" fmla="*/ 80 h 88"/>
              <a:gd name="T12" fmla="*/ 1795 w 1809"/>
              <a:gd name="T13" fmla="*/ 75 h 88"/>
              <a:gd name="T14" fmla="*/ 1801 w 1809"/>
              <a:gd name="T15" fmla="*/ 69 h 88"/>
              <a:gd name="T16" fmla="*/ 1805 w 1809"/>
              <a:gd name="T17" fmla="*/ 61 h 88"/>
              <a:gd name="T18" fmla="*/ 1808 w 1809"/>
              <a:gd name="T19" fmla="*/ 53 h 88"/>
              <a:gd name="T20" fmla="*/ 1809 w 1809"/>
              <a:gd name="T21" fmla="*/ 45 h 88"/>
              <a:gd name="T22" fmla="*/ 1808 w 1809"/>
              <a:gd name="T23" fmla="*/ 37 h 88"/>
              <a:gd name="T24" fmla="*/ 1805 w 1809"/>
              <a:gd name="T25" fmla="*/ 28 h 88"/>
              <a:gd name="T26" fmla="*/ 1801 w 1809"/>
              <a:gd name="T27" fmla="*/ 20 h 88"/>
              <a:gd name="T28" fmla="*/ 1795 w 1809"/>
              <a:gd name="T29" fmla="*/ 13 h 88"/>
              <a:gd name="T30" fmla="*/ 1789 w 1809"/>
              <a:gd name="T31" fmla="*/ 8 h 88"/>
              <a:gd name="T32" fmla="*/ 1780 w 1809"/>
              <a:gd name="T33" fmla="*/ 4 h 88"/>
              <a:gd name="T34" fmla="*/ 1772 w 1809"/>
              <a:gd name="T35" fmla="*/ 1 h 88"/>
              <a:gd name="T36" fmla="*/ 1764 w 1809"/>
              <a:gd name="T37" fmla="*/ 0 h 88"/>
              <a:gd name="T38" fmla="*/ 0 w 1809"/>
              <a:gd name="T39" fmla="*/ 0 h 88"/>
              <a:gd name="T40" fmla="*/ 9 w 1809"/>
              <a:gd name="T41" fmla="*/ 1 h 88"/>
              <a:gd name="T42" fmla="*/ 17 w 1809"/>
              <a:gd name="T43" fmla="*/ 4 h 88"/>
              <a:gd name="T44" fmla="*/ 26 w 1809"/>
              <a:gd name="T45" fmla="*/ 8 h 88"/>
              <a:gd name="T46" fmla="*/ 32 w 1809"/>
              <a:gd name="T47" fmla="*/ 13 h 88"/>
              <a:gd name="T48" fmla="*/ 38 w 1809"/>
              <a:gd name="T49" fmla="*/ 19 h 88"/>
              <a:gd name="T50" fmla="*/ 42 w 1809"/>
              <a:gd name="T51" fmla="*/ 27 h 88"/>
              <a:gd name="T52" fmla="*/ 45 w 1809"/>
              <a:gd name="T53" fmla="*/ 35 h 88"/>
              <a:gd name="T54" fmla="*/ 45 w 1809"/>
              <a:gd name="T55" fmla="*/ 43 h 88"/>
              <a:gd name="T56" fmla="*/ 45 w 1809"/>
              <a:gd name="T57" fmla="*/ 53 h 88"/>
              <a:gd name="T58" fmla="*/ 42 w 1809"/>
              <a:gd name="T59" fmla="*/ 61 h 88"/>
              <a:gd name="T60" fmla="*/ 38 w 1809"/>
              <a:gd name="T61" fmla="*/ 68 h 88"/>
              <a:gd name="T62" fmla="*/ 32 w 1809"/>
              <a:gd name="T63" fmla="*/ 75 h 88"/>
              <a:gd name="T64" fmla="*/ 26 w 1809"/>
              <a:gd name="T65" fmla="*/ 80 h 88"/>
              <a:gd name="T66" fmla="*/ 17 w 1809"/>
              <a:gd name="T67" fmla="*/ 84 h 88"/>
              <a:gd name="T68" fmla="*/ 9 w 1809"/>
              <a:gd name="T69" fmla="*/ 87 h 88"/>
              <a:gd name="T70" fmla="*/ 0 w 1809"/>
              <a:gd name="T71" fmla="*/ 88 h 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</a:cxnLst>
            <a:rect l="0" t="0" r="r" b="b"/>
            <a:pathLst>
              <a:path w="1809" h="88">
                <a:moveTo>
                  <a:pt x="0" y="88"/>
                </a:moveTo>
                <a:lnTo>
                  <a:pt x="1764" y="88"/>
                </a:lnTo>
                <a:lnTo>
                  <a:pt x="1765" y="88"/>
                </a:lnTo>
                <a:lnTo>
                  <a:pt x="1774" y="87"/>
                </a:lnTo>
                <a:lnTo>
                  <a:pt x="1782" y="84"/>
                </a:lnTo>
                <a:lnTo>
                  <a:pt x="1789" y="80"/>
                </a:lnTo>
                <a:lnTo>
                  <a:pt x="1795" y="75"/>
                </a:lnTo>
                <a:lnTo>
                  <a:pt x="1801" y="69"/>
                </a:lnTo>
                <a:lnTo>
                  <a:pt x="1805" y="61"/>
                </a:lnTo>
                <a:lnTo>
                  <a:pt x="1808" y="53"/>
                </a:lnTo>
                <a:lnTo>
                  <a:pt x="1809" y="45"/>
                </a:lnTo>
                <a:lnTo>
                  <a:pt x="1808" y="37"/>
                </a:lnTo>
                <a:lnTo>
                  <a:pt x="1805" y="28"/>
                </a:lnTo>
                <a:lnTo>
                  <a:pt x="1801" y="20"/>
                </a:lnTo>
                <a:lnTo>
                  <a:pt x="1795" y="13"/>
                </a:lnTo>
                <a:lnTo>
                  <a:pt x="1789" y="8"/>
                </a:lnTo>
                <a:lnTo>
                  <a:pt x="1780" y="4"/>
                </a:lnTo>
                <a:lnTo>
                  <a:pt x="1772" y="1"/>
                </a:lnTo>
                <a:lnTo>
                  <a:pt x="1764" y="0"/>
                </a:lnTo>
                <a:lnTo>
                  <a:pt x="0" y="0"/>
                </a:lnTo>
                <a:lnTo>
                  <a:pt x="9" y="1"/>
                </a:lnTo>
                <a:lnTo>
                  <a:pt x="17" y="4"/>
                </a:lnTo>
                <a:lnTo>
                  <a:pt x="26" y="8"/>
                </a:lnTo>
                <a:lnTo>
                  <a:pt x="32" y="13"/>
                </a:lnTo>
                <a:lnTo>
                  <a:pt x="38" y="19"/>
                </a:lnTo>
                <a:lnTo>
                  <a:pt x="42" y="27"/>
                </a:lnTo>
                <a:lnTo>
                  <a:pt x="45" y="35"/>
                </a:lnTo>
                <a:lnTo>
                  <a:pt x="45" y="43"/>
                </a:lnTo>
                <a:lnTo>
                  <a:pt x="45" y="53"/>
                </a:lnTo>
                <a:lnTo>
                  <a:pt x="42" y="61"/>
                </a:lnTo>
                <a:lnTo>
                  <a:pt x="38" y="68"/>
                </a:lnTo>
                <a:lnTo>
                  <a:pt x="32" y="75"/>
                </a:lnTo>
                <a:lnTo>
                  <a:pt x="26" y="80"/>
                </a:lnTo>
                <a:lnTo>
                  <a:pt x="17" y="84"/>
                </a:lnTo>
                <a:lnTo>
                  <a:pt x="9" y="87"/>
                </a:lnTo>
                <a:lnTo>
                  <a:pt x="0" y="88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61" name="Freeform 81"/>
          <p:cNvSpPr>
            <a:spLocks/>
          </p:cNvSpPr>
          <p:nvPr/>
        </p:nvSpPr>
        <p:spPr bwMode="auto">
          <a:xfrm>
            <a:off x="2765426" y="5364164"/>
            <a:ext cx="7292975" cy="130175"/>
          </a:xfrm>
          <a:custGeom>
            <a:avLst/>
            <a:gdLst>
              <a:gd name="T0" fmla="*/ 0 w 1809"/>
              <a:gd name="T1" fmla="*/ 87 h 87"/>
              <a:gd name="T2" fmla="*/ 1764 w 1809"/>
              <a:gd name="T3" fmla="*/ 87 h 87"/>
              <a:gd name="T4" fmla="*/ 1764 w 1809"/>
              <a:gd name="T5" fmla="*/ 87 h 87"/>
              <a:gd name="T6" fmla="*/ 1764 w 1809"/>
              <a:gd name="T7" fmla="*/ 87 h 87"/>
              <a:gd name="T8" fmla="*/ 1764 w 1809"/>
              <a:gd name="T9" fmla="*/ 87 h 87"/>
              <a:gd name="T10" fmla="*/ 1764 w 1809"/>
              <a:gd name="T11" fmla="*/ 87 h 87"/>
              <a:gd name="T12" fmla="*/ 1764 w 1809"/>
              <a:gd name="T13" fmla="*/ 87 h 87"/>
              <a:gd name="T14" fmla="*/ 1764 w 1809"/>
              <a:gd name="T15" fmla="*/ 87 h 87"/>
              <a:gd name="T16" fmla="*/ 1765 w 1809"/>
              <a:gd name="T17" fmla="*/ 87 h 87"/>
              <a:gd name="T18" fmla="*/ 1765 w 1809"/>
              <a:gd name="T19" fmla="*/ 87 h 87"/>
              <a:gd name="T20" fmla="*/ 1774 w 1809"/>
              <a:gd name="T21" fmla="*/ 87 h 87"/>
              <a:gd name="T22" fmla="*/ 1782 w 1809"/>
              <a:gd name="T23" fmla="*/ 84 h 87"/>
              <a:gd name="T24" fmla="*/ 1789 w 1809"/>
              <a:gd name="T25" fmla="*/ 80 h 87"/>
              <a:gd name="T26" fmla="*/ 1795 w 1809"/>
              <a:gd name="T27" fmla="*/ 75 h 87"/>
              <a:gd name="T28" fmla="*/ 1801 w 1809"/>
              <a:gd name="T29" fmla="*/ 68 h 87"/>
              <a:gd name="T30" fmla="*/ 1805 w 1809"/>
              <a:gd name="T31" fmla="*/ 61 h 87"/>
              <a:gd name="T32" fmla="*/ 1808 w 1809"/>
              <a:gd name="T33" fmla="*/ 53 h 87"/>
              <a:gd name="T34" fmla="*/ 1809 w 1809"/>
              <a:gd name="T35" fmla="*/ 43 h 87"/>
              <a:gd name="T36" fmla="*/ 1808 w 1809"/>
              <a:gd name="T37" fmla="*/ 35 h 87"/>
              <a:gd name="T38" fmla="*/ 1805 w 1809"/>
              <a:gd name="T39" fmla="*/ 27 h 87"/>
              <a:gd name="T40" fmla="*/ 1801 w 1809"/>
              <a:gd name="T41" fmla="*/ 20 h 87"/>
              <a:gd name="T42" fmla="*/ 1795 w 1809"/>
              <a:gd name="T43" fmla="*/ 13 h 87"/>
              <a:gd name="T44" fmla="*/ 1789 w 1809"/>
              <a:gd name="T45" fmla="*/ 8 h 87"/>
              <a:gd name="T46" fmla="*/ 1780 w 1809"/>
              <a:gd name="T47" fmla="*/ 4 h 87"/>
              <a:gd name="T48" fmla="*/ 1772 w 1809"/>
              <a:gd name="T49" fmla="*/ 1 h 87"/>
              <a:gd name="T50" fmla="*/ 1764 w 1809"/>
              <a:gd name="T51" fmla="*/ 0 h 87"/>
              <a:gd name="T52" fmla="*/ 0 w 1809"/>
              <a:gd name="T53" fmla="*/ 0 h 87"/>
              <a:gd name="T54" fmla="*/ 9 w 1809"/>
              <a:gd name="T55" fmla="*/ 0 h 87"/>
              <a:gd name="T56" fmla="*/ 17 w 1809"/>
              <a:gd name="T57" fmla="*/ 2 h 87"/>
              <a:gd name="T58" fmla="*/ 26 w 1809"/>
              <a:gd name="T59" fmla="*/ 6 h 87"/>
              <a:gd name="T60" fmla="*/ 32 w 1809"/>
              <a:gd name="T61" fmla="*/ 12 h 87"/>
              <a:gd name="T62" fmla="*/ 38 w 1809"/>
              <a:gd name="T63" fmla="*/ 19 h 87"/>
              <a:gd name="T64" fmla="*/ 42 w 1809"/>
              <a:gd name="T65" fmla="*/ 25 h 87"/>
              <a:gd name="T66" fmla="*/ 45 w 1809"/>
              <a:gd name="T67" fmla="*/ 34 h 87"/>
              <a:gd name="T68" fmla="*/ 45 w 1809"/>
              <a:gd name="T69" fmla="*/ 43 h 87"/>
              <a:gd name="T70" fmla="*/ 45 w 1809"/>
              <a:gd name="T71" fmla="*/ 51 h 87"/>
              <a:gd name="T72" fmla="*/ 42 w 1809"/>
              <a:gd name="T73" fmla="*/ 60 h 87"/>
              <a:gd name="T74" fmla="*/ 38 w 1809"/>
              <a:gd name="T75" fmla="*/ 68 h 87"/>
              <a:gd name="T76" fmla="*/ 32 w 1809"/>
              <a:gd name="T77" fmla="*/ 75 h 87"/>
              <a:gd name="T78" fmla="*/ 26 w 1809"/>
              <a:gd name="T79" fmla="*/ 80 h 87"/>
              <a:gd name="T80" fmla="*/ 17 w 1809"/>
              <a:gd name="T81" fmla="*/ 84 h 87"/>
              <a:gd name="T82" fmla="*/ 9 w 1809"/>
              <a:gd name="T83" fmla="*/ 87 h 87"/>
              <a:gd name="T84" fmla="*/ 0 w 1809"/>
              <a:gd name="T85" fmla="*/ 87 h 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1809" h="87">
                <a:moveTo>
                  <a:pt x="0" y="87"/>
                </a:moveTo>
                <a:lnTo>
                  <a:pt x="1764" y="87"/>
                </a:lnTo>
                <a:lnTo>
                  <a:pt x="1764" y="87"/>
                </a:lnTo>
                <a:lnTo>
                  <a:pt x="1764" y="87"/>
                </a:lnTo>
                <a:lnTo>
                  <a:pt x="1764" y="87"/>
                </a:lnTo>
                <a:lnTo>
                  <a:pt x="1764" y="87"/>
                </a:lnTo>
                <a:lnTo>
                  <a:pt x="1764" y="87"/>
                </a:lnTo>
                <a:lnTo>
                  <a:pt x="1764" y="87"/>
                </a:lnTo>
                <a:lnTo>
                  <a:pt x="1765" y="87"/>
                </a:lnTo>
                <a:lnTo>
                  <a:pt x="1765" y="87"/>
                </a:lnTo>
                <a:lnTo>
                  <a:pt x="1774" y="87"/>
                </a:lnTo>
                <a:lnTo>
                  <a:pt x="1782" y="84"/>
                </a:lnTo>
                <a:lnTo>
                  <a:pt x="1789" y="80"/>
                </a:lnTo>
                <a:lnTo>
                  <a:pt x="1795" y="75"/>
                </a:lnTo>
                <a:lnTo>
                  <a:pt x="1801" y="68"/>
                </a:lnTo>
                <a:lnTo>
                  <a:pt x="1805" y="61"/>
                </a:lnTo>
                <a:lnTo>
                  <a:pt x="1808" y="53"/>
                </a:lnTo>
                <a:lnTo>
                  <a:pt x="1809" y="43"/>
                </a:lnTo>
                <a:lnTo>
                  <a:pt x="1808" y="35"/>
                </a:lnTo>
                <a:lnTo>
                  <a:pt x="1805" y="27"/>
                </a:lnTo>
                <a:lnTo>
                  <a:pt x="1801" y="20"/>
                </a:lnTo>
                <a:lnTo>
                  <a:pt x="1795" y="13"/>
                </a:lnTo>
                <a:lnTo>
                  <a:pt x="1789" y="8"/>
                </a:lnTo>
                <a:lnTo>
                  <a:pt x="1780" y="4"/>
                </a:lnTo>
                <a:lnTo>
                  <a:pt x="1772" y="1"/>
                </a:lnTo>
                <a:lnTo>
                  <a:pt x="1764" y="0"/>
                </a:lnTo>
                <a:lnTo>
                  <a:pt x="0" y="0"/>
                </a:lnTo>
                <a:lnTo>
                  <a:pt x="9" y="0"/>
                </a:lnTo>
                <a:lnTo>
                  <a:pt x="17" y="2"/>
                </a:lnTo>
                <a:lnTo>
                  <a:pt x="26" y="6"/>
                </a:lnTo>
                <a:lnTo>
                  <a:pt x="32" y="12"/>
                </a:lnTo>
                <a:lnTo>
                  <a:pt x="38" y="19"/>
                </a:lnTo>
                <a:lnTo>
                  <a:pt x="42" y="25"/>
                </a:lnTo>
                <a:lnTo>
                  <a:pt x="45" y="34"/>
                </a:lnTo>
                <a:lnTo>
                  <a:pt x="45" y="43"/>
                </a:lnTo>
                <a:lnTo>
                  <a:pt x="45" y="51"/>
                </a:lnTo>
                <a:lnTo>
                  <a:pt x="42" y="60"/>
                </a:lnTo>
                <a:lnTo>
                  <a:pt x="38" y="68"/>
                </a:lnTo>
                <a:lnTo>
                  <a:pt x="32" y="75"/>
                </a:lnTo>
                <a:lnTo>
                  <a:pt x="26" y="80"/>
                </a:lnTo>
                <a:lnTo>
                  <a:pt x="17" y="84"/>
                </a:lnTo>
                <a:lnTo>
                  <a:pt x="9" y="87"/>
                </a:lnTo>
                <a:lnTo>
                  <a:pt x="0" y="87"/>
                </a:lnTo>
                <a:close/>
              </a:path>
            </a:pathLst>
          </a:custGeom>
          <a:solidFill>
            <a:srgbClr val="FFCC99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62" name="Freeform 82"/>
          <p:cNvSpPr>
            <a:spLocks/>
          </p:cNvSpPr>
          <p:nvPr/>
        </p:nvSpPr>
        <p:spPr bwMode="auto">
          <a:xfrm>
            <a:off x="2765425" y="5364164"/>
            <a:ext cx="7272338" cy="136525"/>
          </a:xfrm>
          <a:custGeom>
            <a:avLst/>
            <a:gdLst>
              <a:gd name="T0" fmla="*/ 0 w 1809"/>
              <a:gd name="T1" fmla="*/ 87 h 87"/>
              <a:gd name="T2" fmla="*/ 1764 w 1809"/>
              <a:gd name="T3" fmla="*/ 87 h 87"/>
              <a:gd name="T4" fmla="*/ 1765 w 1809"/>
              <a:gd name="T5" fmla="*/ 87 h 87"/>
              <a:gd name="T6" fmla="*/ 1774 w 1809"/>
              <a:gd name="T7" fmla="*/ 87 h 87"/>
              <a:gd name="T8" fmla="*/ 1782 w 1809"/>
              <a:gd name="T9" fmla="*/ 84 h 87"/>
              <a:gd name="T10" fmla="*/ 1789 w 1809"/>
              <a:gd name="T11" fmla="*/ 80 h 87"/>
              <a:gd name="T12" fmla="*/ 1795 w 1809"/>
              <a:gd name="T13" fmla="*/ 75 h 87"/>
              <a:gd name="T14" fmla="*/ 1801 w 1809"/>
              <a:gd name="T15" fmla="*/ 68 h 87"/>
              <a:gd name="T16" fmla="*/ 1805 w 1809"/>
              <a:gd name="T17" fmla="*/ 61 h 87"/>
              <a:gd name="T18" fmla="*/ 1808 w 1809"/>
              <a:gd name="T19" fmla="*/ 53 h 87"/>
              <a:gd name="T20" fmla="*/ 1809 w 1809"/>
              <a:gd name="T21" fmla="*/ 43 h 87"/>
              <a:gd name="T22" fmla="*/ 1808 w 1809"/>
              <a:gd name="T23" fmla="*/ 35 h 87"/>
              <a:gd name="T24" fmla="*/ 1805 w 1809"/>
              <a:gd name="T25" fmla="*/ 27 h 87"/>
              <a:gd name="T26" fmla="*/ 1801 w 1809"/>
              <a:gd name="T27" fmla="*/ 20 h 87"/>
              <a:gd name="T28" fmla="*/ 1795 w 1809"/>
              <a:gd name="T29" fmla="*/ 13 h 87"/>
              <a:gd name="T30" fmla="*/ 1789 w 1809"/>
              <a:gd name="T31" fmla="*/ 8 h 87"/>
              <a:gd name="T32" fmla="*/ 1780 w 1809"/>
              <a:gd name="T33" fmla="*/ 4 h 87"/>
              <a:gd name="T34" fmla="*/ 1772 w 1809"/>
              <a:gd name="T35" fmla="*/ 1 h 87"/>
              <a:gd name="T36" fmla="*/ 1764 w 1809"/>
              <a:gd name="T37" fmla="*/ 0 h 87"/>
              <a:gd name="T38" fmla="*/ 0 w 1809"/>
              <a:gd name="T39" fmla="*/ 0 h 87"/>
              <a:gd name="T40" fmla="*/ 9 w 1809"/>
              <a:gd name="T41" fmla="*/ 0 h 87"/>
              <a:gd name="T42" fmla="*/ 17 w 1809"/>
              <a:gd name="T43" fmla="*/ 2 h 87"/>
              <a:gd name="T44" fmla="*/ 26 w 1809"/>
              <a:gd name="T45" fmla="*/ 6 h 87"/>
              <a:gd name="T46" fmla="*/ 32 w 1809"/>
              <a:gd name="T47" fmla="*/ 12 h 87"/>
              <a:gd name="T48" fmla="*/ 38 w 1809"/>
              <a:gd name="T49" fmla="*/ 19 h 87"/>
              <a:gd name="T50" fmla="*/ 42 w 1809"/>
              <a:gd name="T51" fmla="*/ 25 h 87"/>
              <a:gd name="T52" fmla="*/ 45 w 1809"/>
              <a:gd name="T53" fmla="*/ 34 h 87"/>
              <a:gd name="T54" fmla="*/ 45 w 1809"/>
              <a:gd name="T55" fmla="*/ 43 h 87"/>
              <a:gd name="T56" fmla="*/ 45 w 1809"/>
              <a:gd name="T57" fmla="*/ 51 h 87"/>
              <a:gd name="T58" fmla="*/ 42 w 1809"/>
              <a:gd name="T59" fmla="*/ 60 h 87"/>
              <a:gd name="T60" fmla="*/ 38 w 1809"/>
              <a:gd name="T61" fmla="*/ 68 h 87"/>
              <a:gd name="T62" fmla="*/ 32 w 1809"/>
              <a:gd name="T63" fmla="*/ 75 h 87"/>
              <a:gd name="T64" fmla="*/ 26 w 1809"/>
              <a:gd name="T65" fmla="*/ 80 h 87"/>
              <a:gd name="T66" fmla="*/ 17 w 1809"/>
              <a:gd name="T67" fmla="*/ 84 h 87"/>
              <a:gd name="T68" fmla="*/ 9 w 1809"/>
              <a:gd name="T69" fmla="*/ 87 h 87"/>
              <a:gd name="T70" fmla="*/ 0 w 1809"/>
              <a:gd name="T71" fmla="*/ 87 h 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</a:cxnLst>
            <a:rect l="0" t="0" r="r" b="b"/>
            <a:pathLst>
              <a:path w="1809" h="87">
                <a:moveTo>
                  <a:pt x="0" y="87"/>
                </a:moveTo>
                <a:lnTo>
                  <a:pt x="1764" y="87"/>
                </a:lnTo>
                <a:lnTo>
                  <a:pt x="1765" y="87"/>
                </a:lnTo>
                <a:lnTo>
                  <a:pt x="1774" y="87"/>
                </a:lnTo>
                <a:lnTo>
                  <a:pt x="1782" y="84"/>
                </a:lnTo>
                <a:lnTo>
                  <a:pt x="1789" y="80"/>
                </a:lnTo>
                <a:lnTo>
                  <a:pt x="1795" y="75"/>
                </a:lnTo>
                <a:lnTo>
                  <a:pt x="1801" y="68"/>
                </a:lnTo>
                <a:lnTo>
                  <a:pt x="1805" y="61"/>
                </a:lnTo>
                <a:lnTo>
                  <a:pt x="1808" y="53"/>
                </a:lnTo>
                <a:lnTo>
                  <a:pt x="1809" y="43"/>
                </a:lnTo>
                <a:lnTo>
                  <a:pt x="1808" y="35"/>
                </a:lnTo>
                <a:lnTo>
                  <a:pt x="1805" y="27"/>
                </a:lnTo>
                <a:lnTo>
                  <a:pt x="1801" y="20"/>
                </a:lnTo>
                <a:lnTo>
                  <a:pt x="1795" y="13"/>
                </a:lnTo>
                <a:lnTo>
                  <a:pt x="1789" y="8"/>
                </a:lnTo>
                <a:lnTo>
                  <a:pt x="1780" y="4"/>
                </a:lnTo>
                <a:lnTo>
                  <a:pt x="1772" y="1"/>
                </a:lnTo>
                <a:lnTo>
                  <a:pt x="1764" y="0"/>
                </a:lnTo>
                <a:lnTo>
                  <a:pt x="0" y="0"/>
                </a:lnTo>
                <a:lnTo>
                  <a:pt x="9" y="0"/>
                </a:lnTo>
                <a:lnTo>
                  <a:pt x="17" y="2"/>
                </a:lnTo>
                <a:lnTo>
                  <a:pt x="26" y="6"/>
                </a:lnTo>
                <a:lnTo>
                  <a:pt x="32" y="12"/>
                </a:lnTo>
                <a:lnTo>
                  <a:pt x="38" y="19"/>
                </a:lnTo>
                <a:lnTo>
                  <a:pt x="42" y="25"/>
                </a:lnTo>
                <a:lnTo>
                  <a:pt x="45" y="34"/>
                </a:lnTo>
                <a:lnTo>
                  <a:pt x="45" y="43"/>
                </a:lnTo>
                <a:lnTo>
                  <a:pt x="45" y="51"/>
                </a:lnTo>
                <a:lnTo>
                  <a:pt x="42" y="60"/>
                </a:lnTo>
                <a:lnTo>
                  <a:pt x="38" y="68"/>
                </a:lnTo>
                <a:lnTo>
                  <a:pt x="32" y="75"/>
                </a:lnTo>
                <a:lnTo>
                  <a:pt x="26" y="80"/>
                </a:lnTo>
                <a:lnTo>
                  <a:pt x="17" y="84"/>
                </a:lnTo>
                <a:lnTo>
                  <a:pt x="9" y="87"/>
                </a:lnTo>
                <a:lnTo>
                  <a:pt x="0" y="87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64" name="Freeform 84"/>
          <p:cNvSpPr>
            <a:spLocks/>
          </p:cNvSpPr>
          <p:nvPr/>
        </p:nvSpPr>
        <p:spPr bwMode="auto">
          <a:xfrm>
            <a:off x="6581776" y="4564064"/>
            <a:ext cx="371475" cy="90487"/>
          </a:xfrm>
          <a:custGeom>
            <a:avLst/>
            <a:gdLst>
              <a:gd name="T0" fmla="*/ 89 w 178"/>
              <a:gd name="T1" fmla="*/ 66 h 66"/>
              <a:gd name="T2" fmla="*/ 107 w 178"/>
              <a:gd name="T3" fmla="*/ 65 h 66"/>
              <a:gd name="T4" fmla="*/ 123 w 178"/>
              <a:gd name="T5" fmla="*/ 64 h 66"/>
              <a:gd name="T6" fmla="*/ 138 w 178"/>
              <a:gd name="T7" fmla="*/ 60 h 66"/>
              <a:gd name="T8" fmla="*/ 152 w 178"/>
              <a:gd name="T9" fmla="*/ 55 h 66"/>
              <a:gd name="T10" fmla="*/ 163 w 178"/>
              <a:gd name="T11" fmla="*/ 51 h 66"/>
              <a:gd name="T12" fmla="*/ 171 w 178"/>
              <a:gd name="T13" fmla="*/ 46 h 66"/>
              <a:gd name="T14" fmla="*/ 174 w 178"/>
              <a:gd name="T15" fmla="*/ 43 h 66"/>
              <a:gd name="T16" fmla="*/ 176 w 178"/>
              <a:gd name="T17" fmla="*/ 39 h 66"/>
              <a:gd name="T18" fmla="*/ 178 w 178"/>
              <a:gd name="T19" fmla="*/ 36 h 66"/>
              <a:gd name="T20" fmla="*/ 178 w 178"/>
              <a:gd name="T21" fmla="*/ 32 h 66"/>
              <a:gd name="T22" fmla="*/ 178 w 178"/>
              <a:gd name="T23" fmla="*/ 30 h 66"/>
              <a:gd name="T24" fmla="*/ 176 w 178"/>
              <a:gd name="T25" fmla="*/ 25 h 66"/>
              <a:gd name="T26" fmla="*/ 174 w 178"/>
              <a:gd name="T27" fmla="*/ 23 h 66"/>
              <a:gd name="T28" fmla="*/ 171 w 178"/>
              <a:gd name="T29" fmla="*/ 20 h 66"/>
              <a:gd name="T30" fmla="*/ 163 w 178"/>
              <a:gd name="T31" fmla="*/ 15 h 66"/>
              <a:gd name="T32" fmla="*/ 152 w 178"/>
              <a:gd name="T33" fmla="*/ 9 h 66"/>
              <a:gd name="T34" fmla="*/ 138 w 178"/>
              <a:gd name="T35" fmla="*/ 5 h 66"/>
              <a:gd name="T36" fmla="*/ 123 w 178"/>
              <a:gd name="T37" fmla="*/ 2 h 66"/>
              <a:gd name="T38" fmla="*/ 107 w 178"/>
              <a:gd name="T39" fmla="*/ 1 h 66"/>
              <a:gd name="T40" fmla="*/ 89 w 178"/>
              <a:gd name="T41" fmla="*/ 0 h 66"/>
              <a:gd name="T42" fmla="*/ 71 w 178"/>
              <a:gd name="T43" fmla="*/ 1 h 66"/>
              <a:gd name="T44" fmla="*/ 55 w 178"/>
              <a:gd name="T45" fmla="*/ 2 h 66"/>
              <a:gd name="T46" fmla="*/ 40 w 178"/>
              <a:gd name="T47" fmla="*/ 5 h 66"/>
              <a:gd name="T48" fmla="*/ 26 w 178"/>
              <a:gd name="T49" fmla="*/ 9 h 66"/>
              <a:gd name="T50" fmla="*/ 15 w 178"/>
              <a:gd name="T51" fmla="*/ 15 h 66"/>
              <a:gd name="T52" fmla="*/ 7 w 178"/>
              <a:gd name="T53" fmla="*/ 20 h 66"/>
              <a:gd name="T54" fmla="*/ 5 w 178"/>
              <a:gd name="T55" fmla="*/ 23 h 66"/>
              <a:gd name="T56" fmla="*/ 3 w 178"/>
              <a:gd name="T57" fmla="*/ 25 h 66"/>
              <a:gd name="T58" fmla="*/ 2 w 178"/>
              <a:gd name="T59" fmla="*/ 30 h 66"/>
              <a:gd name="T60" fmla="*/ 0 w 178"/>
              <a:gd name="T61" fmla="*/ 32 h 66"/>
              <a:gd name="T62" fmla="*/ 2 w 178"/>
              <a:gd name="T63" fmla="*/ 36 h 66"/>
              <a:gd name="T64" fmla="*/ 3 w 178"/>
              <a:gd name="T65" fmla="*/ 39 h 66"/>
              <a:gd name="T66" fmla="*/ 5 w 178"/>
              <a:gd name="T67" fmla="*/ 43 h 66"/>
              <a:gd name="T68" fmla="*/ 7 w 178"/>
              <a:gd name="T69" fmla="*/ 46 h 66"/>
              <a:gd name="T70" fmla="*/ 15 w 178"/>
              <a:gd name="T71" fmla="*/ 51 h 66"/>
              <a:gd name="T72" fmla="*/ 26 w 178"/>
              <a:gd name="T73" fmla="*/ 55 h 66"/>
              <a:gd name="T74" fmla="*/ 40 w 178"/>
              <a:gd name="T75" fmla="*/ 60 h 66"/>
              <a:gd name="T76" fmla="*/ 55 w 178"/>
              <a:gd name="T77" fmla="*/ 64 h 66"/>
              <a:gd name="T78" fmla="*/ 71 w 178"/>
              <a:gd name="T79" fmla="*/ 65 h 66"/>
              <a:gd name="T80" fmla="*/ 89 w 178"/>
              <a:gd name="T81" fmla="*/ 66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78" h="66">
                <a:moveTo>
                  <a:pt x="89" y="66"/>
                </a:moveTo>
                <a:lnTo>
                  <a:pt x="107" y="65"/>
                </a:lnTo>
                <a:lnTo>
                  <a:pt x="123" y="64"/>
                </a:lnTo>
                <a:lnTo>
                  <a:pt x="138" y="60"/>
                </a:lnTo>
                <a:lnTo>
                  <a:pt x="152" y="55"/>
                </a:lnTo>
                <a:lnTo>
                  <a:pt x="163" y="51"/>
                </a:lnTo>
                <a:lnTo>
                  <a:pt x="171" y="46"/>
                </a:lnTo>
                <a:lnTo>
                  <a:pt x="174" y="43"/>
                </a:lnTo>
                <a:lnTo>
                  <a:pt x="176" y="39"/>
                </a:lnTo>
                <a:lnTo>
                  <a:pt x="178" y="36"/>
                </a:lnTo>
                <a:lnTo>
                  <a:pt x="178" y="32"/>
                </a:lnTo>
                <a:lnTo>
                  <a:pt x="178" y="30"/>
                </a:lnTo>
                <a:lnTo>
                  <a:pt x="176" y="25"/>
                </a:lnTo>
                <a:lnTo>
                  <a:pt x="174" y="23"/>
                </a:lnTo>
                <a:lnTo>
                  <a:pt x="171" y="20"/>
                </a:lnTo>
                <a:lnTo>
                  <a:pt x="163" y="15"/>
                </a:lnTo>
                <a:lnTo>
                  <a:pt x="152" y="9"/>
                </a:lnTo>
                <a:lnTo>
                  <a:pt x="138" y="5"/>
                </a:lnTo>
                <a:lnTo>
                  <a:pt x="123" y="2"/>
                </a:lnTo>
                <a:lnTo>
                  <a:pt x="107" y="1"/>
                </a:lnTo>
                <a:lnTo>
                  <a:pt x="89" y="0"/>
                </a:lnTo>
                <a:lnTo>
                  <a:pt x="71" y="1"/>
                </a:lnTo>
                <a:lnTo>
                  <a:pt x="55" y="2"/>
                </a:lnTo>
                <a:lnTo>
                  <a:pt x="40" y="5"/>
                </a:lnTo>
                <a:lnTo>
                  <a:pt x="26" y="9"/>
                </a:lnTo>
                <a:lnTo>
                  <a:pt x="15" y="15"/>
                </a:lnTo>
                <a:lnTo>
                  <a:pt x="7" y="20"/>
                </a:lnTo>
                <a:lnTo>
                  <a:pt x="5" y="23"/>
                </a:lnTo>
                <a:lnTo>
                  <a:pt x="3" y="25"/>
                </a:lnTo>
                <a:lnTo>
                  <a:pt x="2" y="30"/>
                </a:lnTo>
                <a:lnTo>
                  <a:pt x="0" y="32"/>
                </a:lnTo>
                <a:lnTo>
                  <a:pt x="2" y="36"/>
                </a:lnTo>
                <a:lnTo>
                  <a:pt x="3" y="39"/>
                </a:lnTo>
                <a:lnTo>
                  <a:pt x="5" y="43"/>
                </a:lnTo>
                <a:lnTo>
                  <a:pt x="7" y="46"/>
                </a:lnTo>
                <a:lnTo>
                  <a:pt x="15" y="51"/>
                </a:lnTo>
                <a:lnTo>
                  <a:pt x="26" y="55"/>
                </a:lnTo>
                <a:lnTo>
                  <a:pt x="40" y="60"/>
                </a:lnTo>
                <a:lnTo>
                  <a:pt x="55" y="64"/>
                </a:lnTo>
                <a:lnTo>
                  <a:pt x="71" y="65"/>
                </a:lnTo>
                <a:lnTo>
                  <a:pt x="89" y="66"/>
                </a:lnTo>
                <a:close/>
              </a:path>
            </a:pathLst>
          </a:custGeom>
          <a:solidFill>
            <a:srgbClr val="FF993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65" name="Freeform 85"/>
          <p:cNvSpPr>
            <a:spLocks/>
          </p:cNvSpPr>
          <p:nvPr/>
        </p:nvSpPr>
        <p:spPr bwMode="auto">
          <a:xfrm>
            <a:off x="6581776" y="4564064"/>
            <a:ext cx="371475" cy="90487"/>
          </a:xfrm>
          <a:custGeom>
            <a:avLst/>
            <a:gdLst>
              <a:gd name="T0" fmla="*/ 89 w 178"/>
              <a:gd name="T1" fmla="*/ 66 h 66"/>
              <a:gd name="T2" fmla="*/ 107 w 178"/>
              <a:gd name="T3" fmla="*/ 65 h 66"/>
              <a:gd name="T4" fmla="*/ 123 w 178"/>
              <a:gd name="T5" fmla="*/ 64 h 66"/>
              <a:gd name="T6" fmla="*/ 138 w 178"/>
              <a:gd name="T7" fmla="*/ 60 h 66"/>
              <a:gd name="T8" fmla="*/ 152 w 178"/>
              <a:gd name="T9" fmla="*/ 55 h 66"/>
              <a:gd name="T10" fmla="*/ 163 w 178"/>
              <a:gd name="T11" fmla="*/ 51 h 66"/>
              <a:gd name="T12" fmla="*/ 171 w 178"/>
              <a:gd name="T13" fmla="*/ 46 h 66"/>
              <a:gd name="T14" fmla="*/ 174 w 178"/>
              <a:gd name="T15" fmla="*/ 43 h 66"/>
              <a:gd name="T16" fmla="*/ 176 w 178"/>
              <a:gd name="T17" fmla="*/ 39 h 66"/>
              <a:gd name="T18" fmla="*/ 178 w 178"/>
              <a:gd name="T19" fmla="*/ 36 h 66"/>
              <a:gd name="T20" fmla="*/ 178 w 178"/>
              <a:gd name="T21" fmla="*/ 32 h 66"/>
              <a:gd name="T22" fmla="*/ 178 w 178"/>
              <a:gd name="T23" fmla="*/ 30 h 66"/>
              <a:gd name="T24" fmla="*/ 176 w 178"/>
              <a:gd name="T25" fmla="*/ 25 h 66"/>
              <a:gd name="T26" fmla="*/ 174 w 178"/>
              <a:gd name="T27" fmla="*/ 23 h 66"/>
              <a:gd name="T28" fmla="*/ 171 w 178"/>
              <a:gd name="T29" fmla="*/ 20 h 66"/>
              <a:gd name="T30" fmla="*/ 163 w 178"/>
              <a:gd name="T31" fmla="*/ 15 h 66"/>
              <a:gd name="T32" fmla="*/ 152 w 178"/>
              <a:gd name="T33" fmla="*/ 9 h 66"/>
              <a:gd name="T34" fmla="*/ 138 w 178"/>
              <a:gd name="T35" fmla="*/ 5 h 66"/>
              <a:gd name="T36" fmla="*/ 123 w 178"/>
              <a:gd name="T37" fmla="*/ 2 h 66"/>
              <a:gd name="T38" fmla="*/ 107 w 178"/>
              <a:gd name="T39" fmla="*/ 1 h 66"/>
              <a:gd name="T40" fmla="*/ 89 w 178"/>
              <a:gd name="T41" fmla="*/ 0 h 66"/>
              <a:gd name="T42" fmla="*/ 71 w 178"/>
              <a:gd name="T43" fmla="*/ 1 h 66"/>
              <a:gd name="T44" fmla="*/ 55 w 178"/>
              <a:gd name="T45" fmla="*/ 2 h 66"/>
              <a:gd name="T46" fmla="*/ 40 w 178"/>
              <a:gd name="T47" fmla="*/ 5 h 66"/>
              <a:gd name="T48" fmla="*/ 26 w 178"/>
              <a:gd name="T49" fmla="*/ 9 h 66"/>
              <a:gd name="T50" fmla="*/ 15 w 178"/>
              <a:gd name="T51" fmla="*/ 15 h 66"/>
              <a:gd name="T52" fmla="*/ 7 w 178"/>
              <a:gd name="T53" fmla="*/ 20 h 66"/>
              <a:gd name="T54" fmla="*/ 5 w 178"/>
              <a:gd name="T55" fmla="*/ 23 h 66"/>
              <a:gd name="T56" fmla="*/ 3 w 178"/>
              <a:gd name="T57" fmla="*/ 25 h 66"/>
              <a:gd name="T58" fmla="*/ 2 w 178"/>
              <a:gd name="T59" fmla="*/ 30 h 66"/>
              <a:gd name="T60" fmla="*/ 0 w 178"/>
              <a:gd name="T61" fmla="*/ 32 h 66"/>
              <a:gd name="T62" fmla="*/ 2 w 178"/>
              <a:gd name="T63" fmla="*/ 36 h 66"/>
              <a:gd name="T64" fmla="*/ 3 w 178"/>
              <a:gd name="T65" fmla="*/ 39 h 66"/>
              <a:gd name="T66" fmla="*/ 5 w 178"/>
              <a:gd name="T67" fmla="*/ 43 h 66"/>
              <a:gd name="T68" fmla="*/ 7 w 178"/>
              <a:gd name="T69" fmla="*/ 46 h 66"/>
              <a:gd name="T70" fmla="*/ 15 w 178"/>
              <a:gd name="T71" fmla="*/ 51 h 66"/>
              <a:gd name="T72" fmla="*/ 26 w 178"/>
              <a:gd name="T73" fmla="*/ 55 h 66"/>
              <a:gd name="T74" fmla="*/ 40 w 178"/>
              <a:gd name="T75" fmla="*/ 60 h 66"/>
              <a:gd name="T76" fmla="*/ 55 w 178"/>
              <a:gd name="T77" fmla="*/ 64 h 66"/>
              <a:gd name="T78" fmla="*/ 71 w 178"/>
              <a:gd name="T79" fmla="*/ 65 h 66"/>
              <a:gd name="T80" fmla="*/ 89 w 178"/>
              <a:gd name="T81" fmla="*/ 66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78" h="66">
                <a:moveTo>
                  <a:pt x="89" y="66"/>
                </a:moveTo>
                <a:lnTo>
                  <a:pt x="107" y="65"/>
                </a:lnTo>
                <a:lnTo>
                  <a:pt x="123" y="64"/>
                </a:lnTo>
                <a:lnTo>
                  <a:pt x="138" y="60"/>
                </a:lnTo>
                <a:lnTo>
                  <a:pt x="152" y="55"/>
                </a:lnTo>
                <a:lnTo>
                  <a:pt x="163" y="51"/>
                </a:lnTo>
                <a:lnTo>
                  <a:pt x="171" y="46"/>
                </a:lnTo>
                <a:lnTo>
                  <a:pt x="174" y="43"/>
                </a:lnTo>
                <a:lnTo>
                  <a:pt x="176" y="39"/>
                </a:lnTo>
                <a:lnTo>
                  <a:pt x="178" y="36"/>
                </a:lnTo>
                <a:lnTo>
                  <a:pt x="178" y="32"/>
                </a:lnTo>
                <a:lnTo>
                  <a:pt x="178" y="30"/>
                </a:lnTo>
                <a:lnTo>
                  <a:pt x="176" y="25"/>
                </a:lnTo>
                <a:lnTo>
                  <a:pt x="174" y="23"/>
                </a:lnTo>
                <a:lnTo>
                  <a:pt x="171" y="20"/>
                </a:lnTo>
                <a:lnTo>
                  <a:pt x="163" y="15"/>
                </a:lnTo>
                <a:lnTo>
                  <a:pt x="152" y="9"/>
                </a:lnTo>
                <a:lnTo>
                  <a:pt x="138" y="5"/>
                </a:lnTo>
                <a:lnTo>
                  <a:pt x="123" y="2"/>
                </a:lnTo>
                <a:lnTo>
                  <a:pt x="107" y="1"/>
                </a:lnTo>
                <a:lnTo>
                  <a:pt x="89" y="0"/>
                </a:lnTo>
                <a:lnTo>
                  <a:pt x="71" y="1"/>
                </a:lnTo>
                <a:lnTo>
                  <a:pt x="55" y="2"/>
                </a:lnTo>
                <a:lnTo>
                  <a:pt x="40" y="5"/>
                </a:lnTo>
                <a:lnTo>
                  <a:pt x="26" y="9"/>
                </a:lnTo>
                <a:lnTo>
                  <a:pt x="15" y="15"/>
                </a:lnTo>
                <a:lnTo>
                  <a:pt x="7" y="20"/>
                </a:lnTo>
                <a:lnTo>
                  <a:pt x="5" y="23"/>
                </a:lnTo>
                <a:lnTo>
                  <a:pt x="3" y="25"/>
                </a:lnTo>
                <a:lnTo>
                  <a:pt x="2" y="30"/>
                </a:lnTo>
                <a:lnTo>
                  <a:pt x="0" y="32"/>
                </a:lnTo>
                <a:lnTo>
                  <a:pt x="2" y="36"/>
                </a:lnTo>
                <a:lnTo>
                  <a:pt x="3" y="39"/>
                </a:lnTo>
                <a:lnTo>
                  <a:pt x="5" y="43"/>
                </a:lnTo>
                <a:lnTo>
                  <a:pt x="7" y="46"/>
                </a:lnTo>
                <a:lnTo>
                  <a:pt x="15" y="51"/>
                </a:lnTo>
                <a:lnTo>
                  <a:pt x="26" y="55"/>
                </a:lnTo>
                <a:lnTo>
                  <a:pt x="40" y="60"/>
                </a:lnTo>
                <a:lnTo>
                  <a:pt x="55" y="64"/>
                </a:lnTo>
                <a:lnTo>
                  <a:pt x="71" y="65"/>
                </a:lnTo>
                <a:lnTo>
                  <a:pt x="89" y="66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66" name="Freeform 86"/>
          <p:cNvSpPr>
            <a:spLocks/>
          </p:cNvSpPr>
          <p:nvPr/>
        </p:nvSpPr>
        <p:spPr bwMode="auto">
          <a:xfrm>
            <a:off x="7078663" y="4919663"/>
            <a:ext cx="368300" cy="87312"/>
          </a:xfrm>
          <a:custGeom>
            <a:avLst/>
            <a:gdLst>
              <a:gd name="T0" fmla="*/ 88 w 177"/>
              <a:gd name="T1" fmla="*/ 66 h 66"/>
              <a:gd name="T2" fmla="*/ 106 w 177"/>
              <a:gd name="T3" fmla="*/ 66 h 66"/>
              <a:gd name="T4" fmla="*/ 122 w 177"/>
              <a:gd name="T5" fmla="*/ 63 h 66"/>
              <a:gd name="T6" fmla="*/ 137 w 177"/>
              <a:gd name="T7" fmla="*/ 60 h 66"/>
              <a:gd name="T8" fmla="*/ 151 w 177"/>
              <a:gd name="T9" fmla="*/ 56 h 66"/>
              <a:gd name="T10" fmla="*/ 162 w 177"/>
              <a:gd name="T11" fmla="*/ 51 h 66"/>
              <a:gd name="T12" fmla="*/ 170 w 177"/>
              <a:gd name="T13" fmla="*/ 45 h 66"/>
              <a:gd name="T14" fmla="*/ 173 w 177"/>
              <a:gd name="T15" fmla="*/ 43 h 66"/>
              <a:gd name="T16" fmla="*/ 174 w 177"/>
              <a:gd name="T17" fmla="*/ 40 h 66"/>
              <a:gd name="T18" fmla="*/ 176 w 177"/>
              <a:gd name="T19" fmla="*/ 36 h 66"/>
              <a:gd name="T20" fmla="*/ 177 w 177"/>
              <a:gd name="T21" fmla="*/ 33 h 66"/>
              <a:gd name="T22" fmla="*/ 176 w 177"/>
              <a:gd name="T23" fmla="*/ 29 h 66"/>
              <a:gd name="T24" fmla="*/ 174 w 177"/>
              <a:gd name="T25" fmla="*/ 26 h 66"/>
              <a:gd name="T26" fmla="*/ 173 w 177"/>
              <a:gd name="T27" fmla="*/ 23 h 66"/>
              <a:gd name="T28" fmla="*/ 170 w 177"/>
              <a:gd name="T29" fmla="*/ 21 h 66"/>
              <a:gd name="T30" fmla="*/ 162 w 177"/>
              <a:gd name="T31" fmla="*/ 14 h 66"/>
              <a:gd name="T32" fmla="*/ 151 w 177"/>
              <a:gd name="T33" fmla="*/ 10 h 66"/>
              <a:gd name="T34" fmla="*/ 137 w 177"/>
              <a:gd name="T35" fmla="*/ 6 h 66"/>
              <a:gd name="T36" fmla="*/ 122 w 177"/>
              <a:gd name="T37" fmla="*/ 3 h 66"/>
              <a:gd name="T38" fmla="*/ 106 w 177"/>
              <a:gd name="T39" fmla="*/ 0 h 66"/>
              <a:gd name="T40" fmla="*/ 88 w 177"/>
              <a:gd name="T41" fmla="*/ 0 h 66"/>
              <a:gd name="T42" fmla="*/ 71 w 177"/>
              <a:gd name="T43" fmla="*/ 0 h 66"/>
              <a:gd name="T44" fmla="*/ 54 w 177"/>
              <a:gd name="T45" fmla="*/ 3 h 66"/>
              <a:gd name="T46" fmla="*/ 39 w 177"/>
              <a:gd name="T47" fmla="*/ 6 h 66"/>
              <a:gd name="T48" fmla="*/ 26 w 177"/>
              <a:gd name="T49" fmla="*/ 10 h 66"/>
              <a:gd name="T50" fmla="*/ 15 w 177"/>
              <a:gd name="T51" fmla="*/ 14 h 66"/>
              <a:gd name="T52" fmla="*/ 6 w 177"/>
              <a:gd name="T53" fmla="*/ 21 h 66"/>
              <a:gd name="T54" fmla="*/ 4 w 177"/>
              <a:gd name="T55" fmla="*/ 23 h 66"/>
              <a:gd name="T56" fmla="*/ 1 w 177"/>
              <a:gd name="T57" fmla="*/ 26 h 66"/>
              <a:gd name="T58" fmla="*/ 1 w 177"/>
              <a:gd name="T59" fmla="*/ 29 h 66"/>
              <a:gd name="T60" fmla="*/ 0 w 177"/>
              <a:gd name="T61" fmla="*/ 33 h 66"/>
              <a:gd name="T62" fmla="*/ 1 w 177"/>
              <a:gd name="T63" fmla="*/ 36 h 66"/>
              <a:gd name="T64" fmla="*/ 1 w 177"/>
              <a:gd name="T65" fmla="*/ 40 h 66"/>
              <a:gd name="T66" fmla="*/ 4 w 177"/>
              <a:gd name="T67" fmla="*/ 43 h 66"/>
              <a:gd name="T68" fmla="*/ 6 w 177"/>
              <a:gd name="T69" fmla="*/ 45 h 66"/>
              <a:gd name="T70" fmla="*/ 15 w 177"/>
              <a:gd name="T71" fmla="*/ 51 h 66"/>
              <a:gd name="T72" fmla="*/ 26 w 177"/>
              <a:gd name="T73" fmla="*/ 56 h 66"/>
              <a:gd name="T74" fmla="*/ 39 w 177"/>
              <a:gd name="T75" fmla="*/ 60 h 66"/>
              <a:gd name="T76" fmla="*/ 54 w 177"/>
              <a:gd name="T77" fmla="*/ 63 h 66"/>
              <a:gd name="T78" fmla="*/ 71 w 177"/>
              <a:gd name="T79" fmla="*/ 66 h 66"/>
              <a:gd name="T80" fmla="*/ 88 w 177"/>
              <a:gd name="T81" fmla="*/ 66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77" h="66">
                <a:moveTo>
                  <a:pt x="88" y="66"/>
                </a:moveTo>
                <a:lnTo>
                  <a:pt x="106" y="66"/>
                </a:lnTo>
                <a:lnTo>
                  <a:pt x="122" y="63"/>
                </a:lnTo>
                <a:lnTo>
                  <a:pt x="137" y="60"/>
                </a:lnTo>
                <a:lnTo>
                  <a:pt x="151" y="56"/>
                </a:lnTo>
                <a:lnTo>
                  <a:pt x="162" y="51"/>
                </a:lnTo>
                <a:lnTo>
                  <a:pt x="170" y="45"/>
                </a:lnTo>
                <a:lnTo>
                  <a:pt x="173" y="43"/>
                </a:lnTo>
                <a:lnTo>
                  <a:pt x="174" y="40"/>
                </a:lnTo>
                <a:lnTo>
                  <a:pt x="176" y="36"/>
                </a:lnTo>
                <a:lnTo>
                  <a:pt x="177" y="33"/>
                </a:lnTo>
                <a:lnTo>
                  <a:pt x="176" y="29"/>
                </a:lnTo>
                <a:lnTo>
                  <a:pt x="174" y="26"/>
                </a:lnTo>
                <a:lnTo>
                  <a:pt x="173" y="23"/>
                </a:lnTo>
                <a:lnTo>
                  <a:pt x="170" y="21"/>
                </a:lnTo>
                <a:lnTo>
                  <a:pt x="162" y="14"/>
                </a:lnTo>
                <a:lnTo>
                  <a:pt x="151" y="10"/>
                </a:lnTo>
                <a:lnTo>
                  <a:pt x="137" y="6"/>
                </a:lnTo>
                <a:lnTo>
                  <a:pt x="122" y="3"/>
                </a:lnTo>
                <a:lnTo>
                  <a:pt x="106" y="0"/>
                </a:lnTo>
                <a:lnTo>
                  <a:pt x="88" y="0"/>
                </a:lnTo>
                <a:lnTo>
                  <a:pt x="71" y="0"/>
                </a:lnTo>
                <a:lnTo>
                  <a:pt x="54" y="3"/>
                </a:lnTo>
                <a:lnTo>
                  <a:pt x="39" y="6"/>
                </a:lnTo>
                <a:lnTo>
                  <a:pt x="26" y="10"/>
                </a:lnTo>
                <a:lnTo>
                  <a:pt x="15" y="14"/>
                </a:lnTo>
                <a:lnTo>
                  <a:pt x="6" y="21"/>
                </a:lnTo>
                <a:lnTo>
                  <a:pt x="4" y="23"/>
                </a:lnTo>
                <a:lnTo>
                  <a:pt x="1" y="26"/>
                </a:lnTo>
                <a:lnTo>
                  <a:pt x="1" y="29"/>
                </a:lnTo>
                <a:lnTo>
                  <a:pt x="0" y="33"/>
                </a:lnTo>
                <a:lnTo>
                  <a:pt x="1" y="36"/>
                </a:lnTo>
                <a:lnTo>
                  <a:pt x="1" y="40"/>
                </a:lnTo>
                <a:lnTo>
                  <a:pt x="4" y="43"/>
                </a:lnTo>
                <a:lnTo>
                  <a:pt x="6" y="45"/>
                </a:lnTo>
                <a:lnTo>
                  <a:pt x="15" y="51"/>
                </a:lnTo>
                <a:lnTo>
                  <a:pt x="26" y="56"/>
                </a:lnTo>
                <a:lnTo>
                  <a:pt x="39" y="60"/>
                </a:lnTo>
                <a:lnTo>
                  <a:pt x="54" y="63"/>
                </a:lnTo>
                <a:lnTo>
                  <a:pt x="71" y="66"/>
                </a:lnTo>
                <a:lnTo>
                  <a:pt x="88" y="66"/>
                </a:lnTo>
                <a:close/>
              </a:path>
            </a:pathLst>
          </a:custGeom>
          <a:solidFill>
            <a:srgbClr val="FF993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67" name="Freeform 87"/>
          <p:cNvSpPr>
            <a:spLocks/>
          </p:cNvSpPr>
          <p:nvPr/>
        </p:nvSpPr>
        <p:spPr bwMode="auto">
          <a:xfrm>
            <a:off x="7078663" y="4919663"/>
            <a:ext cx="368300" cy="87312"/>
          </a:xfrm>
          <a:custGeom>
            <a:avLst/>
            <a:gdLst>
              <a:gd name="T0" fmla="*/ 88 w 177"/>
              <a:gd name="T1" fmla="*/ 66 h 66"/>
              <a:gd name="T2" fmla="*/ 106 w 177"/>
              <a:gd name="T3" fmla="*/ 66 h 66"/>
              <a:gd name="T4" fmla="*/ 122 w 177"/>
              <a:gd name="T5" fmla="*/ 63 h 66"/>
              <a:gd name="T6" fmla="*/ 137 w 177"/>
              <a:gd name="T7" fmla="*/ 60 h 66"/>
              <a:gd name="T8" fmla="*/ 151 w 177"/>
              <a:gd name="T9" fmla="*/ 56 h 66"/>
              <a:gd name="T10" fmla="*/ 162 w 177"/>
              <a:gd name="T11" fmla="*/ 51 h 66"/>
              <a:gd name="T12" fmla="*/ 170 w 177"/>
              <a:gd name="T13" fmla="*/ 45 h 66"/>
              <a:gd name="T14" fmla="*/ 173 w 177"/>
              <a:gd name="T15" fmla="*/ 43 h 66"/>
              <a:gd name="T16" fmla="*/ 174 w 177"/>
              <a:gd name="T17" fmla="*/ 40 h 66"/>
              <a:gd name="T18" fmla="*/ 176 w 177"/>
              <a:gd name="T19" fmla="*/ 36 h 66"/>
              <a:gd name="T20" fmla="*/ 177 w 177"/>
              <a:gd name="T21" fmla="*/ 33 h 66"/>
              <a:gd name="T22" fmla="*/ 176 w 177"/>
              <a:gd name="T23" fmla="*/ 29 h 66"/>
              <a:gd name="T24" fmla="*/ 174 w 177"/>
              <a:gd name="T25" fmla="*/ 26 h 66"/>
              <a:gd name="T26" fmla="*/ 173 w 177"/>
              <a:gd name="T27" fmla="*/ 23 h 66"/>
              <a:gd name="T28" fmla="*/ 170 w 177"/>
              <a:gd name="T29" fmla="*/ 21 h 66"/>
              <a:gd name="T30" fmla="*/ 162 w 177"/>
              <a:gd name="T31" fmla="*/ 14 h 66"/>
              <a:gd name="T32" fmla="*/ 151 w 177"/>
              <a:gd name="T33" fmla="*/ 10 h 66"/>
              <a:gd name="T34" fmla="*/ 137 w 177"/>
              <a:gd name="T35" fmla="*/ 6 h 66"/>
              <a:gd name="T36" fmla="*/ 122 w 177"/>
              <a:gd name="T37" fmla="*/ 3 h 66"/>
              <a:gd name="T38" fmla="*/ 106 w 177"/>
              <a:gd name="T39" fmla="*/ 0 h 66"/>
              <a:gd name="T40" fmla="*/ 88 w 177"/>
              <a:gd name="T41" fmla="*/ 0 h 66"/>
              <a:gd name="T42" fmla="*/ 71 w 177"/>
              <a:gd name="T43" fmla="*/ 0 h 66"/>
              <a:gd name="T44" fmla="*/ 54 w 177"/>
              <a:gd name="T45" fmla="*/ 3 h 66"/>
              <a:gd name="T46" fmla="*/ 39 w 177"/>
              <a:gd name="T47" fmla="*/ 6 h 66"/>
              <a:gd name="T48" fmla="*/ 26 w 177"/>
              <a:gd name="T49" fmla="*/ 10 h 66"/>
              <a:gd name="T50" fmla="*/ 15 w 177"/>
              <a:gd name="T51" fmla="*/ 14 h 66"/>
              <a:gd name="T52" fmla="*/ 6 w 177"/>
              <a:gd name="T53" fmla="*/ 21 h 66"/>
              <a:gd name="T54" fmla="*/ 4 w 177"/>
              <a:gd name="T55" fmla="*/ 23 h 66"/>
              <a:gd name="T56" fmla="*/ 1 w 177"/>
              <a:gd name="T57" fmla="*/ 26 h 66"/>
              <a:gd name="T58" fmla="*/ 1 w 177"/>
              <a:gd name="T59" fmla="*/ 29 h 66"/>
              <a:gd name="T60" fmla="*/ 0 w 177"/>
              <a:gd name="T61" fmla="*/ 33 h 66"/>
              <a:gd name="T62" fmla="*/ 1 w 177"/>
              <a:gd name="T63" fmla="*/ 36 h 66"/>
              <a:gd name="T64" fmla="*/ 1 w 177"/>
              <a:gd name="T65" fmla="*/ 40 h 66"/>
              <a:gd name="T66" fmla="*/ 4 w 177"/>
              <a:gd name="T67" fmla="*/ 43 h 66"/>
              <a:gd name="T68" fmla="*/ 6 w 177"/>
              <a:gd name="T69" fmla="*/ 45 h 66"/>
              <a:gd name="T70" fmla="*/ 15 w 177"/>
              <a:gd name="T71" fmla="*/ 51 h 66"/>
              <a:gd name="T72" fmla="*/ 26 w 177"/>
              <a:gd name="T73" fmla="*/ 56 h 66"/>
              <a:gd name="T74" fmla="*/ 39 w 177"/>
              <a:gd name="T75" fmla="*/ 60 h 66"/>
              <a:gd name="T76" fmla="*/ 54 w 177"/>
              <a:gd name="T77" fmla="*/ 63 h 66"/>
              <a:gd name="T78" fmla="*/ 71 w 177"/>
              <a:gd name="T79" fmla="*/ 66 h 66"/>
              <a:gd name="T80" fmla="*/ 88 w 177"/>
              <a:gd name="T81" fmla="*/ 66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77" h="66">
                <a:moveTo>
                  <a:pt x="88" y="66"/>
                </a:moveTo>
                <a:lnTo>
                  <a:pt x="106" y="66"/>
                </a:lnTo>
                <a:lnTo>
                  <a:pt x="122" y="63"/>
                </a:lnTo>
                <a:lnTo>
                  <a:pt x="137" y="60"/>
                </a:lnTo>
                <a:lnTo>
                  <a:pt x="151" y="56"/>
                </a:lnTo>
                <a:lnTo>
                  <a:pt x="162" y="51"/>
                </a:lnTo>
                <a:lnTo>
                  <a:pt x="170" y="45"/>
                </a:lnTo>
                <a:lnTo>
                  <a:pt x="173" y="43"/>
                </a:lnTo>
                <a:lnTo>
                  <a:pt x="174" y="40"/>
                </a:lnTo>
                <a:lnTo>
                  <a:pt x="176" y="36"/>
                </a:lnTo>
                <a:lnTo>
                  <a:pt x="177" y="33"/>
                </a:lnTo>
                <a:lnTo>
                  <a:pt x="176" y="29"/>
                </a:lnTo>
                <a:lnTo>
                  <a:pt x="174" y="26"/>
                </a:lnTo>
                <a:lnTo>
                  <a:pt x="173" y="23"/>
                </a:lnTo>
                <a:lnTo>
                  <a:pt x="170" y="21"/>
                </a:lnTo>
                <a:lnTo>
                  <a:pt x="162" y="14"/>
                </a:lnTo>
                <a:lnTo>
                  <a:pt x="151" y="10"/>
                </a:lnTo>
                <a:lnTo>
                  <a:pt x="137" y="6"/>
                </a:lnTo>
                <a:lnTo>
                  <a:pt x="122" y="3"/>
                </a:lnTo>
                <a:lnTo>
                  <a:pt x="106" y="0"/>
                </a:lnTo>
                <a:lnTo>
                  <a:pt x="88" y="0"/>
                </a:lnTo>
                <a:lnTo>
                  <a:pt x="71" y="0"/>
                </a:lnTo>
                <a:lnTo>
                  <a:pt x="54" y="3"/>
                </a:lnTo>
                <a:lnTo>
                  <a:pt x="39" y="6"/>
                </a:lnTo>
                <a:lnTo>
                  <a:pt x="26" y="10"/>
                </a:lnTo>
                <a:lnTo>
                  <a:pt x="15" y="14"/>
                </a:lnTo>
                <a:lnTo>
                  <a:pt x="6" y="21"/>
                </a:lnTo>
                <a:lnTo>
                  <a:pt x="4" y="23"/>
                </a:lnTo>
                <a:lnTo>
                  <a:pt x="1" y="26"/>
                </a:lnTo>
                <a:lnTo>
                  <a:pt x="1" y="29"/>
                </a:lnTo>
                <a:lnTo>
                  <a:pt x="0" y="33"/>
                </a:lnTo>
                <a:lnTo>
                  <a:pt x="1" y="36"/>
                </a:lnTo>
                <a:lnTo>
                  <a:pt x="1" y="40"/>
                </a:lnTo>
                <a:lnTo>
                  <a:pt x="4" y="43"/>
                </a:lnTo>
                <a:lnTo>
                  <a:pt x="6" y="45"/>
                </a:lnTo>
                <a:lnTo>
                  <a:pt x="15" y="51"/>
                </a:lnTo>
                <a:lnTo>
                  <a:pt x="26" y="56"/>
                </a:lnTo>
                <a:lnTo>
                  <a:pt x="39" y="60"/>
                </a:lnTo>
                <a:lnTo>
                  <a:pt x="54" y="63"/>
                </a:lnTo>
                <a:lnTo>
                  <a:pt x="71" y="66"/>
                </a:lnTo>
                <a:lnTo>
                  <a:pt x="88" y="66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68" name="Freeform 88"/>
          <p:cNvSpPr>
            <a:spLocks/>
          </p:cNvSpPr>
          <p:nvPr/>
        </p:nvSpPr>
        <p:spPr bwMode="auto">
          <a:xfrm>
            <a:off x="7716839" y="5272088"/>
            <a:ext cx="365125" cy="88900"/>
          </a:xfrm>
          <a:custGeom>
            <a:avLst/>
            <a:gdLst>
              <a:gd name="T0" fmla="*/ 88 w 177"/>
              <a:gd name="T1" fmla="*/ 67 h 67"/>
              <a:gd name="T2" fmla="*/ 106 w 177"/>
              <a:gd name="T3" fmla="*/ 65 h 67"/>
              <a:gd name="T4" fmla="*/ 122 w 177"/>
              <a:gd name="T5" fmla="*/ 64 h 67"/>
              <a:gd name="T6" fmla="*/ 137 w 177"/>
              <a:gd name="T7" fmla="*/ 61 h 67"/>
              <a:gd name="T8" fmla="*/ 151 w 177"/>
              <a:gd name="T9" fmla="*/ 57 h 67"/>
              <a:gd name="T10" fmla="*/ 162 w 177"/>
              <a:gd name="T11" fmla="*/ 52 h 67"/>
              <a:gd name="T12" fmla="*/ 170 w 177"/>
              <a:gd name="T13" fmla="*/ 46 h 67"/>
              <a:gd name="T14" fmla="*/ 173 w 177"/>
              <a:gd name="T15" fmla="*/ 43 h 67"/>
              <a:gd name="T16" fmla="*/ 174 w 177"/>
              <a:gd name="T17" fmla="*/ 39 h 67"/>
              <a:gd name="T18" fmla="*/ 176 w 177"/>
              <a:gd name="T19" fmla="*/ 37 h 67"/>
              <a:gd name="T20" fmla="*/ 177 w 177"/>
              <a:gd name="T21" fmla="*/ 32 h 67"/>
              <a:gd name="T22" fmla="*/ 176 w 177"/>
              <a:gd name="T23" fmla="*/ 30 h 67"/>
              <a:gd name="T24" fmla="*/ 174 w 177"/>
              <a:gd name="T25" fmla="*/ 27 h 67"/>
              <a:gd name="T26" fmla="*/ 173 w 177"/>
              <a:gd name="T27" fmla="*/ 23 h 67"/>
              <a:gd name="T28" fmla="*/ 170 w 177"/>
              <a:gd name="T29" fmla="*/ 20 h 67"/>
              <a:gd name="T30" fmla="*/ 162 w 177"/>
              <a:gd name="T31" fmla="*/ 15 h 67"/>
              <a:gd name="T32" fmla="*/ 151 w 177"/>
              <a:gd name="T33" fmla="*/ 9 h 67"/>
              <a:gd name="T34" fmla="*/ 137 w 177"/>
              <a:gd name="T35" fmla="*/ 5 h 67"/>
              <a:gd name="T36" fmla="*/ 122 w 177"/>
              <a:gd name="T37" fmla="*/ 2 h 67"/>
              <a:gd name="T38" fmla="*/ 106 w 177"/>
              <a:gd name="T39" fmla="*/ 1 h 67"/>
              <a:gd name="T40" fmla="*/ 88 w 177"/>
              <a:gd name="T41" fmla="*/ 0 h 67"/>
              <a:gd name="T42" fmla="*/ 71 w 177"/>
              <a:gd name="T43" fmla="*/ 1 h 67"/>
              <a:gd name="T44" fmla="*/ 54 w 177"/>
              <a:gd name="T45" fmla="*/ 2 h 67"/>
              <a:gd name="T46" fmla="*/ 39 w 177"/>
              <a:gd name="T47" fmla="*/ 5 h 67"/>
              <a:gd name="T48" fmla="*/ 26 w 177"/>
              <a:gd name="T49" fmla="*/ 9 h 67"/>
              <a:gd name="T50" fmla="*/ 15 w 177"/>
              <a:gd name="T51" fmla="*/ 15 h 67"/>
              <a:gd name="T52" fmla="*/ 7 w 177"/>
              <a:gd name="T53" fmla="*/ 20 h 67"/>
              <a:gd name="T54" fmla="*/ 4 w 177"/>
              <a:gd name="T55" fmla="*/ 23 h 67"/>
              <a:gd name="T56" fmla="*/ 1 w 177"/>
              <a:gd name="T57" fmla="*/ 27 h 67"/>
              <a:gd name="T58" fmla="*/ 0 w 177"/>
              <a:gd name="T59" fmla="*/ 30 h 67"/>
              <a:gd name="T60" fmla="*/ 0 w 177"/>
              <a:gd name="T61" fmla="*/ 32 h 67"/>
              <a:gd name="T62" fmla="*/ 0 w 177"/>
              <a:gd name="T63" fmla="*/ 37 h 67"/>
              <a:gd name="T64" fmla="*/ 1 w 177"/>
              <a:gd name="T65" fmla="*/ 39 h 67"/>
              <a:gd name="T66" fmla="*/ 4 w 177"/>
              <a:gd name="T67" fmla="*/ 43 h 67"/>
              <a:gd name="T68" fmla="*/ 7 w 177"/>
              <a:gd name="T69" fmla="*/ 46 h 67"/>
              <a:gd name="T70" fmla="*/ 15 w 177"/>
              <a:gd name="T71" fmla="*/ 52 h 67"/>
              <a:gd name="T72" fmla="*/ 26 w 177"/>
              <a:gd name="T73" fmla="*/ 57 h 67"/>
              <a:gd name="T74" fmla="*/ 39 w 177"/>
              <a:gd name="T75" fmla="*/ 61 h 67"/>
              <a:gd name="T76" fmla="*/ 54 w 177"/>
              <a:gd name="T77" fmla="*/ 64 h 67"/>
              <a:gd name="T78" fmla="*/ 71 w 177"/>
              <a:gd name="T79" fmla="*/ 65 h 67"/>
              <a:gd name="T80" fmla="*/ 88 w 177"/>
              <a:gd name="T81" fmla="*/ 67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77" h="67">
                <a:moveTo>
                  <a:pt x="88" y="67"/>
                </a:moveTo>
                <a:lnTo>
                  <a:pt x="106" y="65"/>
                </a:lnTo>
                <a:lnTo>
                  <a:pt x="122" y="64"/>
                </a:lnTo>
                <a:lnTo>
                  <a:pt x="137" y="61"/>
                </a:lnTo>
                <a:lnTo>
                  <a:pt x="151" y="57"/>
                </a:lnTo>
                <a:lnTo>
                  <a:pt x="162" y="52"/>
                </a:lnTo>
                <a:lnTo>
                  <a:pt x="170" y="46"/>
                </a:lnTo>
                <a:lnTo>
                  <a:pt x="173" y="43"/>
                </a:lnTo>
                <a:lnTo>
                  <a:pt x="174" y="39"/>
                </a:lnTo>
                <a:lnTo>
                  <a:pt x="176" y="37"/>
                </a:lnTo>
                <a:lnTo>
                  <a:pt x="177" y="32"/>
                </a:lnTo>
                <a:lnTo>
                  <a:pt x="176" y="30"/>
                </a:lnTo>
                <a:lnTo>
                  <a:pt x="174" y="27"/>
                </a:lnTo>
                <a:lnTo>
                  <a:pt x="173" y="23"/>
                </a:lnTo>
                <a:lnTo>
                  <a:pt x="170" y="20"/>
                </a:lnTo>
                <a:lnTo>
                  <a:pt x="162" y="15"/>
                </a:lnTo>
                <a:lnTo>
                  <a:pt x="151" y="9"/>
                </a:lnTo>
                <a:lnTo>
                  <a:pt x="137" y="5"/>
                </a:lnTo>
                <a:lnTo>
                  <a:pt x="122" y="2"/>
                </a:lnTo>
                <a:lnTo>
                  <a:pt x="106" y="1"/>
                </a:lnTo>
                <a:lnTo>
                  <a:pt x="88" y="0"/>
                </a:lnTo>
                <a:lnTo>
                  <a:pt x="71" y="1"/>
                </a:lnTo>
                <a:lnTo>
                  <a:pt x="54" y="2"/>
                </a:lnTo>
                <a:lnTo>
                  <a:pt x="39" y="5"/>
                </a:lnTo>
                <a:lnTo>
                  <a:pt x="26" y="9"/>
                </a:lnTo>
                <a:lnTo>
                  <a:pt x="15" y="15"/>
                </a:lnTo>
                <a:lnTo>
                  <a:pt x="7" y="20"/>
                </a:lnTo>
                <a:lnTo>
                  <a:pt x="4" y="23"/>
                </a:lnTo>
                <a:lnTo>
                  <a:pt x="1" y="27"/>
                </a:lnTo>
                <a:lnTo>
                  <a:pt x="0" y="30"/>
                </a:lnTo>
                <a:lnTo>
                  <a:pt x="0" y="32"/>
                </a:lnTo>
                <a:lnTo>
                  <a:pt x="0" y="37"/>
                </a:lnTo>
                <a:lnTo>
                  <a:pt x="1" y="39"/>
                </a:lnTo>
                <a:lnTo>
                  <a:pt x="4" y="43"/>
                </a:lnTo>
                <a:lnTo>
                  <a:pt x="7" y="46"/>
                </a:lnTo>
                <a:lnTo>
                  <a:pt x="15" y="52"/>
                </a:lnTo>
                <a:lnTo>
                  <a:pt x="26" y="57"/>
                </a:lnTo>
                <a:lnTo>
                  <a:pt x="39" y="61"/>
                </a:lnTo>
                <a:lnTo>
                  <a:pt x="54" y="64"/>
                </a:lnTo>
                <a:lnTo>
                  <a:pt x="71" y="65"/>
                </a:lnTo>
                <a:lnTo>
                  <a:pt x="88" y="67"/>
                </a:lnTo>
                <a:close/>
              </a:path>
            </a:pathLst>
          </a:custGeom>
          <a:solidFill>
            <a:srgbClr val="FF993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69" name="Freeform 89"/>
          <p:cNvSpPr>
            <a:spLocks/>
          </p:cNvSpPr>
          <p:nvPr/>
        </p:nvSpPr>
        <p:spPr bwMode="auto">
          <a:xfrm>
            <a:off x="7716839" y="5272088"/>
            <a:ext cx="365125" cy="88900"/>
          </a:xfrm>
          <a:custGeom>
            <a:avLst/>
            <a:gdLst>
              <a:gd name="T0" fmla="*/ 88 w 177"/>
              <a:gd name="T1" fmla="*/ 67 h 67"/>
              <a:gd name="T2" fmla="*/ 106 w 177"/>
              <a:gd name="T3" fmla="*/ 65 h 67"/>
              <a:gd name="T4" fmla="*/ 122 w 177"/>
              <a:gd name="T5" fmla="*/ 64 h 67"/>
              <a:gd name="T6" fmla="*/ 137 w 177"/>
              <a:gd name="T7" fmla="*/ 61 h 67"/>
              <a:gd name="T8" fmla="*/ 151 w 177"/>
              <a:gd name="T9" fmla="*/ 57 h 67"/>
              <a:gd name="T10" fmla="*/ 162 w 177"/>
              <a:gd name="T11" fmla="*/ 52 h 67"/>
              <a:gd name="T12" fmla="*/ 170 w 177"/>
              <a:gd name="T13" fmla="*/ 46 h 67"/>
              <a:gd name="T14" fmla="*/ 173 w 177"/>
              <a:gd name="T15" fmla="*/ 43 h 67"/>
              <a:gd name="T16" fmla="*/ 174 w 177"/>
              <a:gd name="T17" fmla="*/ 39 h 67"/>
              <a:gd name="T18" fmla="*/ 176 w 177"/>
              <a:gd name="T19" fmla="*/ 37 h 67"/>
              <a:gd name="T20" fmla="*/ 177 w 177"/>
              <a:gd name="T21" fmla="*/ 32 h 67"/>
              <a:gd name="T22" fmla="*/ 176 w 177"/>
              <a:gd name="T23" fmla="*/ 30 h 67"/>
              <a:gd name="T24" fmla="*/ 174 w 177"/>
              <a:gd name="T25" fmla="*/ 27 h 67"/>
              <a:gd name="T26" fmla="*/ 173 w 177"/>
              <a:gd name="T27" fmla="*/ 23 h 67"/>
              <a:gd name="T28" fmla="*/ 170 w 177"/>
              <a:gd name="T29" fmla="*/ 20 h 67"/>
              <a:gd name="T30" fmla="*/ 162 w 177"/>
              <a:gd name="T31" fmla="*/ 15 h 67"/>
              <a:gd name="T32" fmla="*/ 151 w 177"/>
              <a:gd name="T33" fmla="*/ 9 h 67"/>
              <a:gd name="T34" fmla="*/ 137 w 177"/>
              <a:gd name="T35" fmla="*/ 5 h 67"/>
              <a:gd name="T36" fmla="*/ 122 w 177"/>
              <a:gd name="T37" fmla="*/ 2 h 67"/>
              <a:gd name="T38" fmla="*/ 106 w 177"/>
              <a:gd name="T39" fmla="*/ 1 h 67"/>
              <a:gd name="T40" fmla="*/ 88 w 177"/>
              <a:gd name="T41" fmla="*/ 0 h 67"/>
              <a:gd name="T42" fmla="*/ 71 w 177"/>
              <a:gd name="T43" fmla="*/ 1 h 67"/>
              <a:gd name="T44" fmla="*/ 54 w 177"/>
              <a:gd name="T45" fmla="*/ 2 h 67"/>
              <a:gd name="T46" fmla="*/ 39 w 177"/>
              <a:gd name="T47" fmla="*/ 5 h 67"/>
              <a:gd name="T48" fmla="*/ 26 w 177"/>
              <a:gd name="T49" fmla="*/ 9 h 67"/>
              <a:gd name="T50" fmla="*/ 15 w 177"/>
              <a:gd name="T51" fmla="*/ 15 h 67"/>
              <a:gd name="T52" fmla="*/ 7 w 177"/>
              <a:gd name="T53" fmla="*/ 20 h 67"/>
              <a:gd name="T54" fmla="*/ 4 w 177"/>
              <a:gd name="T55" fmla="*/ 23 h 67"/>
              <a:gd name="T56" fmla="*/ 1 w 177"/>
              <a:gd name="T57" fmla="*/ 27 h 67"/>
              <a:gd name="T58" fmla="*/ 0 w 177"/>
              <a:gd name="T59" fmla="*/ 30 h 67"/>
              <a:gd name="T60" fmla="*/ 0 w 177"/>
              <a:gd name="T61" fmla="*/ 32 h 67"/>
              <a:gd name="T62" fmla="*/ 0 w 177"/>
              <a:gd name="T63" fmla="*/ 37 h 67"/>
              <a:gd name="T64" fmla="*/ 1 w 177"/>
              <a:gd name="T65" fmla="*/ 39 h 67"/>
              <a:gd name="T66" fmla="*/ 4 w 177"/>
              <a:gd name="T67" fmla="*/ 43 h 67"/>
              <a:gd name="T68" fmla="*/ 7 w 177"/>
              <a:gd name="T69" fmla="*/ 46 h 67"/>
              <a:gd name="T70" fmla="*/ 15 w 177"/>
              <a:gd name="T71" fmla="*/ 52 h 67"/>
              <a:gd name="T72" fmla="*/ 26 w 177"/>
              <a:gd name="T73" fmla="*/ 57 h 67"/>
              <a:gd name="T74" fmla="*/ 39 w 177"/>
              <a:gd name="T75" fmla="*/ 61 h 67"/>
              <a:gd name="T76" fmla="*/ 54 w 177"/>
              <a:gd name="T77" fmla="*/ 64 h 67"/>
              <a:gd name="T78" fmla="*/ 71 w 177"/>
              <a:gd name="T79" fmla="*/ 65 h 67"/>
              <a:gd name="T80" fmla="*/ 88 w 177"/>
              <a:gd name="T81" fmla="*/ 67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77" h="67">
                <a:moveTo>
                  <a:pt x="88" y="67"/>
                </a:moveTo>
                <a:lnTo>
                  <a:pt x="106" y="65"/>
                </a:lnTo>
                <a:lnTo>
                  <a:pt x="122" y="64"/>
                </a:lnTo>
                <a:lnTo>
                  <a:pt x="137" y="61"/>
                </a:lnTo>
                <a:lnTo>
                  <a:pt x="151" y="57"/>
                </a:lnTo>
                <a:lnTo>
                  <a:pt x="162" y="52"/>
                </a:lnTo>
                <a:lnTo>
                  <a:pt x="170" y="46"/>
                </a:lnTo>
                <a:lnTo>
                  <a:pt x="173" y="43"/>
                </a:lnTo>
                <a:lnTo>
                  <a:pt x="174" y="39"/>
                </a:lnTo>
                <a:lnTo>
                  <a:pt x="176" y="37"/>
                </a:lnTo>
                <a:lnTo>
                  <a:pt x="177" y="32"/>
                </a:lnTo>
                <a:lnTo>
                  <a:pt x="176" y="30"/>
                </a:lnTo>
                <a:lnTo>
                  <a:pt x="174" y="27"/>
                </a:lnTo>
                <a:lnTo>
                  <a:pt x="173" y="23"/>
                </a:lnTo>
                <a:lnTo>
                  <a:pt x="170" y="20"/>
                </a:lnTo>
                <a:lnTo>
                  <a:pt x="162" y="15"/>
                </a:lnTo>
                <a:lnTo>
                  <a:pt x="151" y="9"/>
                </a:lnTo>
                <a:lnTo>
                  <a:pt x="137" y="5"/>
                </a:lnTo>
                <a:lnTo>
                  <a:pt x="122" y="2"/>
                </a:lnTo>
                <a:lnTo>
                  <a:pt x="106" y="1"/>
                </a:lnTo>
                <a:lnTo>
                  <a:pt x="88" y="0"/>
                </a:lnTo>
                <a:lnTo>
                  <a:pt x="71" y="1"/>
                </a:lnTo>
                <a:lnTo>
                  <a:pt x="54" y="2"/>
                </a:lnTo>
                <a:lnTo>
                  <a:pt x="39" y="5"/>
                </a:lnTo>
                <a:lnTo>
                  <a:pt x="26" y="9"/>
                </a:lnTo>
                <a:lnTo>
                  <a:pt x="15" y="15"/>
                </a:lnTo>
                <a:lnTo>
                  <a:pt x="7" y="20"/>
                </a:lnTo>
                <a:lnTo>
                  <a:pt x="4" y="23"/>
                </a:lnTo>
                <a:lnTo>
                  <a:pt x="1" y="27"/>
                </a:lnTo>
                <a:lnTo>
                  <a:pt x="0" y="30"/>
                </a:lnTo>
                <a:lnTo>
                  <a:pt x="0" y="32"/>
                </a:lnTo>
                <a:lnTo>
                  <a:pt x="0" y="37"/>
                </a:lnTo>
                <a:lnTo>
                  <a:pt x="1" y="39"/>
                </a:lnTo>
                <a:lnTo>
                  <a:pt x="4" y="43"/>
                </a:lnTo>
                <a:lnTo>
                  <a:pt x="7" y="46"/>
                </a:lnTo>
                <a:lnTo>
                  <a:pt x="15" y="52"/>
                </a:lnTo>
                <a:lnTo>
                  <a:pt x="26" y="57"/>
                </a:lnTo>
                <a:lnTo>
                  <a:pt x="39" y="61"/>
                </a:lnTo>
                <a:lnTo>
                  <a:pt x="54" y="64"/>
                </a:lnTo>
                <a:lnTo>
                  <a:pt x="71" y="65"/>
                </a:lnTo>
                <a:lnTo>
                  <a:pt x="88" y="67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0" name="Freeform 90"/>
          <p:cNvSpPr>
            <a:spLocks/>
          </p:cNvSpPr>
          <p:nvPr/>
        </p:nvSpPr>
        <p:spPr bwMode="auto">
          <a:xfrm>
            <a:off x="6970714" y="4597401"/>
            <a:ext cx="179387" cy="15875"/>
          </a:xfrm>
          <a:custGeom>
            <a:avLst/>
            <a:gdLst>
              <a:gd name="T0" fmla="*/ 85 w 85"/>
              <a:gd name="T1" fmla="*/ 6 h 11"/>
              <a:gd name="T2" fmla="*/ 85 w 85"/>
              <a:gd name="T3" fmla="*/ 0 h 11"/>
              <a:gd name="T4" fmla="*/ 0 w 85"/>
              <a:gd name="T5" fmla="*/ 0 h 11"/>
              <a:gd name="T6" fmla="*/ 0 w 85"/>
              <a:gd name="T7" fmla="*/ 11 h 11"/>
              <a:gd name="T8" fmla="*/ 85 w 85"/>
              <a:gd name="T9" fmla="*/ 11 h 11"/>
              <a:gd name="T10" fmla="*/ 85 w 85"/>
              <a:gd name="T11" fmla="*/ 6 h 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5" h="11">
                <a:moveTo>
                  <a:pt x="85" y="6"/>
                </a:moveTo>
                <a:lnTo>
                  <a:pt x="85" y="0"/>
                </a:lnTo>
                <a:lnTo>
                  <a:pt x="0" y="0"/>
                </a:lnTo>
                <a:lnTo>
                  <a:pt x="0" y="11"/>
                </a:lnTo>
                <a:lnTo>
                  <a:pt x="85" y="11"/>
                </a:lnTo>
                <a:lnTo>
                  <a:pt x="85" y="6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1" name="Freeform 91"/>
          <p:cNvSpPr>
            <a:spLocks/>
          </p:cNvSpPr>
          <p:nvPr/>
        </p:nvSpPr>
        <p:spPr bwMode="auto">
          <a:xfrm>
            <a:off x="7080250" y="4567239"/>
            <a:ext cx="134938" cy="77787"/>
          </a:xfrm>
          <a:custGeom>
            <a:avLst/>
            <a:gdLst>
              <a:gd name="T0" fmla="*/ 67 w 67"/>
              <a:gd name="T1" fmla="*/ 29 h 58"/>
              <a:gd name="T2" fmla="*/ 0 w 67"/>
              <a:gd name="T3" fmla="*/ 0 h 58"/>
              <a:gd name="T4" fmla="*/ 0 w 67"/>
              <a:gd name="T5" fmla="*/ 2 h 58"/>
              <a:gd name="T6" fmla="*/ 1 w 67"/>
              <a:gd name="T7" fmla="*/ 3 h 58"/>
              <a:gd name="T8" fmla="*/ 3 w 67"/>
              <a:gd name="T9" fmla="*/ 6 h 58"/>
              <a:gd name="T10" fmla="*/ 3 w 67"/>
              <a:gd name="T11" fmla="*/ 7 h 58"/>
              <a:gd name="T12" fmla="*/ 4 w 67"/>
              <a:gd name="T13" fmla="*/ 8 h 58"/>
              <a:gd name="T14" fmla="*/ 4 w 67"/>
              <a:gd name="T15" fmla="*/ 11 h 58"/>
              <a:gd name="T16" fmla="*/ 4 w 67"/>
              <a:gd name="T17" fmla="*/ 13 h 58"/>
              <a:gd name="T18" fmla="*/ 5 w 67"/>
              <a:gd name="T19" fmla="*/ 14 h 58"/>
              <a:gd name="T20" fmla="*/ 5 w 67"/>
              <a:gd name="T21" fmla="*/ 17 h 58"/>
              <a:gd name="T22" fmla="*/ 5 w 67"/>
              <a:gd name="T23" fmla="*/ 18 h 58"/>
              <a:gd name="T24" fmla="*/ 7 w 67"/>
              <a:gd name="T25" fmla="*/ 19 h 58"/>
              <a:gd name="T26" fmla="*/ 7 w 67"/>
              <a:gd name="T27" fmla="*/ 22 h 58"/>
              <a:gd name="T28" fmla="*/ 7 w 67"/>
              <a:gd name="T29" fmla="*/ 23 h 58"/>
              <a:gd name="T30" fmla="*/ 7 w 67"/>
              <a:gd name="T31" fmla="*/ 25 h 58"/>
              <a:gd name="T32" fmla="*/ 7 w 67"/>
              <a:gd name="T33" fmla="*/ 28 h 58"/>
              <a:gd name="T34" fmla="*/ 7 w 67"/>
              <a:gd name="T35" fmla="*/ 29 h 58"/>
              <a:gd name="T36" fmla="*/ 7 w 67"/>
              <a:gd name="T37" fmla="*/ 30 h 58"/>
              <a:gd name="T38" fmla="*/ 7 w 67"/>
              <a:gd name="T39" fmla="*/ 33 h 58"/>
              <a:gd name="T40" fmla="*/ 7 w 67"/>
              <a:gd name="T41" fmla="*/ 34 h 58"/>
              <a:gd name="T42" fmla="*/ 7 w 67"/>
              <a:gd name="T43" fmla="*/ 36 h 58"/>
              <a:gd name="T44" fmla="*/ 7 w 67"/>
              <a:gd name="T45" fmla="*/ 38 h 58"/>
              <a:gd name="T46" fmla="*/ 5 w 67"/>
              <a:gd name="T47" fmla="*/ 40 h 58"/>
              <a:gd name="T48" fmla="*/ 5 w 67"/>
              <a:gd name="T49" fmla="*/ 41 h 58"/>
              <a:gd name="T50" fmla="*/ 5 w 67"/>
              <a:gd name="T51" fmla="*/ 44 h 58"/>
              <a:gd name="T52" fmla="*/ 4 w 67"/>
              <a:gd name="T53" fmla="*/ 45 h 58"/>
              <a:gd name="T54" fmla="*/ 4 w 67"/>
              <a:gd name="T55" fmla="*/ 47 h 58"/>
              <a:gd name="T56" fmla="*/ 4 w 67"/>
              <a:gd name="T57" fmla="*/ 49 h 58"/>
              <a:gd name="T58" fmla="*/ 3 w 67"/>
              <a:gd name="T59" fmla="*/ 51 h 58"/>
              <a:gd name="T60" fmla="*/ 3 w 67"/>
              <a:gd name="T61" fmla="*/ 52 h 58"/>
              <a:gd name="T62" fmla="*/ 1 w 67"/>
              <a:gd name="T63" fmla="*/ 55 h 58"/>
              <a:gd name="T64" fmla="*/ 0 w 67"/>
              <a:gd name="T65" fmla="*/ 56 h 58"/>
              <a:gd name="T66" fmla="*/ 0 w 67"/>
              <a:gd name="T67" fmla="*/ 58 h 58"/>
              <a:gd name="T68" fmla="*/ 67 w 67"/>
              <a:gd name="T69" fmla="*/ 29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67" h="58">
                <a:moveTo>
                  <a:pt x="67" y="29"/>
                </a:moveTo>
                <a:lnTo>
                  <a:pt x="0" y="0"/>
                </a:lnTo>
                <a:lnTo>
                  <a:pt x="0" y="2"/>
                </a:lnTo>
                <a:lnTo>
                  <a:pt x="1" y="3"/>
                </a:lnTo>
                <a:lnTo>
                  <a:pt x="3" y="6"/>
                </a:lnTo>
                <a:lnTo>
                  <a:pt x="3" y="7"/>
                </a:lnTo>
                <a:lnTo>
                  <a:pt x="4" y="8"/>
                </a:lnTo>
                <a:lnTo>
                  <a:pt x="4" y="11"/>
                </a:lnTo>
                <a:lnTo>
                  <a:pt x="4" y="13"/>
                </a:lnTo>
                <a:lnTo>
                  <a:pt x="5" y="14"/>
                </a:lnTo>
                <a:lnTo>
                  <a:pt x="5" y="17"/>
                </a:lnTo>
                <a:lnTo>
                  <a:pt x="5" y="18"/>
                </a:lnTo>
                <a:lnTo>
                  <a:pt x="7" y="19"/>
                </a:lnTo>
                <a:lnTo>
                  <a:pt x="7" y="22"/>
                </a:lnTo>
                <a:lnTo>
                  <a:pt x="7" y="23"/>
                </a:lnTo>
                <a:lnTo>
                  <a:pt x="7" y="25"/>
                </a:lnTo>
                <a:lnTo>
                  <a:pt x="7" y="28"/>
                </a:lnTo>
                <a:lnTo>
                  <a:pt x="7" y="29"/>
                </a:lnTo>
                <a:lnTo>
                  <a:pt x="7" y="30"/>
                </a:lnTo>
                <a:lnTo>
                  <a:pt x="7" y="33"/>
                </a:lnTo>
                <a:lnTo>
                  <a:pt x="7" y="34"/>
                </a:lnTo>
                <a:lnTo>
                  <a:pt x="7" y="36"/>
                </a:lnTo>
                <a:lnTo>
                  <a:pt x="7" y="38"/>
                </a:lnTo>
                <a:lnTo>
                  <a:pt x="5" y="40"/>
                </a:lnTo>
                <a:lnTo>
                  <a:pt x="5" y="41"/>
                </a:lnTo>
                <a:lnTo>
                  <a:pt x="5" y="44"/>
                </a:lnTo>
                <a:lnTo>
                  <a:pt x="4" y="45"/>
                </a:lnTo>
                <a:lnTo>
                  <a:pt x="4" y="47"/>
                </a:lnTo>
                <a:lnTo>
                  <a:pt x="4" y="49"/>
                </a:lnTo>
                <a:lnTo>
                  <a:pt x="3" y="51"/>
                </a:lnTo>
                <a:lnTo>
                  <a:pt x="3" y="52"/>
                </a:lnTo>
                <a:lnTo>
                  <a:pt x="1" y="55"/>
                </a:lnTo>
                <a:lnTo>
                  <a:pt x="0" y="56"/>
                </a:lnTo>
                <a:lnTo>
                  <a:pt x="0" y="58"/>
                </a:lnTo>
                <a:lnTo>
                  <a:pt x="67" y="29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2" name="Freeform 92"/>
          <p:cNvSpPr>
            <a:spLocks/>
          </p:cNvSpPr>
          <p:nvPr/>
        </p:nvSpPr>
        <p:spPr bwMode="auto">
          <a:xfrm>
            <a:off x="7462839" y="4957763"/>
            <a:ext cx="179387" cy="11112"/>
          </a:xfrm>
          <a:custGeom>
            <a:avLst/>
            <a:gdLst>
              <a:gd name="T0" fmla="*/ 86 w 86"/>
              <a:gd name="T1" fmla="*/ 4 h 9"/>
              <a:gd name="T2" fmla="*/ 86 w 86"/>
              <a:gd name="T3" fmla="*/ 0 h 9"/>
              <a:gd name="T4" fmla="*/ 0 w 86"/>
              <a:gd name="T5" fmla="*/ 0 h 9"/>
              <a:gd name="T6" fmla="*/ 0 w 86"/>
              <a:gd name="T7" fmla="*/ 9 h 9"/>
              <a:gd name="T8" fmla="*/ 86 w 86"/>
              <a:gd name="T9" fmla="*/ 9 h 9"/>
              <a:gd name="T10" fmla="*/ 86 w 86"/>
              <a:gd name="T11" fmla="*/ 4 h 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6" h="9">
                <a:moveTo>
                  <a:pt x="86" y="4"/>
                </a:moveTo>
                <a:lnTo>
                  <a:pt x="86" y="0"/>
                </a:lnTo>
                <a:lnTo>
                  <a:pt x="0" y="0"/>
                </a:lnTo>
                <a:lnTo>
                  <a:pt x="0" y="9"/>
                </a:lnTo>
                <a:lnTo>
                  <a:pt x="86" y="9"/>
                </a:lnTo>
                <a:lnTo>
                  <a:pt x="86" y="4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3" name="Freeform 93"/>
          <p:cNvSpPr>
            <a:spLocks/>
          </p:cNvSpPr>
          <p:nvPr/>
        </p:nvSpPr>
        <p:spPr bwMode="auto">
          <a:xfrm>
            <a:off x="7570789" y="4922839"/>
            <a:ext cx="142875" cy="79375"/>
          </a:xfrm>
          <a:custGeom>
            <a:avLst/>
            <a:gdLst>
              <a:gd name="T0" fmla="*/ 68 w 68"/>
              <a:gd name="T1" fmla="*/ 29 h 59"/>
              <a:gd name="T2" fmla="*/ 0 w 68"/>
              <a:gd name="T3" fmla="*/ 0 h 59"/>
              <a:gd name="T4" fmla="*/ 1 w 68"/>
              <a:gd name="T5" fmla="*/ 2 h 59"/>
              <a:gd name="T6" fmla="*/ 3 w 68"/>
              <a:gd name="T7" fmla="*/ 4 h 59"/>
              <a:gd name="T8" fmla="*/ 3 w 68"/>
              <a:gd name="T9" fmla="*/ 6 h 59"/>
              <a:gd name="T10" fmla="*/ 4 w 68"/>
              <a:gd name="T11" fmla="*/ 7 h 59"/>
              <a:gd name="T12" fmla="*/ 4 w 68"/>
              <a:gd name="T13" fmla="*/ 10 h 59"/>
              <a:gd name="T14" fmla="*/ 6 w 68"/>
              <a:gd name="T15" fmla="*/ 11 h 59"/>
              <a:gd name="T16" fmla="*/ 6 w 68"/>
              <a:gd name="T17" fmla="*/ 13 h 59"/>
              <a:gd name="T18" fmla="*/ 6 w 68"/>
              <a:gd name="T19" fmla="*/ 15 h 59"/>
              <a:gd name="T20" fmla="*/ 7 w 68"/>
              <a:gd name="T21" fmla="*/ 17 h 59"/>
              <a:gd name="T22" fmla="*/ 7 w 68"/>
              <a:gd name="T23" fmla="*/ 18 h 59"/>
              <a:gd name="T24" fmla="*/ 7 w 68"/>
              <a:gd name="T25" fmla="*/ 21 h 59"/>
              <a:gd name="T26" fmla="*/ 7 w 68"/>
              <a:gd name="T27" fmla="*/ 22 h 59"/>
              <a:gd name="T28" fmla="*/ 7 w 68"/>
              <a:gd name="T29" fmla="*/ 24 h 59"/>
              <a:gd name="T30" fmla="*/ 8 w 68"/>
              <a:gd name="T31" fmla="*/ 26 h 59"/>
              <a:gd name="T32" fmla="*/ 8 w 68"/>
              <a:gd name="T33" fmla="*/ 28 h 59"/>
              <a:gd name="T34" fmla="*/ 8 w 68"/>
              <a:gd name="T35" fmla="*/ 29 h 59"/>
              <a:gd name="T36" fmla="*/ 8 w 68"/>
              <a:gd name="T37" fmla="*/ 32 h 59"/>
              <a:gd name="T38" fmla="*/ 8 w 68"/>
              <a:gd name="T39" fmla="*/ 33 h 59"/>
              <a:gd name="T40" fmla="*/ 7 w 68"/>
              <a:gd name="T41" fmla="*/ 34 h 59"/>
              <a:gd name="T42" fmla="*/ 7 w 68"/>
              <a:gd name="T43" fmla="*/ 37 h 59"/>
              <a:gd name="T44" fmla="*/ 7 w 68"/>
              <a:gd name="T45" fmla="*/ 39 h 59"/>
              <a:gd name="T46" fmla="*/ 7 w 68"/>
              <a:gd name="T47" fmla="*/ 40 h 59"/>
              <a:gd name="T48" fmla="*/ 7 w 68"/>
              <a:gd name="T49" fmla="*/ 43 h 59"/>
              <a:gd name="T50" fmla="*/ 6 w 68"/>
              <a:gd name="T51" fmla="*/ 44 h 59"/>
              <a:gd name="T52" fmla="*/ 6 w 68"/>
              <a:gd name="T53" fmla="*/ 45 h 59"/>
              <a:gd name="T54" fmla="*/ 6 w 68"/>
              <a:gd name="T55" fmla="*/ 48 h 59"/>
              <a:gd name="T56" fmla="*/ 4 w 68"/>
              <a:gd name="T57" fmla="*/ 49 h 59"/>
              <a:gd name="T58" fmla="*/ 4 w 68"/>
              <a:gd name="T59" fmla="*/ 51 h 59"/>
              <a:gd name="T60" fmla="*/ 3 w 68"/>
              <a:gd name="T61" fmla="*/ 54 h 59"/>
              <a:gd name="T62" fmla="*/ 3 w 68"/>
              <a:gd name="T63" fmla="*/ 55 h 59"/>
              <a:gd name="T64" fmla="*/ 1 w 68"/>
              <a:gd name="T65" fmla="*/ 56 h 59"/>
              <a:gd name="T66" fmla="*/ 0 w 68"/>
              <a:gd name="T67" fmla="*/ 59 h 59"/>
              <a:gd name="T68" fmla="*/ 68 w 68"/>
              <a:gd name="T69" fmla="*/ 29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68" h="59">
                <a:moveTo>
                  <a:pt x="68" y="29"/>
                </a:moveTo>
                <a:lnTo>
                  <a:pt x="0" y="0"/>
                </a:lnTo>
                <a:lnTo>
                  <a:pt x="1" y="2"/>
                </a:lnTo>
                <a:lnTo>
                  <a:pt x="3" y="4"/>
                </a:lnTo>
                <a:lnTo>
                  <a:pt x="3" y="6"/>
                </a:lnTo>
                <a:lnTo>
                  <a:pt x="4" y="7"/>
                </a:lnTo>
                <a:lnTo>
                  <a:pt x="4" y="10"/>
                </a:lnTo>
                <a:lnTo>
                  <a:pt x="6" y="11"/>
                </a:lnTo>
                <a:lnTo>
                  <a:pt x="6" y="13"/>
                </a:lnTo>
                <a:lnTo>
                  <a:pt x="6" y="15"/>
                </a:lnTo>
                <a:lnTo>
                  <a:pt x="7" y="17"/>
                </a:lnTo>
                <a:lnTo>
                  <a:pt x="7" y="18"/>
                </a:lnTo>
                <a:lnTo>
                  <a:pt x="7" y="21"/>
                </a:lnTo>
                <a:lnTo>
                  <a:pt x="7" y="22"/>
                </a:lnTo>
                <a:lnTo>
                  <a:pt x="7" y="24"/>
                </a:lnTo>
                <a:lnTo>
                  <a:pt x="8" y="26"/>
                </a:lnTo>
                <a:lnTo>
                  <a:pt x="8" y="28"/>
                </a:lnTo>
                <a:lnTo>
                  <a:pt x="8" y="29"/>
                </a:lnTo>
                <a:lnTo>
                  <a:pt x="8" y="32"/>
                </a:lnTo>
                <a:lnTo>
                  <a:pt x="8" y="33"/>
                </a:lnTo>
                <a:lnTo>
                  <a:pt x="7" y="34"/>
                </a:lnTo>
                <a:lnTo>
                  <a:pt x="7" y="37"/>
                </a:lnTo>
                <a:lnTo>
                  <a:pt x="7" y="39"/>
                </a:lnTo>
                <a:lnTo>
                  <a:pt x="7" y="40"/>
                </a:lnTo>
                <a:lnTo>
                  <a:pt x="7" y="43"/>
                </a:lnTo>
                <a:lnTo>
                  <a:pt x="6" y="44"/>
                </a:lnTo>
                <a:lnTo>
                  <a:pt x="6" y="45"/>
                </a:lnTo>
                <a:lnTo>
                  <a:pt x="6" y="48"/>
                </a:lnTo>
                <a:lnTo>
                  <a:pt x="4" y="49"/>
                </a:lnTo>
                <a:lnTo>
                  <a:pt x="4" y="51"/>
                </a:lnTo>
                <a:lnTo>
                  <a:pt x="3" y="54"/>
                </a:lnTo>
                <a:lnTo>
                  <a:pt x="3" y="55"/>
                </a:lnTo>
                <a:lnTo>
                  <a:pt x="1" y="56"/>
                </a:lnTo>
                <a:lnTo>
                  <a:pt x="0" y="59"/>
                </a:lnTo>
                <a:lnTo>
                  <a:pt x="68" y="29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4" name="Freeform 94"/>
          <p:cNvSpPr>
            <a:spLocks/>
          </p:cNvSpPr>
          <p:nvPr/>
        </p:nvSpPr>
        <p:spPr bwMode="auto">
          <a:xfrm>
            <a:off x="8096250" y="5308600"/>
            <a:ext cx="173038" cy="14288"/>
          </a:xfrm>
          <a:custGeom>
            <a:avLst/>
            <a:gdLst>
              <a:gd name="T0" fmla="*/ 85 w 85"/>
              <a:gd name="T1" fmla="*/ 4 h 10"/>
              <a:gd name="T2" fmla="*/ 85 w 85"/>
              <a:gd name="T3" fmla="*/ 0 h 10"/>
              <a:gd name="T4" fmla="*/ 0 w 85"/>
              <a:gd name="T5" fmla="*/ 0 h 10"/>
              <a:gd name="T6" fmla="*/ 0 w 85"/>
              <a:gd name="T7" fmla="*/ 10 h 10"/>
              <a:gd name="T8" fmla="*/ 85 w 85"/>
              <a:gd name="T9" fmla="*/ 10 h 10"/>
              <a:gd name="T10" fmla="*/ 85 w 85"/>
              <a:gd name="T11" fmla="*/ 4 h 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5" h="10">
                <a:moveTo>
                  <a:pt x="85" y="4"/>
                </a:moveTo>
                <a:lnTo>
                  <a:pt x="85" y="0"/>
                </a:lnTo>
                <a:lnTo>
                  <a:pt x="0" y="0"/>
                </a:lnTo>
                <a:lnTo>
                  <a:pt x="0" y="10"/>
                </a:lnTo>
                <a:lnTo>
                  <a:pt x="85" y="10"/>
                </a:lnTo>
                <a:lnTo>
                  <a:pt x="85" y="4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5" name="Freeform 95"/>
          <p:cNvSpPr>
            <a:spLocks/>
          </p:cNvSpPr>
          <p:nvPr/>
        </p:nvSpPr>
        <p:spPr bwMode="auto">
          <a:xfrm>
            <a:off x="8204200" y="5276850"/>
            <a:ext cx="139700" cy="76200"/>
          </a:xfrm>
          <a:custGeom>
            <a:avLst/>
            <a:gdLst>
              <a:gd name="T0" fmla="*/ 69 w 69"/>
              <a:gd name="T1" fmla="*/ 28 h 57"/>
              <a:gd name="T2" fmla="*/ 0 w 69"/>
              <a:gd name="T3" fmla="*/ 0 h 57"/>
              <a:gd name="T4" fmla="*/ 2 w 69"/>
              <a:gd name="T5" fmla="*/ 1 h 57"/>
              <a:gd name="T6" fmla="*/ 2 w 69"/>
              <a:gd name="T7" fmla="*/ 2 h 57"/>
              <a:gd name="T8" fmla="*/ 3 w 69"/>
              <a:gd name="T9" fmla="*/ 5 h 57"/>
              <a:gd name="T10" fmla="*/ 3 w 69"/>
              <a:gd name="T11" fmla="*/ 7 h 57"/>
              <a:gd name="T12" fmla="*/ 4 w 69"/>
              <a:gd name="T13" fmla="*/ 8 h 57"/>
              <a:gd name="T14" fmla="*/ 4 w 69"/>
              <a:gd name="T15" fmla="*/ 11 h 57"/>
              <a:gd name="T16" fmla="*/ 6 w 69"/>
              <a:gd name="T17" fmla="*/ 12 h 57"/>
              <a:gd name="T18" fmla="*/ 6 w 69"/>
              <a:gd name="T19" fmla="*/ 13 h 57"/>
              <a:gd name="T20" fmla="*/ 6 w 69"/>
              <a:gd name="T21" fmla="*/ 16 h 57"/>
              <a:gd name="T22" fmla="*/ 7 w 69"/>
              <a:gd name="T23" fmla="*/ 18 h 57"/>
              <a:gd name="T24" fmla="*/ 7 w 69"/>
              <a:gd name="T25" fmla="*/ 19 h 57"/>
              <a:gd name="T26" fmla="*/ 7 w 69"/>
              <a:gd name="T27" fmla="*/ 22 h 57"/>
              <a:gd name="T28" fmla="*/ 7 w 69"/>
              <a:gd name="T29" fmla="*/ 23 h 57"/>
              <a:gd name="T30" fmla="*/ 7 w 69"/>
              <a:gd name="T31" fmla="*/ 24 h 57"/>
              <a:gd name="T32" fmla="*/ 7 w 69"/>
              <a:gd name="T33" fmla="*/ 27 h 57"/>
              <a:gd name="T34" fmla="*/ 7 w 69"/>
              <a:gd name="T35" fmla="*/ 28 h 57"/>
              <a:gd name="T36" fmla="*/ 7 w 69"/>
              <a:gd name="T37" fmla="*/ 30 h 57"/>
              <a:gd name="T38" fmla="*/ 7 w 69"/>
              <a:gd name="T39" fmla="*/ 33 h 57"/>
              <a:gd name="T40" fmla="*/ 7 w 69"/>
              <a:gd name="T41" fmla="*/ 34 h 57"/>
              <a:gd name="T42" fmla="*/ 7 w 69"/>
              <a:gd name="T43" fmla="*/ 35 h 57"/>
              <a:gd name="T44" fmla="*/ 7 w 69"/>
              <a:gd name="T45" fmla="*/ 38 h 57"/>
              <a:gd name="T46" fmla="*/ 7 w 69"/>
              <a:gd name="T47" fmla="*/ 39 h 57"/>
              <a:gd name="T48" fmla="*/ 6 w 69"/>
              <a:gd name="T49" fmla="*/ 41 h 57"/>
              <a:gd name="T50" fmla="*/ 6 w 69"/>
              <a:gd name="T51" fmla="*/ 43 h 57"/>
              <a:gd name="T52" fmla="*/ 6 w 69"/>
              <a:gd name="T53" fmla="*/ 45 h 57"/>
              <a:gd name="T54" fmla="*/ 4 w 69"/>
              <a:gd name="T55" fmla="*/ 46 h 57"/>
              <a:gd name="T56" fmla="*/ 4 w 69"/>
              <a:gd name="T57" fmla="*/ 49 h 57"/>
              <a:gd name="T58" fmla="*/ 3 w 69"/>
              <a:gd name="T59" fmla="*/ 50 h 57"/>
              <a:gd name="T60" fmla="*/ 3 w 69"/>
              <a:gd name="T61" fmla="*/ 52 h 57"/>
              <a:gd name="T62" fmla="*/ 2 w 69"/>
              <a:gd name="T63" fmla="*/ 54 h 57"/>
              <a:gd name="T64" fmla="*/ 2 w 69"/>
              <a:gd name="T65" fmla="*/ 56 h 57"/>
              <a:gd name="T66" fmla="*/ 0 w 69"/>
              <a:gd name="T67" fmla="*/ 57 h 57"/>
              <a:gd name="T68" fmla="*/ 69 w 69"/>
              <a:gd name="T69" fmla="*/ 28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69" h="57">
                <a:moveTo>
                  <a:pt x="69" y="28"/>
                </a:moveTo>
                <a:lnTo>
                  <a:pt x="0" y="0"/>
                </a:lnTo>
                <a:lnTo>
                  <a:pt x="2" y="1"/>
                </a:lnTo>
                <a:lnTo>
                  <a:pt x="2" y="2"/>
                </a:lnTo>
                <a:lnTo>
                  <a:pt x="3" y="5"/>
                </a:lnTo>
                <a:lnTo>
                  <a:pt x="3" y="7"/>
                </a:lnTo>
                <a:lnTo>
                  <a:pt x="4" y="8"/>
                </a:lnTo>
                <a:lnTo>
                  <a:pt x="4" y="11"/>
                </a:lnTo>
                <a:lnTo>
                  <a:pt x="6" y="12"/>
                </a:lnTo>
                <a:lnTo>
                  <a:pt x="6" y="13"/>
                </a:lnTo>
                <a:lnTo>
                  <a:pt x="6" y="16"/>
                </a:lnTo>
                <a:lnTo>
                  <a:pt x="7" y="18"/>
                </a:lnTo>
                <a:lnTo>
                  <a:pt x="7" y="19"/>
                </a:lnTo>
                <a:lnTo>
                  <a:pt x="7" y="22"/>
                </a:lnTo>
                <a:lnTo>
                  <a:pt x="7" y="23"/>
                </a:lnTo>
                <a:lnTo>
                  <a:pt x="7" y="24"/>
                </a:lnTo>
                <a:lnTo>
                  <a:pt x="7" y="27"/>
                </a:lnTo>
                <a:lnTo>
                  <a:pt x="7" y="28"/>
                </a:lnTo>
                <a:lnTo>
                  <a:pt x="7" y="30"/>
                </a:lnTo>
                <a:lnTo>
                  <a:pt x="7" y="33"/>
                </a:lnTo>
                <a:lnTo>
                  <a:pt x="7" y="34"/>
                </a:lnTo>
                <a:lnTo>
                  <a:pt x="7" y="35"/>
                </a:lnTo>
                <a:lnTo>
                  <a:pt x="7" y="38"/>
                </a:lnTo>
                <a:lnTo>
                  <a:pt x="7" y="39"/>
                </a:lnTo>
                <a:lnTo>
                  <a:pt x="6" y="41"/>
                </a:lnTo>
                <a:lnTo>
                  <a:pt x="6" y="43"/>
                </a:lnTo>
                <a:lnTo>
                  <a:pt x="6" y="45"/>
                </a:lnTo>
                <a:lnTo>
                  <a:pt x="4" y="46"/>
                </a:lnTo>
                <a:lnTo>
                  <a:pt x="4" y="49"/>
                </a:lnTo>
                <a:lnTo>
                  <a:pt x="3" y="50"/>
                </a:lnTo>
                <a:lnTo>
                  <a:pt x="3" y="52"/>
                </a:lnTo>
                <a:lnTo>
                  <a:pt x="2" y="54"/>
                </a:lnTo>
                <a:lnTo>
                  <a:pt x="2" y="56"/>
                </a:lnTo>
                <a:lnTo>
                  <a:pt x="0" y="57"/>
                </a:lnTo>
                <a:lnTo>
                  <a:pt x="69" y="28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6" name="Freeform 96"/>
          <p:cNvSpPr>
            <a:spLocks/>
          </p:cNvSpPr>
          <p:nvPr/>
        </p:nvSpPr>
        <p:spPr bwMode="auto">
          <a:xfrm>
            <a:off x="6394450" y="4600575"/>
            <a:ext cx="177800" cy="12700"/>
          </a:xfrm>
          <a:custGeom>
            <a:avLst/>
            <a:gdLst>
              <a:gd name="T0" fmla="*/ 0 w 85"/>
              <a:gd name="T1" fmla="*/ 5 h 9"/>
              <a:gd name="T2" fmla="*/ 0 w 85"/>
              <a:gd name="T3" fmla="*/ 9 h 9"/>
              <a:gd name="T4" fmla="*/ 85 w 85"/>
              <a:gd name="T5" fmla="*/ 9 h 9"/>
              <a:gd name="T6" fmla="*/ 85 w 85"/>
              <a:gd name="T7" fmla="*/ 0 h 9"/>
              <a:gd name="T8" fmla="*/ 0 w 85"/>
              <a:gd name="T9" fmla="*/ 0 h 9"/>
              <a:gd name="T10" fmla="*/ 0 w 85"/>
              <a:gd name="T11" fmla="*/ 5 h 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5" h="9">
                <a:moveTo>
                  <a:pt x="0" y="5"/>
                </a:moveTo>
                <a:lnTo>
                  <a:pt x="0" y="9"/>
                </a:lnTo>
                <a:lnTo>
                  <a:pt x="85" y="9"/>
                </a:lnTo>
                <a:lnTo>
                  <a:pt x="85" y="0"/>
                </a:lnTo>
                <a:lnTo>
                  <a:pt x="0" y="0"/>
                </a:lnTo>
                <a:lnTo>
                  <a:pt x="0" y="5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7" name="Freeform 97"/>
          <p:cNvSpPr>
            <a:spLocks/>
          </p:cNvSpPr>
          <p:nvPr/>
        </p:nvSpPr>
        <p:spPr bwMode="auto">
          <a:xfrm>
            <a:off x="6321426" y="4570413"/>
            <a:ext cx="142875" cy="76200"/>
          </a:xfrm>
          <a:custGeom>
            <a:avLst/>
            <a:gdLst>
              <a:gd name="T0" fmla="*/ 0 w 67"/>
              <a:gd name="T1" fmla="*/ 28 h 57"/>
              <a:gd name="T2" fmla="*/ 67 w 67"/>
              <a:gd name="T3" fmla="*/ 57 h 57"/>
              <a:gd name="T4" fmla="*/ 67 w 67"/>
              <a:gd name="T5" fmla="*/ 56 h 57"/>
              <a:gd name="T6" fmla="*/ 65 w 67"/>
              <a:gd name="T7" fmla="*/ 54 h 57"/>
              <a:gd name="T8" fmla="*/ 64 w 67"/>
              <a:gd name="T9" fmla="*/ 51 h 57"/>
              <a:gd name="T10" fmla="*/ 64 w 67"/>
              <a:gd name="T11" fmla="*/ 50 h 57"/>
              <a:gd name="T12" fmla="*/ 63 w 67"/>
              <a:gd name="T13" fmla="*/ 49 h 57"/>
              <a:gd name="T14" fmla="*/ 63 w 67"/>
              <a:gd name="T15" fmla="*/ 46 h 57"/>
              <a:gd name="T16" fmla="*/ 63 w 67"/>
              <a:gd name="T17" fmla="*/ 45 h 57"/>
              <a:gd name="T18" fmla="*/ 61 w 67"/>
              <a:gd name="T19" fmla="*/ 43 h 57"/>
              <a:gd name="T20" fmla="*/ 61 w 67"/>
              <a:gd name="T21" fmla="*/ 41 h 57"/>
              <a:gd name="T22" fmla="*/ 61 w 67"/>
              <a:gd name="T23" fmla="*/ 39 h 57"/>
              <a:gd name="T24" fmla="*/ 60 w 67"/>
              <a:gd name="T25" fmla="*/ 38 h 57"/>
              <a:gd name="T26" fmla="*/ 60 w 67"/>
              <a:gd name="T27" fmla="*/ 35 h 57"/>
              <a:gd name="T28" fmla="*/ 60 w 67"/>
              <a:gd name="T29" fmla="*/ 34 h 57"/>
              <a:gd name="T30" fmla="*/ 60 w 67"/>
              <a:gd name="T31" fmla="*/ 32 h 57"/>
              <a:gd name="T32" fmla="*/ 60 w 67"/>
              <a:gd name="T33" fmla="*/ 30 h 57"/>
              <a:gd name="T34" fmla="*/ 60 w 67"/>
              <a:gd name="T35" fmla="*/ 28 h 57"/>
              <a:gd name="T36" fmla="*/ 60 w 67"/>
              <a:gd name="T37" fmla="*/ 27 h 57"/>
              <a:gd name="T38" fmla="*/ 60 w 67"/>
              <a:gd name="T39" fmla="*/ 24 h 57"/>
              <a:gd name="T40" fmla="*/ 60 w 67"/>
              <a:gd name="T41" fmla="*/ 23 h 57"/>
              <a:gd name="T42" fmla="*/ 60 w 67"/>
              <a:gd name="T43" fmla="*/ 21 h 57"/>
              <a:gd name="T44" fmla="*/ 60 w 67"/>
              <a:gd name="T45" fmla="*/ 19 h 57"/>
              <a:gd name="T46" fmla="*/ 61 w 67"/>
              <a:gd name="T47" fmla="*/ 17 h 57"/>
              <a:gd name="T48" fmla="*/ 61 w 67"/>
              <a:gd name="T49" fmla="*/ 16 h 57"/>
              <a:gd name="T50" fmla="*/ 61 w 67"/>
              <a:gd name="T51" fmla="*/ 13 h 57"/>
              <a:gd name="T52" fmla="*/ 63 w 67"/>
              <a:gd name="T53" fmla="*/ 12 h 57"/>
              <a:gd name="T54" fmla="*/ 63 w 67"/>
              <a:gd name="T55" fmla="*/ 11 h 57"/>
              <a:gd name="T56" fmla="*/ 63 w 67"/>
              <a:gd name="T57" fmla="*/ 8 h 57"/>
              <a:gd name="T58" fmla="*/ 64 w 67"/>
              <a:gd name="T59" fmla="*/ 6 h 57"/>
              <a:gd name="T60" fmla="*/ 64 w 67"/>
              <a:gd name="T61" fmla="*/ 5 h 57"/>
              <a:gd name="T62" fmla="*/ 65 w 67"/>
              <a:gd name="T63" fmla="*/ 2 h 57"/>
              <a:gd name="T64" fmla="*/ 67 w 67"/>
              <a:gd name="T65" fmla="*/ 1 h 57"/>
              <a:gd name="T66" fmla="*/ 67 w 67"/>
              <a:gd name="T67" fmla="*/ 0 h 57"/>
              <a:gd name="T68" fmla="*/ 0 w 67"/>
              <a:gd name="T69" fmla="*/ 28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67" h="57">
                <a:moveTo>
                  <a:pt x="0" y="28"/>
                </a:moveTo>
                <a:lnTo>
                  <a:pt x="67" y="57"/>
                </a:lnTo>
                <a:lnTo>
                  <a:pt x="67" y="56"/>
                </a:lnTo>
                <a:lnTo>
                  <a:pt x="65" y="54"/>
                </a:lnTo>
                <a:lnTo>
                  <a:pt x="64" y="51"/>
                </a:lnTo>
                <a:lnTo>
                  <a:pt x="64" y="50"/>
                </a:lnTo>
                <a:lnTo>
                  <a:pt x="63" y="49"/>
                </a:lnTo>
                <a:lnTo>
                  <a:pt x="63" y="46"/>
                </a:lnTo>
                <a:lnTo>
                  <a:pt x="63" y="45"/>
                </a:lnTo>
                <a:lnTo>
                  <a:pt x="61" y="43"/>
                </a:lnTo>
                <a:lnTo>
                  <a:pt x="61" y="41"/>
                </a:lnTo>
                <a:lnTo>
                  <a:pt x="61" y="39"/>
                </a:lnTo>
                <a:lnTo>
                  <a:pt x="60" y="38"/>
                </a:lnTo>
                <a:lnTo>
                  <a:pt x="60" y="35"/>
                </a:lnTo>
                <a:lnTo>
                  <a:pt x="60" y="34"/>
                </a:lnTo>
                <a:lnTo>
                  <a:pt x="60" y="32"/>
                </a:lnTo>
                <a:lnTo>
                  <a:pt x="60" y="30"/>
                </a:lnTo>
                <a:lnTo>
                  <a:pt x="60" y="28"/>
                </a:lnTo>
                <a:lnTo>
                  <a:pt x="60" y="27"/>
                </a:lnTo>
                <a:lnTo>
                  <a:pt x="60" y="24"/>
                </a:lnTo>
                <a:lnTo>
                  <a:pt x="60" y="23"/>
                </a:lnTo>
                <a:lnTo>
                  <a:pt x="60" y="21"/>
                </a:lnTo>
                <a:lnTo>
                  <a:pt x="60" y="19"/>
                </a:lnTo>
                <a:lnTo>
                  <a:pt x="61" y="17"/>
                </a:lnTo>
                <a:lnTo>
                  <a:pt x="61" y="16"/>
                </a:lnTo>
                <a:lnTo>
                  <a:pt x="61" y="13"/>
                </a:lnTo>
                <a:lnTo>
                  <a:pt x="63" y="12"/>
                </a:lnTo>
                <a:lnTo>
                  <a:pt x="63" y="11"/>
                </a:lnTo>
                <a:lnTo>
                  <a:pt x="63" y="8"/>
                </a:lnTo>
                <a:lnTo>
                  <a:pt x="64" y="6"/>
                </a:lnTo>
                <a:lnTo>
                  <a:pt x="64" y="5"/>
                </a:lnTo>
                <a:lnTo>
                  <a:pt x="65" y="2"/>
                </a:lnTo>
                <a:lnTo>
                  <a:pt x="67" y="1"/>
                </a:lnTo>
                <a:lnTo>
                  <a:pt x="67" y="0"/>
                </a:lnTo>
                <a:lnTo>
                  <a:pt x="0" y="28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8" name="Freeform 98"/>
          <p:cNvSpPr>
            <a:spLocks/>
          </p:cNvSpPr>
          <p:nvPr/>
        </p:nvSpPr>
        <p:spPr bwMode="auto">
          <a:xfrm>
            <a:off x="6889750" y="4959350"/>
            <a:ext cx="177800" cy="12700"/>
          </a:xfrm>
          <a:custGeom>
            <a:avLst/>
            <a:gdLst>
              <a:gd name="T0" fmla="*/ 0 w 86"/>
              <a:gd name="T1" fmla="*/ 4 h 10"/>
              <a:gd name="T2" fmla="*/ 0 w 86"/>
              <a:gd name="T3" fmla="*/ 10 h 10"/>
              <a:gd name="T4" fmla="*/ 86 w 86"/>
              <a:gd name="T5" fmla="*/ 10 h 10"/>
              <a:gd name="T6" fmla="*/ 86 w 86"/>
              <a:gd name="T7" fmla="*/ 0 h 10"/>
              <a:gd name="T8" fmla="*/ 0 w 86"/>
              <a:gd name="T9" fmla="*/ 0 h 10"/>
              <a:gd name="T10" fmla="*/ 0 w 86"/>
              <a:gd name="T11" fmla="*/ 4 h 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6" h="10">
                <a:moveTo>
                  <a:pt x="0" y="4"/>
                </a:moveTo>
                <a:lnTo>
                  <a:pt x="0" y="10"/>
                </a:lnTo>
                <a:lnTo>
                  <a:pt x="86" y="10"/>
                </a:lnTo>
                <a:lnTo>
                  <a:pt x="86" y="0"/>
                </a:lnTo>
                <a:lnTo>
                  <a:pt x="0" y="0"/>
                </a:lnTo>
                <a:lnTo>
                  <a:pt x="0" y="4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79" name="Freeform 99"/>
          <p:cNvSpPr>
            <a:spLocks/>
          </p:cNvSpPr>
          <p:nvPr/>
        </p:nvSpPr>
        <p:spPr bwMode="auto">
          <a:xfrm>
            <a:off x="6816725" y="4926014"/>
            <a:ext cx="141288" cy="77787"/>
          </a:xfrm>
          <a:custGeom>
            <a:avLst/>
            <a:gdLst>
              <a:gd name="T0" fmla="*/ 0 w 68"/>
              <a:gd name="T1" fmla="*/ 28 h 58"/>
              <a:gd name="T2" fmla="*/ 68 w 68"/>
              <a:gd name="T3" fmla="*/ 58 h 58"/>
              <a:gd name="T4" fmla="*/ 67 w 68"/>
              <a:gd name="T5" fmla="*/ 56 h 58"/>
              <a:gd name="T6" fmla="*/ 67 w 68"/>
              <a:gd name="T7" fmla="*/ 54 h 58"/>
              <a:gd name="T8" fmla="*/ 66 w 68"/>
              <a:gd name="T9" fmla="*/ 53 h 58"/>
              <a:gd name="T10" fmla="*/ 64 w 68"/>
              <a:gd name="T11" fmla="*/ 50 h 58"/>
              <a:gd name="T12" fmla="*/ 64 w 68"/>
              <a:gd name="T13" fmla="*/ 49 h 58"/>
              <a:gd name="T14" fmla="*/ 64 w 68"/>
              <a:gd name="T15" fmla="*/ 47 h 58"/>
              <a:gd name="T16" fmla="*/ 63 w 68"/>
              <a:gd name="T17" fmla="*/ 45 h 58"/>
              <a:gd name="T18" fmla="*/ 63 w 68"/>
              <a:gd name="T19" fmla="*/ 43 h 58"/>
              <a:gd name="T20" fmla="*/ 63 w 68"/>
              <a:gd name="T21" fmla="*/ 42 h 58"/>
              <a:gd name="T22" fmla="*/ 62 w 68"/>
              <a:gd name="T23" fmla="*/ 39 h 58"/>
              <a:gd name="T24" fmla="*/ 62 w 68"/>
              <a:gd name="T25" fmla="*/ 38 h 58"/>
              <a:gd name="T26" fmla="*/ 62 w 68"/>
              <a:gd name="T27" fmla="*/ 37 h 58"/>
              <a:gd name="T28" fmla="*/ 62 w 68"/>
              <a:gd name="T29" fmla="*/ 34 h 58"/>
              <a:gd name="T30" fmla="*/ 62 w 68"/>
              <a:gd name="T31" fmla="*/ 32 h 58"/>
              <a:gd name="T32" fmla="*/ 62 w 68"/>
              <a:gd name="T33" fmla="*/ 31 h 58"/>
              <a:gd name="T34" fmla="*/ 60 w 68"/>
              <a:gd name="T35" fmla="*/ 28 h 58"/>
              <a:gd name="T36" fmla="*/ 62 w 68"/>
              <a:gd name="T37" fmla="*/ 27 h 58"/>
              <a:gd name="T38" fmla="*/ 62 w 68"/>
              <a:gd name="T39" fmla="*/ 26 h 58"/>
              <a:gd name="T40" fmla="*/ 62 w 68"/>
              <a:gd name="T41" fmla="*/ 23 h 58"/>
              <a:gd name="T42" fmla="*/ 62 w 68"/>
              <a:gd name="T43" fmla="*/ 22 h 58"/>
              <a:gd name="T44" fmla="*/ 62 w 68"/>
              <a:gd name="T45" fmla="*/ 20 h 58"/>
              <a:gd name="T46" fmla="*/ 62 w 68"/>
              <a:gd name="T47" fmla="*/ 17 h 58"/>
              <a:gd name="T48" fmla="*/ 63 w 68"/>
              <a:gd name="T49" fmla="*/ 16 h 58"/>
              <a:gd name="T50" fmla="*/ 63 w 68"/>
              <a:gd name="T51" fmla="*/ 15 h 58"/>
              <a:gd name="T52" fmla="*/ 63 w 68"/>
              <a:gd name="T53" fmla="*/ 12 h 58"/>
              <a:gd name="T54" fmla="*/ 64 w 68"/>
              <a:gd name="T55" fmla="*/ 11 h 58"/>
              <a:gd name="T56" fmla="*/ 64 w 68"/>
              <a:gd name="T57" fmla="*/ 9 h 58"/>
              <a:gd name="T58" fmla="*/ 64 w 68"/>
              <a:gd name="T59" fmla="*/ 7 h 58"/>
              <a:gd name="T60" fmla="*/ 66 w 68"/>
              <a:gd name="T61" fmla="*/ 5 h 58"/>
              <a:gd name="T62" fmla="*/ 67 w 68"/>
              <a:gd name="T63" fmla="*/ 4 h 58"/>
              <a:gd name="T64" fmla="*/ 67 w 68"/>
              <a:gd name="T65" fmla="*/ 1 h 58"/>
              <a:gd name="T66" fmla="*/ 68 w 68"/>
              <a:gd name="T67" fmla="*/ 0 h 58"/>
              <a:gd name="T68" fmla="*/ 0 w 68"/>
              <a:gd name="T69" fmla="*/ 28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68" h="58">
                <a:moveTo>
                  <a:pt x="0" y="28"/>
                </a:moveTo>
                <a:lnTo>
                  <a:pt x="68" y="58"/>
                </a:lnTo>
                <a:lnTo>
                  <a:pt x="67" y="56"/>
                </a:lnTo>
                <a:lnTo>
                  <a:pt x="67" y="54"/>
                </a:lnTo>
                <a:lnTo>
                  <a:pt x="66" y="53"/>
                </a:lnTo>
                <a:lnTo>
                  <a:pt x="64" y="50"/>
                </a:lnTo>
                <a:lnTo>
                  <a:pt x="64" y="49"/>
                </a:lnTo>
                <a:lnTo>
                  <a:pt x="64" y="47"/>
                </a:lnTo>
                <a:lnTo>
                  <a:pt x="63" y="45"/>
                </a:lnTo>
                <a:lnTo>
                  <a:pt x="63" y="43"/>
                </a:lnTo>
                <a:lnTo>
                  <a:pt x="63" y="42"/>
                </a:lnTo>
                <a:lnTo>
                  <a:pt x="62" y="39"/>
                </a:lnTo>
                <a:lnTo>
                  <a:pt x="62" y="38"/>
                </a:lnTo>
                <a:lnTo>
                  <a:pt x="62" y="37"/>
                </a:lnTo>
                <a:lnTo>
                  <a:pt x="62" y="34"/>
                </a:lnTo>
                <a:lnTo>
                  <a:pt x="62" y="32"/>
                </a:lnTo>
                <a:lnTo>
                  <a:pt x="62" y="31"/>
                </a:lnTo>
                <a:lnTo>
                  <a:pt x="60" y="28"/>
                </a:lnTo>
                <a:lnTo>
                  <a:pt x="62" y="27"/>
                </a:lnTo>
                <a:lnTo>
                  <a:pt x="62" y="26"/>
                </a:lnTo>
                <a:lnTo>
                  <a:pt x="62" y="23"/>
                </a:lnTo>
                <a:lnTo>
                  <a:pt x="62" y="22"/>
                </a:lnTo>
                <a:lnTo>
                  <a:pt x="62" y="20"/>
                </a:lnTo>
                <a:lnTo>
                  <a:pt x="62" y="17"/>
                </a:lnTo>
                <a:lnTo>
                  <a:pt x="63" y="16"/>
                </a:lnTo>
                <a:lnTo>
                  <a:pt x="63" y="15"/>
                </a:lnTo>
                <a:lnTo>
                  <a:pt x="63" y="12"/>
                </a:lnTo>
                <a:lnTo>
                  <a:pt x="64" y="11"/>
                </a:lnTo>
                <a:lnTo>
                  <a:pt x="64" y="9"/>
                </a:lnTo>
                <a:lnTo>
                  <a:pt x="64" y="7"/>
                </a:lnTo>
                <a:lnTo>
                  <a:pt x="66" y="5"/>
                </a:lnTo>
                <a:lnTo>
                  <a:pt x="67" y="4"/>
                </a:lnTo>
                <a:lnTo>
                  <a:pt x="67" y="1"/>
                </a:lnTo>
                <a:lnTo>
                  <a:pt x="68" y="0"/>
                </a:lnTo>
                <a:lnTo>
                  <a:pt x="0" y="28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80" name="Freeform 100"/>
          <p:cNvSpPr>
            <a:spLocks/>
          </p:cNvSpPr>
          <p:nvPr/>
        </p:nvSpPr>
        <p:spPr bwMode="auto">
          <a:xfrm>
            <a:off x="7521576" y="5308601"/>
            <a:ext cx="174625" cy="15875"/>
          </a:xfrm>
          <a:custGeom>
            <a:avLst/>
            <a:gdLst>
              <a:gd name="T0" fmla="*/ 0 w 85"/>
              <a:gd name="T1" fmla="*/ 6 h 11"/>
              <a:gd name="T2" fmla="*/ 0 w 85"/>
              <a:gd name="T3" fmla="*/ 11 h 11"/>
              <a:gd name="T4" fmla="*/ 85 w 85"/>
              <a:gd name="T5" fmla="*/ 11 h 11"/>
              <a:gd name="T6" fmla="*/ 85 w 85"/>
              <a:gd name="T7" fmla="*/ 0 h 11"/>
              <a:gd name="T8" fmla="*/ 0 w 85"/>
              <a:gd name="T9" fmla="*/ 0 h 11"/>
              <a:gd name="T10" fmla="*/ 0 w 85"/>
              <a:gd name="T11" fmla="*/ 6 h 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5" h="11">
                <a:moveTo>
                  <a:pt x="0" y="6"/>
                </a:moveTo>
                <a:lnTo>
                  <a:pt x="0" y="11"/>
                </a:lnTo>
                <a:lnTo>
                  <a:pt x="85" y="11"/>
                </a:lnTo>
                <a:lnTo>
                  <a:pt x="85" y="0"/>
                </a:lnTo>
                <a:lnTo>
                  <a:pt x="0" y="0"/>
                </a:lnTo>
                <a:lnTo>
                  <a:pt x="0" y="6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81" name="Freeform 101"/>
          <p:cNvSpPr>
            <a:spLocks/>
          </p:cNvSpPr>
          <p:nvPr/>
        </p:nvSpPr>
        <p:spPr bwMode="auto">
          <a:xfrm>
            <a:off x="7445375" y="5278438"/>
            <a:ext cx="146050" cy="76200"/>
          </a:xfrm>
          <a:custGeom>
            <a:avLst/>
            <a:gdLst>
              <a:gd name="T0" fmla="*/ 0 w 69"/>
              <a:gd name="T1" fmla="*/ 29 h 57"/>
              <a:gd name="T2" fmla="*/ 69 w 69"/>
              <a:gd name="T3" fmla="*/ 57 h 57"/>
              <a:gd name="T4" fmla="*/ 67 w 69"/>
              <a:gd name="T5" fmla="*/ 56 h 57"/>
              <a:gd name="T6" fmla="*/ 66 w 69"/>
              <a:gd name="T7" fmla="*/ 55 h 57"/>
              <a:gd name="T8" fmla="*/ 66 w 69"/>
              <a:gd name="T9" fmla="*/ 52 h 57"/>
              <a:gd name="T10" fmla="*/ 65 w 69"/>
              <a:gd name="T11" fmla="*/ 51 h 57"/>
              <a:gd name="T12" fmla="*/ 65 w 69"/>
              <a:gd name="T13" fmla="*/ 49 h 57"/>
              <a:gd name="T14" fmla="*/ 63 w 69"/>
              <a:gd name="T15" fmla="*/ 47 h 57"/>
              <a:gd name="T16" fmla="*/ 63 w 69"/>
              <a:gd name="T17" fmla="*/ 45 h 57"/>
              <a:gd name="T18" fmla="*/ 63 w 69"/>
              <a:gd name="T19" fmla="*/ 44 h 57"/>
              <a:gd name="T20" fmla="*/ 62 w 69"/>
              <a:gd name="T21" fmla="*/ 41 h 57"/>
              <a:gd name="T22" fmla="*/ 62 w 69"/>
              <a:gd name="T23" fmla="*/ 40 h 57"/>
              <a:gd name="T24" fmla="*/ 62 w 69"/>
              <a:gd name="T25" fmla="*/ 38 h 57"/>
              <a:gd name="T26" fmla="*/ 62 w 69"/>
              <a:gd name="T27" fmla="*/ 36 h 57"/>
              <a:gd name="T28" fmla="*/ 60 w 69"/>
              <a:gd name="T29" fmla="*/ 34 h 57"/>
              <a:gd name="T30" fmla="*/ 60 w 69"/>
              <a:gd name="T31" fmla="*/ 33 h 57"/>
              <a:gd name="T32" fmla="*/ 60 w 69"/>
              <a:gd name="T33" fmla="*/ 30 h 57"/>
              <a:gd name="T34" fmla="*/ 60 w 69"/>
              <a:gd name="T35" fmla="*/ 29 h 57"/>
              <a:gd name="T36" fmla="*/ 60 w 69"/>
              <a:gd name="T37" fmla="*/ 27 h 57"/>
              <a:gd name="T38" fmla="*/ 60 w 69"/>
              <a:gd name="T39" fmla="*/ 25 h 57"/>
              <a:gd name="T40" fmla="*/ 60 w 69"/>
              <a:gd name="T41" fmla="*/ 23 h 57"/>
              <a:gd name="T42" fmla="*/ 62 w 69"/>
              <a:gd name="T43" fmla="*/ 22 h 57"/>
              <a:gd name="T44" fmla="*/ 62 w 69"/>
              <a:gd name="T45" fmla="*/ 19 h 57"/>
              <a:gd name="T46" fmla="*/ 62 w 69"/>
              <a:gd name="T47" fmla="*/ 18 h 57"/>
              <a:gd name="T48" fmla="*/ 62 w 69"/>
              <a:gd name="T49" fmla="*/ 17 h 57"/>
              <a:gd name="T50" fmla="*/ 63 w 69"/>
              <a:gd name="T51" fmla="*/ 14 h 57"/>
              <a:gd name="T52" fmla="*/ 63 w 69"/>
              <a:gd name="T53" fmla="*/ 12 h 57"/>
              <a:gd name="T54" fmla="*/ 63 w 69"/>
              <a:gd name="T55" fmla="*/ 11 h 57"/>
              <a:gd name="T56" fmla="*/ 65 w 69"/>
              <a:gd name="T57" fmla="*/ 8 h 57"/>
              <a:gd name="T58" fmla="*/ 65 w 69"/>
              <a:gd name="T59" fmla="*/ 7 h 57"/>
              <a:gd name="T60" fmla="*/ 66 w 69"/>
              <a:gd name="T61" fmla="*/ 6 h 57"/>
              <a:gd name="T62" fmla="*/ 66 w 69"/>
              <a:gd name="T63" fmla="*/ 3 h 57"/>
              <a:gd name="T64" fmla="*/ 67 w 69"/>
              <a:gd name="T65" fmla="*/ 1 h 57"/>
              <a:gd name="T66" fmla="*/ 69 w 69"/>
              <a:gd name="T67" fmla="*/ 0 h 57"/>
              <a:gd name="T68" fmla="*/ 0 w 69"/>
              <a:gd name="T69" fmla="*/ 29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69" h="57">
                <a:moveTo>
                  <a:pt x="0" y="29"/>
                </a:moveTo>
                <a:lnTo>
                  <a:pt x="69" y="57"/>
                </a:lnTo>
                <a:lnTo>
                  <a:pt x="67" y="56"/>
                </a:lnTo>
                <a:lnTo>
                  <a:pt x="66" y="55"/>
                </a:lnTo>
                <a:lnTo>
                  <a:pt x="66" y="52"/>
                </a:lnTo>
                <a:lnTo>
                  <a:pt x="65" y="51"/>
                </a:lnTo>
                <a:lnTo>
                  <a:pt x="65" y="49"/>
                </a:lnTo>
                <a:lnTo>
                  <a:pt x="63" y="47"/>
                </a:lnTo>
                <a:lnTo>
                  <a:pt x="63" y="45"/>
                </a:lnTo>
                <a:lnTo>
                  <a:pt x="63" y="44"/>
                </a:lnTo>
                <a:lnTo>
                  <a:pt x="62" y="41"/>
                </a:lnTo>
                <a:lnTo>
                  <a:pt x="62" y="40"/>
                </a:lnTo>
                <a:lnTo>
                  <a:pt x="62" y="38"/>
                </a:lnTo>
                <a:lnTo>
                  <a:pt x="62" y="36"/>
                </a:lnTo>
                <a:lnTo>
                  <a:pt x="60" y="34"/>
                </a:lnTo>
                <a:lnTo>
                  <a:pt x="60" y="33"/>
                </a:lnTo>
                <a:lnTo>
                  <a:pt x="60" y="30"/>
                </a:lnTo>
                <a:lnTo>
                  <a:pt x="60" y="29"/>
                </a:lnTo>
                <a:lnTo>
                  <a:pt x="60" y="27"/>
                </a:lnTo>
                <a:lnTo>
                  <a:pt x="60" y="25"/>
                </a:lnTo>
                <a:lnTo>
                  <a:pt x="60" y="23"/>
                </a:lnTo>
                <a:lnTo>
                  <a:pt x="62" y="22"/>
                </a:lnTo>
                <a:lnTo>
                  <a:pt x="62" y="19"/>
                </a:lnTo>
                <a:lnTo>
                  <a:pt x="62" y="18"/>
                </a:lnTo>
                <a:lnTo>
                  <a:pt x="62" y="17"/>
                </a:lnTo>
                <a:lnTo>
                  <a:pt x="63" y="14"/>
                </a:lnTo>
                <a:lnTo>
                  <a:pt x="63" y="12"/>
                </a:lnTo>
                <a:lnTo>
                  <a:pt x="63" y="11"/>
                </a:lnTo>
                <a:lnTo>
                  <a:pt x="65" y="8"/>
                </a:lnTo>
                <a:lnTo>
                  <a:pt x="65" y="7"/>
                </a:lnTo>
                <a:lnTo>
                  <a:pt x="66" y="6"/>
                </a:lnTo>
                <a:lnTo>
                  <a:pt x="66" y="3"/>
                </a:lnTo>
                <a:lnTo>
                  <a:pt x="67" y="1"/>
                </a:lnTo>
                <a:lnTo>
                  <a:pt x="69" y="0"/>
                </a:lnTo>
                <a:lnTo>
                  <a:pt x="0" y="29"/>
                </a:lnTo>
                <a:close/>
              </a:path>
            </a:pathLst>
          </a:custGeom>
          <a:solidFill>
            <a:srgbClr val="6699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782" name="Line 102"/>
          <p:cNvSpPr>
            <a:spLocks noChangeShapeType="1"/>
          </p:cNvSpPr>
          <p:nvPr/>
        </p:nvSpPr>
        <p:spPr bwMode="auto">
          <a:xfrm flipH="1">
            <a:off x="7223126" y="4778376"/>
            <a:ext cx="23813" cy="188913"/>
          </a:xfrm>
          <a:prstGeom prst="line">
            <a:avLst/>
          </a:prstGeom>
          <a:noFill/>
          <a:ln w="57150">
            <a:solidFill>
              <a:srgbClr val="00FF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783" name="Rectangle 103"/>
          <p:cNvSpPr>
            <a:spLocks noChangeArrowheads="1"/>
          </p:cNvSpPr>
          <p:nvPr/>
        </p:nvSpPr>
        <p:spPr bwMode="auto">
          <a:xfrm>
            <a:off x="6321426" y="4691064"/>
            <a:ext cx="676275" cy="117475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795" name="Rectangle 115"/>
          <p:cNvSpPr>
            <a:spLocks noChangeArrowheads="1"/>
          </p:cNvSpPr>
          <p:nvPr/>
        </p:nvSpPr>
        <p:spPr bwMode="auto">
          <a:xfrm>
            <a:off x="6905626" y="5021264"/>
            <a:ext cx="676275" cy="117475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796" name="Rectangle 116"/>
          <p:cNvSpPr>
            <a:spLocks noChangeArrowheads="1"/>
          </p:cNvSpPr>
          <p:nvPr/>
        </p:nvSpPr>
        <p:spPr bwMode="auto">
          <a:xfrm>
            <a:off x="7491414" y="5364164"/>
            <a:ext cx="676275" cy="117475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01" name="AutoShape 121"/>
          <p:cNvSpPr>
            <a:spLocks noChangeArrowheads="1"/>
          </p:cNvSpPr>
          <p:nvPr/>
        </p:nvSpPr>
        <p:spPr bwMode="auto">
          <a:xfrm>
            <a:off x="4521200" y="5634039"/>
            <a:ext cx="1665288" cy="180975"/>
          </a:xfrm>
          <a:prstGeom prst="leftArrow">
            <a:avLst>
              <a:gd name="adj1" fmla="val 50000"/>
              <a:gd name="adj2" fmla="val 230044"/>
            </a:avLst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02" name="AutoShape 122"/>
          <p:cNvSpPr>
            <a:spLocks noChangeArrowheads="1"/>
          </p:cNvSpPr>
          <p:nvPr/>
        </p:nvSpPr>
        <p:spPr bwMode="auto">
          <a:xfrm flipH="1" flipV="1">
            <a:off x="8526464" y="5634039"/>
            <a:ext cx="1665287" cy="180975"/>
          </a:xfrm>
          <a:prstGeom prst="leftArrow">
            <a:avLst>
              <a:gd name="adj1" fmla="val 50000"/>
              <a:gd name="adj2" fmla="val 230044"/>
            </a:avLst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03" name="Text Box 123"/>
          <p:cNvSpPr txBox="1">
            <a:spLocks noChangeArrowheads="1"/>
          </p:cNvSpPr>
          <p:nvPr/>
        </p:nvSpPr>
        <p:spPr bwMode="auto">
          <a:xfrm>
            <a:off x="6477278" y="5557394"/>
            <a:ext cx="149752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uscle fibers</a:t>
            </a:r>
          </a:p>
        </p:txBody>
      </p:sp>
      <p:sp>
        <p:nvSpPr>
          <p:cNvPr id="71807" name="Freeform 127"/>
          <p:cNvSpPr>
            <a:spLocks/>
          </p:cNvSpPr>
          <p:nvPr/>
        </p:nvSpPr>
        <p:spPr bwMode="auto">
          <a:xfrm>
            <a:off x="6410325" y="271464"/>
            <a:ext cx="1125538" cy="592137"/>
          </a:xfrm>
          <a:custGeom>
            <a:avLst/>
            <a:gdLst>
              <a:gd name="T0" fmla="*/ 0 w 709"/>
              <a:gd name="T1" fmla="*/ 5 h 373"/>
              <a:gd name="T2" fmla="*/ 454 w 709"/>
              <a:gd name="T3" fmla="*/ 33 h 373"/>
              <a:gd name="T4" fmla="*/ 652 w 709"/>
              <a:gd name="T5" fmla="*/ 203 h 373"/>
              <a:gd name="T6" fmla="*/ 709 w 709"/>
              <a:gd name="T7" fmla="*/ 373 h 3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9" h="373">
                <a:moveTo>
                  <a:pt x="0" y="5"/>
                </a:moveTo>
                <a:cubicBezTo>
                  <a:pt x="172" y="2"/>
                  <a:pt x="345" y="0"/>
                  <a:pt x="454" y="33"/>
                </a:cubicBezTo>
                <a:cubicBezTo>
                  <a:pt x="563" y="66"/>
                  <a:pt x="610" y="146"/>
                  <a:pt x="652" y="203"/>
                </a:cubicBezTo>
                <a:cubicBezTo>
                  <a:pt x="694" y="260"/>
                  <a:pt x="700" y="345"/>
                  <a:pt x="709" y="373"/>
                </a:cubicBezTo>
              </a:path>
            </a:pathLst>
          </a:custGeom>
          <a:noFill/>
          <a:ln w="38100" cmpd="sng">
            <a:solidFill>
              <a:srgbClr val="00FF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808" name="Oval 128"/>
          <p:cNvSpPr>
            <a:spLocks noChangeArrowheads="1"/>
          </p:cNvSpPr>
          <p:nvPr/>
        </p:nvSpPr>
        <p:spPr bwMode="auto">
          <a:xfrm>
            <a:off x="7472364" y="800100"/>
            <a:ext cx="134937" cy="134938"/>
          </a:xfrm>
          <a:prstGeom prst="ellipse">
            <a:avLst/>
          </a:prstGeom>
          <a:solidFill>
            <a:srgbClr val="00FF00"/>
          </a:solidFill>
          <a:ln w="9525">
            <a:solidFill>
              <a:srgbClr val="00FF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09" name="Oval 129"/>
          <p:cNvSpPr>
            <a:spLocks noChangeArrowheads="1"/>
          </p:cNvSpPr>
          <p:nvPr/>
        </p:nvSpPr>
        <p:spPr bwMode="auto">
          <a:xfrm>
            <a:off x="7896225" y="549275"/>
            <a:ext cx="134938" cy="134938"/>
          </a:xfrm>
          <a:prstGeom prst="ellipse">
            <a:avLst/>
          </a:prstGeom>
          <a:solidFill>
            <a:srgbClr val="00FF00"/>
          </a:solidFill>
          <a:ln w="9525">
            <a:solidFill>
              <a:srgbClr val="00FF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10" name="Oval 130"/>
          <p:cNvSpPr>
            <a:spLocks noChangeArrowheads="1"/>
          </p:cNvSpPr>
          <p:nvPr/>
        </p:nvSpPr>
        <p:spPr bwMode="auto">
          <a:xfrm>
            <a:off x="8210550" y="908050"/>
            <a:ext cx="134938" cy="134938"/>
          </a:xfrm>
          <a:prstGeom prst="ellipse">
            <a:avLst/>
          </a:prstGeom>
          <a:solidFill>
            <a:srgbClr val="00FF00"/>
          </a:solidFill>
          <a:ln w="9525">
            <a:solidFill>
              <a:srgbClr val="00FF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11" name="Freeform 131"/>
          <p:cNvSpPr>
            <a:spLocks/>
          </p:cNvSpPr>
          <p:nvPr/>
        </p:nvSpPr>
        <p:spPr bwMode="auto">
          <a:xfrm>
            <a:off x="7747000" y="174625"/>
            <a:ext cx="1093788" cy="419100"/>
          </a:xfrm>
          <a:custGeom>
            <a:avLst/>
            <a:gdLst>
              <a:gd name="T0" fmla="*/ 689 w 689"/>
              <a:gd name="T1" fmla="*/ 9 h 264"/>
              <a:gd name="T2" fmla="*/ 406 w 689"/>
              <a:gd name="T3" fmla="*/ 9 h 264"/>
              <a:gd name="T4" fmla="*/ 66 w 689"/>
              <a:gd name="T5" fmla="*/ 66 h 264"/>
              <a:gd name="T6" fmla="*/ 9 w 689"/>
              <a:gd name="T7" fmla="*/ 207 h 264"/>
              <a:gd name="T8" fmla="*/ 122 w 689"/>
              <a:gd name="T9" fmla="*/ 264 h 2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689" h="264">
                <a:moveTo>
                  <a:pt x="689" y="9"/>
                </a:moveTo>
                <a:cubicBezTo>
                  <a:pt x="599" y="4"/>
                  <a:pt x="510" y="0"/>
                  <a:pt x="406" y="9"/>
                </a:cubicBezTo>
                <a:cubicBezTo>
                  <a:pt x="302" y="18"/>
                  <a:pt x="132" y="33"/>
                  <a:pt x="66" y="66"/>
                </a:cubicBezTo>
                <a:cubicBezTo>
                  <a:pt x="0" y="99"/>
                  <a:pt x="0" y="174"/>
                  <a:pt x="9" y="207"/>
                </a:cubicBezTo>
                <a:cubicBezTo>
                  <a:pt x="18" y="240"/>
                  <a:pt x="103" y="254"/>
                  <a:pt x="122" y="264"/>
                </a:cubicBezTo>
              </a:path>
            </a:pathLst>
          </a:custGeom>
          <a:noFill/>
          <a:ln w="38100" cmpd="sng">
            <a:solidFill>
              <a:srgbClr val="00FF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812" name="Freeform 132"/>
          <p:cNvSpPr>
            <a:spLocks/>
          </p:cNvSpPr>
          <p:nvPr/>
        </p:nvSpPr>
        <p:spPr bwMode="auto">
          <a:xfrm>
            <a:off x="8288339" y="323850"/>
            <a:ext cx="720725" cy="630238"/>
          </a:xfrm>
          <a:custGeom>
            <a:avLst/>
            <a:gdLst>
              <a:gd name="T0" fmla="*/ 0 w 454"/>
              <a:gd name="T1" fmla="*/ 397 h 397"/>
              <a:gd name="T2" fmla="*/ 29 w 454"/>
              <a:gd name="T3" fmla="*/ 227 h 397"/>
              <a:gd name="T4" fmla="*/ 114 w 454"/>
              <a:gd name="T5" fmla="*/ 113 h 397"/>
              <a:gd name="T6" fmla="*/ 454 w 454"/>
              <a:gd name="T7" fmla="*/ 0 h 3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54" h="397">
                <a:moveTo>
                  <a:pt x="0" y="397"/>
                </a:moveTo>
                <a:cubicBezTo>
                  <a:pt x="5" y="335"/>
                  <a:pt x="10" y="274"/>
                  <a:pt x="29" y="227"/>
                </a:cubicBezTo>
                <a:cubicBezTo>
                  <a:pt x="48" y="180"/>
                  <a:pt x="43" y="151"/>
                  <a:pt x="114" y="113"/>
                </a:cubicBezTo>
                <a:cubicBezTo>
                  <a:pt x="185" y="75"/>
                  <a:pt x="397" y="19"/>
                  <a:pt x="454" y="0"/>
                </a:cubicBezTo>
              </a:path>
            </a:pathLst>
          </a:custGeom>
          <a:noFill/>
          <a:ln w="38100" cmpd="sng">
            <a:solidFill>
              <a:srgbClr val="00FF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813" name="Text Box 133"/>
          <p:cNvSpPr txBox="1">
            <a:spLocks noChangeArrowheads="1"/>
          </p:cNvSpPr>
          <p:nvPr/>
        </p:nvSpPr>
        <p:spPr bwMode="auto">
          <a:xfrm>
            <a:off x="4484064" y="5820585"/>
            <a:ext cx="183736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 m/s = 4 mm/ms</a:t>
            </a:r>
          </a:p>
        </p:txBody>
      </p:sp>
      <p:sp>
        <p:nvSpPr>
          <p:cNvPr id="71814" name="Text Box 134"/>
          <p:cNvSpPr txBox="1">
            <a:spLocks noChangeArrowheads="1"/>
          </p:cNvSpPr>
          <p:nvPr/>
        </p:nvSpPr>
        <p:spPr bwMode="auto">
          <a:xfrm>
            <a:off x="8440426" y="5813288"/>
            <a:ext cx="183736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 m/s = 4 mm/ms</a:t>
            </a:r>
          </a:p>
        </p:txBody>
      </p:sp>
      <p:sp>
        <p:nvSpPr>
          <p:cNvPr id="71815" name="Freeform 135"/>
          <p:cNvSpPr>
            <a:spLocks/>
          </p:cNvSpPr>
          <p:nvPr/>
        </p:nvSpPr>
        <p:spPr bwMode="auto">
          <a:xfrm rot="20792173">
            <a:off x="6325882" y="2523450"/>
            <a:ext cx="193158" cy="1039603"/>
          </a:xfrm>
          <a:custGeom>
            <a:avLst/>
            <a:gdLst>
              <a:gd name="T0" fmla="*/ 576 w 576"/>
              <a:gd name="T1" fmla="*/ 0 h 1417"/>
              <a:gd name="T2" fmla="*/ 378 w 576"/>
              <a:gd name="T3" fmla="*/ 142 h 1417"/>
              <a:gd name="T4" fmla="*/ 151 w 576"/>
              <a:gd name="T5" fmla="*/ 368 h 1417"/>
              <a:gd name="T6" fmla="*/ 38 w 576"/>
              <a:gd name="T7" fmla="*/ 680 h 1417"/>
              <a:gd name="T8" fmla="*/ 9 w 576"/>
              <a:gd name="T9" fmla="*/ 1162 h 1417"/>
              <a:gd name="T10" fmla="*/ 94 w 576"/>
              <a:gd name="T11" fmla="*/ 1417 h 14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76" h="1417">
                <a:moveTo>
                  <a:pt x="576" y="0"/>
                </a:moveTo>
                <a:cubicBezTo>
                  <a:pt x="512" y="40"/>
                  <a:pt x="449" y="81"/>
                  <a:pt x="378" y="142"/>
                </a:cubicBezTo>
                <a:cubicBezTo>
                  <a:pt x="307" y="203"/>
                  <a:pt x="208" y="278"/>
                  <a:pt x="151" y="368"/>
                </a:cubicBezTo>
                <a:cubicBezTo>
                  <a:pt x="94" y="458"/>
                  <a:pt x="62" y="548"/>
                  <a:pt x="38" y="680"/>
                </a:cubicBezTo>
                <a:cubicBezTo>
                  <a:pt x="14" y="812"/>
                  <a:pt x="0" y="1039"/>
                  <a:pt x="9" y="1162"/>
                </a:cubicBezTo>
                <a:cubicBezTo>
                  <a:pt x="18" y="1285"/>
                  <a:pt x="80" y="1375"/>
                  <a:pt x="94" y="1417"/>
                </a:cubicBezTo>
              </a:path>
            </a:pathLst>
          </a:custGeom>
          <a:noFill/>
          <a:ln w="28575" cmpd="sng">
            <a:solidFill>
              <a:srgbClr val="FF0000"/>
            </a:solidFill>
            <a:round/>
            <a:headEnd type="none" w="med" len="med"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816" name="Text Box 136"/>
          <p:cNvSpPr txBox="1">
            <a:spLocks noChangeArrowheads="1"/>
          </p:cNvSpPr>
          <p:nvPr/>
        </p:nvSpPr>
        <p:spPr bwMode="auto">
          <a:xfrm rot="16200000">
            <a:off x="5576746" y="2816936"/>
            <a:ext cx="100059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0-70 m/s</a:t>
            </a:r>
          </a:p>
        </p:txBody>
      </p:sp>
      <p:sp>
        <p:nvSpPr>
          <p:cNvPr id="71818" name="Text Box 138"/>
          <p:cNvSpPr txBox="1">
            <a:spLocks noChangeArrowheads="1"/>
          </p:cNvSpPr>
          <p:nvPr/>
        </p:nvSpPr>
        <p:spPr bwMode="auto">
          <a:xfrm>
            <a:off x="5600701" y="414338"/>
            <a:ext cx="1800225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it-IT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nputs from other neurons</a:t>
            </a:r>
          </a:p>
        </p:txBody>
      </p:sp>
      <p:sp>
        <p:nvSpPr>
          <p:cNvPr id="71819" name="Line 139"/>
          <p:cNvSpPr>
            <a:spLocks noChangeShapeType="1"/>
          </p:cNvSpPr>
          <p:nvPr/>
        </p:nvSpPr>
        <p:spPr bwMode="auto">
          <a:xfrm flipV="1">
            <a:off x="6996114" y="549275"/>
            <a:ext cx="314325" cy="179388"/>
          </a:xfrm>
          <a:prstGeom prst="line">
            <a:avLst/>
          </a:prstGeom>
          <a:noFill/>
          <a:ln w="19050">
            <a:solidFill>
              <a:schemeClr val="bg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1820" name="AutoShape 140"/>
          <p:cNvSpPr>
            <a:spLocks noChangeArrowheads="1"/>
          </p:cNvSpPr>
          <p:nvPr/>
        </p:nvSpPr>
        <p:spPr bwMode="auto">
          <a:xfrm>
            <a:off x="7670800" y="1179514"/>
            <a:ext cx="134938" cy="179387"/>
          </a:xfrm>
          <a:prstGeom prst="irregularSeal1">
            <a:avLst/>
          </a:prstGeom>
          <a:solidFill>
            <a:srgbClr val="FFFF00"/>
          </a:solidFill>
          <a:ln w="9525" algn="ctr">
            <a:solidFill>
              <a:srgbClr val="FFFF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21" name="AutoShape 141"/>
          <p:cNvSpPr>
            <a:spLocks noChangeArrowheads="1"/>
          </p:cNvSpPr>
          <p:nvPr/>
        </p:nvSpPr>
        <p:spPr bwMode="auto">
          <a:xfrm>
            <a:off x="7626350" y="1133475"/>
            <a:ext cx="134938" cy="179388"/>
          </a:xfrm>
          <a:prstGeom prst="irregularSeal1">
            <a:avLst/>
          </a:prstGeom>
          <a:solidFill>
            <a:srgbClr val="FFFF00"/>
          </a:solidFill>
          <a:ln w="9525" algn="ctr">
            <a:solidFill>
              <a:srgbClr val="FFFF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22" name="AutoShape 142"/>
          <p:cNvSpPr>
            <a:spLocks noChangeArrowheads="1"/>
          </p:cNvSpPr>
          <p:nvPr/>
        </p:nvSpPr>
        <p:spPr bwMode="auto">
          <a:xfrm>
            <a:off x="7581900" y="1133476"/>
            <a:ext cx="134938" cy="180975"/>
          </a:xfrm>
          <a:prstGeom prst="irregularSeal1">
            <a:avLst/>
          </a:prstGeom>
          <a:solidFill>
            <a:srgbClr val="FFFF00"/>
          </a:solidFill>
          <a:ln w="9525" algn="ctr">
            <a:solidFill>
              <a:srgbClr val="FFFF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23" name="Text Box 143"/>
          <p:cNvSpPr txBox="1">
            <a:spLocks noChangeArrowheads="1"/>
          </p:cNvSpPr>
          <p:nvPr/>
        </p:nvSpPr>
        <p:spPr bwMode="auto">
          <a:xfrm>
            <a:off x="2495606" y="6220541"/>
            <a:ext cx="678493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0" hangingPunct="0"/>
            <a:r>
              <a:rPr lang="it-IT" altLang="en-US" sz="1600" b="1" dirty="0" err="1"/>
              <a:t>One</a:t>
            </a:r>
            <a:r>
              <a:rPr lang="it-IT" altLang="en-US" sz="1600" b="1" dirty="0"/>
              <a:t> </a:t>
            </a:r>
            <a:r>
              <a:rPr lang="it-IT" altLang="en-US" sz="1600" b="1" dirty="0" err="1"/>
              <a:t>muscle</a:t>
            </a:r>
            <a:r>
              <a:rPr lang="it-IT" altLang="en-US" sz="1600" b="1" dirty="0"/>
              <a:t>: 10-1000 MU     </a:t>
            </a:r>
            <a:r>
              <a:rPr lang="it-IT" altLang="en-US" sz="1600" b="1" dirty="0" err="1"/>
              <a:t>One</a:t>
            </a:r>
            <a:r>
              <a:rPr lang="it-IT" altLang="en-US" sz="1600" b="1" dirty="0"/>
              <a:t> MU:  50-1000 </a:t>
            </a:r>
            <a:r>
              <a:rPr lang="it-IT" altLang="en-US" sz="1600" b="1" dirty="0" err="1"/>
              <a:t>fibers</a:t>
            </a:r>
            <a:r>
              <a:rPr lang="it-IT" altLang="en-US" sz="1600" b="1" dirty="0"/>
              <a:t> of the </a:t>
            </a:r>
            <a:r>
              <a:rPr lang="it-IT" altLang="en-US" sz="1600" b="1" dirty="0" err="1"/>
              <a:t>same</a:t>
            </a:r>
            <a:r>
              <a:rPr lang="it-IT" altLang="en-US" sz="1600" b="1" dirty="0"/>
              <a:t> </a:t>
            </a:r>
            <a:r>
              <a:rPr lang="it-IT" altLang="en-US" sz="1600" b="1" dirty="0" err="1"/>
              <a:t>type</a:t>
            </a:r>
            <a:r>
              <a:rPr lang="it-IT" altLang="en-US" sz="1600" b="1" dirty="0"/>
              <a:t>  (I or II)</a:t>
            </a:r>
          </a:p>
        </p:txBody>
      </p:sp>
      <p:sp>
        <p:nvSpPr>
          <p:cNvPr id="71824" name="Rectangle 144"/>
          <p:cNvSpPr>
            <a:spLocks noChangeArrowheads="1"/>
          </p:cNvSpPr>
          <p:nvPr/>
        </p:nvSpPr>
        <p:spPr bwMode="auto">
          <a:xfrm>
            <a:off x="6905626" y="5021264"/>
            <a:ext cx="676275" cy="117475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25" name="Rectangle 145"/>
          <p:cNvSpPr>
            <a:spLocks noChangeArrowheads="1"/>
          </p:cNvSpPr>
          <p:nvPr/>
        </p:nvSpPr>
        <p:spPr bwMode="auto">
          <a:xfrm>
            <a:off x="7491414" y="5372101"/>
            <a:ext cx="676275" cy="117475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826" name="Rectangle 146"/>
          <p:cNvSpPr>
            <a:spLocks noChangeArrowheads="1"/>
          </p:cNvSpPr>
          <p:nvPr/>
        </p:nvSpPr>
        <p:spPr bwMode="auto">
          <a:xfrm>
            <a:off x="6321426" y="4691064"/>
            <a:ext cx="676275" cy="117475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57" name="Freeform 77">
            <a:extLst>
              <a:ext uri="{FF2B5EF4-FFF2-40B4-BE49-F238E27FC236}">
                <a16:creationId xmlns:a16="http://schemas.microsoft.com/office/drawing/2014/main" id="{2C67971D-6CAE-4664-8920-EBE4DD3CC0F8}"/>
              </a:ext>
            </a:extLst>
          </p:cNvPr>
          <p:cNvSpPr>
            <a:spLocks/>
          </p:cNvSpPr>
          <p:nvPr/>
        </p:nvSpPr>
        <p:spPr bwMode="auto">
          <a:xfrm>
            <a:off x="2211265" y="5010535"/>
            <a:ext cx="284341" cy="119062"/>
          </a:xfrm>
          <a:custGeom>
            <a:avLst/>
            <a:gdLst>
              <a:gd name="T0" fmla="*/ 45 w 89"/>
              <a:gd name="T1" fmla="*/ 89 h 89"/>
              <a:gd name="T2" fmla="*/ 53 w 89"/>
              <a:gd name="T3" fmla="*/ 89 h 89"/>
              <a:gd name="T4" fmla="*/ 61 w 89"/>
              <a:gd name="T5" fmla="*/ 86 h 89"/>
              <a:gd name="T6" fmla="*/ 70 w 89"/>
              <a:gd name="T7" fmla="*/ 82 h 89"/>
              <a:gd name="T8" fmla="*/ 76 w 89"/>
              <a:gd name="T9" fmla="*/ 76 h 89"/>
              <a:gd name="T10" fmla="*/ 82 w 89"/>
              <a:gd name="T11" fmla="*/ 70 h 89"/>
              <a:gd name="T12" fmla="*/ 86 w 89"/>
              <a:gd name="T13" fmla="*/ 61 h 89"/>
              <a:gd name="T14" fmla="*/ 89 w 89"/>
              <a:gd name="T15" fmla="*/ 53 h 89"/>
              <a:gd name="T16" fmla="*/ 89 w 89"/>
              <a:gd name="T17" fmla="*/ 45 h 89"/>
              <a:gd name="T18" fmla="*/ 89 w 89"/>
              <a:gd name="T19" fmla="*/ 35 h 89"/>
              <a:gd name="T20" fmla="*/ 86 w 89"/>
              <a:gd name="T21" fmla="*/ 27 h 89"/>
              <a:gd name="T22" fmla="*/ 82 w 89"/>
              <a:gd name="T23" fmla="*/ 20 h 89"/>
              <a:gd name="T24" fmla="*/ 76 w 89"/>
              <a:gd name="T25" fmla="*/ 14 h 89"/>
              <a:gd name="T26" fmla="*/ 70 w 89"/>
              <a:gd name="T27" fmla="*/ 8 h 89"/>
              <a:gd name="T28" fmla="*/ 61 w 89"/>
              <a:gd name="T29" fmla="*/ 4 h 89"/>
              <a:gd name="T30" fmla="*/ 53 w 89"/>
              <a:gd name="T31" fmla="*/ 1 h 89"/>
              <a:gd name="T32" fmla="*/ 45 w 89"/>
              <a:gd name="T33" fmla="*/ 0 h 89"/>
              <a:gd name="T34" fmla="*/ 35 w 89"/>
              <a:gd name="T35" fmla="*/ 1 h 89"/>
              <a:gd name="T36" fmla="*/ 27 w 89"/>
              <a:gd name="T37" fmla="*/ 4 h 89"/>
              <a:gd name="T38" fmla="*/ 20 w 89"/>
              <a:gd name="T39" fmla="*/ 8 h 89"/>
              <a:gd name="T40" fmla="*/ 14 w 89"/>
              <a:gd name="T41" fmla="*/ 14 h 89"/>
              <a:gd name="T42" fmla="*/ 8 w 89"/>
              <a:gd name="T43" fmla="*/ 20 h 89"/>
              <a:gd name="T44" fmla="*/ 4 w 89"/>
              <a:gd name="T45" fmla="*/ 27 h 89"/>
              <a:gd name="T46" fmla="*/ 1 w 89"/>
              <a:gd name="T47" fmla="*/ 35 h 89"/>
              <a:gd name="T48" fmla="*/ 0 w 89"/>
              <a:gd name="T49" fmla="*/ 45 h 89"/>
              <a:gd name="T50" fmla="*/ 1 w 89"/>
              <a:gd name="T51" fmla="*/ 53 h 89"/>
              <a:gd name="T52" fmla="*/ 4 w 89"/>
              <a:gd name="T53" fmla="*/ 61 h 89"/>
              <a:gd name="T54" fmla="*/ 8 w 89"/>
              <a:gd name="T55" fmla="*/ 70 h 89"/>
              <a:gd name="T56" fmla="*/ 14 w 89"/>
              <a:gd name="T57" fmla="*/ 76 h 89"/>
              <a:gd name="T58" fmla="*/ 20 w 89"/>
              <a:gd name="T59" fmla="*/ 82 h 89"/>
              <a:gd name="T60" fmla="*/ 27 w 89"/>
              <a:gd name="T61" fmla="*/ 86 h 89"/>
              <a:gd name="T62" fmla="*/ 35 w 89"/>
              <a:gd name="T63" fmla="*/ 89 h 89"/>
              <a:gd name="T64" fmla="*/ 45 w 89"/>
              <a:gd name="T65" fmla="*/ 89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</a:cxnLst>
            <a:rect l="0" t="0" r="r" b="b"/>
            <a:pathLst>
              <a:path w="89" h="89">
                <a:moveTo>
                  <a:pt x="45" y="89"/>
                </a:moveTo>
                <a:lnTo>
                  <a:pt x="53" y="89"/>
                </a:lnTo>
                <a:lnTo>
                  <a:pt x="61" y="86"/>
                </a:lnTo>
                <a:lnTo>
                  <a:pt x="70" y="82"/>
                </a:lnTo>
                <a:lnTo>
                  <a:pt x="76" y="76"/>
                </a:lnTo>
                <a:lnTo>
                  <a:pt x="82" y="70"/>
                </a:lnTo>
                <a:lnTo>
                  <a:pt x="86" y="61"/>
                </a:lnTo>
                <a:lnTo>
                  <a:pt x="89" y="53"/>
                </a:lnTo>
                <a:lnTo>
                  <a:pt x="89" y="45"/>
                </a:lnTo>
                <a:lnTo>
                  <a:pt x="89" y="35"/>
                </a:lnTo>
                <a:lnTo>
                  <a:pt x="86" y="27"/>
                </a:lnTo>
                <a:lnTo>
                  <a:pt x="82" y="20"/>
                </a:lnTo>
                <a:lnTo>
                  <a:pt x="76" y="14"/>
                </a:lnTo>
                <a:lnTo>
                  <a:pt x="70" y="8"/>
                </a:lnTo>
                <a:lnTo>
                  <a:pt x="61" y="4"/>
                </a:lnTo>
                <a:lnTo>
                  <a:pt x="53" y="1"/>
                </a:lnTo>
                <a:lnTo>
                  <a:pt x="45" y="0"/>
                </a:lnTo>
                <a:lnTo>
                  <a:pt x="35" y="1"/>
                </a:lnTo>
                <a:lnTo>
                  <a:pt x="27" y="4"/>
                </a:lnTo>
                <a:lnTo>
                  <a:pt x="20" y="8"/>
                </a:lnTo>
                <a:lnTo>
                  <a:pt x="14" y="14"/>
                </a:lnTo>
                <a:lnTo>
                  <a:pt x="8" y="20"/>
                </a:lnTo>
                <a:lnTo>
                  <a:pt x="4" y="27"/>
                </a:lnTo>
                <a:lnTo>
                  <a:pt x="1" y="35"/>
                </a:lnTo>
                <a:lnTo>
                  <a:pt x="0" y="45"/>
                </a:lnTo>
                <a:lnTo>
                  <a:pt x="1" y="53"/>
                </a:lnTo>
                <a:lnTo>
                  <a:pt x="4" y="61"/>
                </a:lnTo>
                <a:lnTo>
                  <a:pt x="8" y="70"/>
                </a:lnTo>
                <a:lnTo>
                  <a:pt x="14" y="76"/>
                </a:lnTo>
                <a:lnTo>
                  <a:pt x="20" y="82"/>
                </a:lnTo>
                <a:lnTo>
                  <a:pt x="27" y="86"/>
                </a:lnTo>
                <a:lnTo>
                  <a:pt x="35" y="89"/>
                </a:lnTo>
                <a:lnTo>
                  <a:pt x="45" y="89"/>
                </a:lnTo>
                <a:close/>
              </a:path>
            </a:pathLst>
          </a:custGeom>
          <a:solidFill>
            <a:srgbClr val="FFCC99"/>
          </a:solidFill>
          <a:ln w="12700" cmpd="sng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59" name="Freeform 77">
            <a:extLst>
              <a:ext uri="{FF2B5EF4-FFF2-40B4-BE49-F238E27FC236}">
                <a16:creationId xmlns:a16="http://schemas.microsoft.com/office/drawing/2014/main" id="{8360C8FF-4BAF-4F52-9242-54A89A496841}"/>
              </a:ext>
            </a:extLst>
          </p:cNvPr>
          <p:cNvSpPr>
            <a:spLocks/>
          </p:cNvSpPr>
          <p:nvPr/>
        </p:nvSpPr>
        <p:spPr bwMode="auto">
          <a:xfrm>
            <a:off x="2660585" y="5377084"/>
            <a:ext cx="284341" cy="119062"/>
          </a:xfrm>
          <a:custGeom>
            <a:avLst/>
            <a:gdLst>
              <a:gd name="T0" fmla="*/ 45 w 89"/>
              <a:gd name="T1" fmla="*/ 89 h 89"/>
              <a:gd name="T2" fmla="*/ 53 w 89"/>
              <a:gd name="T3" fmla="*/ 89 h 89"/>
              <a:gd name="T4" fmla="*/ 61 w 89"/>
              <a:gd name="T5" fmla="*/ 86 h 89"/>
              <a:gd name="T6" fmla="*/ 70 w 89"/>
              <a:gd name="T7" fmla="*/ 82 h 89"/>
              <a:gd name="T8" fmla="*/ 76 w 89"/>
              <a:gd name="T9" fmla="*/ 76 h 89"/>
              <a:gd name="T10" fmla="*/ 82 w 89"/>
              <a:gd name="T11" fmla="*/ 70 h 89"/>
              <a:gd name="T12" fmla="*/ 86 w 89"/>
              <a:gd name="T13" fmla="*/ 61 h 89"/>
              <a:gd name="T14" fmla="*/ 89 w 89"/>
              <a:gd name="T15" fmla="*/ 53 h 89"/>
              <a:gd name="T16" fmla="*/ 89 w 89"/>
              <a:gd name="T17" fmla="*/ 45 h 89"/>
              <a:gd name="T18" fmla="*/ 89 w 89"/>
              <a:gd name="T19" fmla="*/ 35 h 89"/>
              <a:gd name="T20" fmla="*/ 86 w 89"/>
              <a:gd name="T21" fmla="*/ 27 h 89"/>
              <a:gd name="T22" fmla="*/ 82 w 89"/>
              <a:gd name="T23" fmla="*/ 20 h 89"/>
              <a:gd name="T24" fmla="*/ 76 w 89"/>
              <a:gd name="T25" fmla="*/ 14 h 89"/>
              <a:gd name="T26" fmla="*/ 70 w 89"/>
              <a:gd name="T27" fmla="*/ 8 h 89"/>
              <a:gd name="T28" fmla="*/ 61 w 89"/>
              <a:gd name="T29" fmla="*/ 4 h 89"/>
              <a:gd name="T30" fmla="*/ 53 w 89"/>
              <a:gd name="T31" fmla="*/ 1 h 89"/>
              <a:gd name="T32" fmla="*/ 45 w 89"/>
              <a:gd name="T33" fmla="*/ 0 h 89"/>
              <a:gd name="T34" fmla="*/ 35 w 89"/>
              <a:gd name="T35" fmla="*/ 1 h 89"/>
              <a:gd name="T36" fmla="*/ 27 w 89"/>
              <a:gd name="T37" fmla="*/ 4 h 89"/>
              <a:gd name="T38" fmla="*/ 20 w 89"/>
              <a:gd name="T39" fmla="*/ 8 h 89"/>
              <a:gd name="T40" fmla="*/ 14 w 89"/>
              <a:gd name="T41" fmla="*/ 14 h 89"/>
              <a:gd name="T42" fmla="*/ 8 w 89"/>
              <a:gd name="T43" fmla="*/ 20 h 89"/>
              <a:gd name="T44" fmla="*/ 4 w 89"/>
              <a:gd name="T45" fmla="*/ 27 h 89"/>
              <a:gd name="T46" fmla="*/ 1 w 89"/>
              <a:gd name="T47" fmla="*/ 35 h 89"/>
              <a:gd name="T48" fmla="*/ 0 w 89"/>
              <a:gd name="T49" fmla="*/ 45 h 89"/>
              <a:gd name="T50" fmla="*/ 1 w 89"/>
              <a:gd name="T51" fmla="*/ 53 h 89"/>
              <a:gd name="T52" fmla="*/ 4 w 89"/>
              <a:gd name="T53" fmla="*/ 61 h 89"/>
              <a:gd name="T54" fmla="*/ 8 w 89"/>
              <a:gd name="T55" fmla="*/ 70 h 89"/>
              <a:gd name="T56" fmla="*/ 14 w 89"/>
              <a:gd name="T57" fmla="*/ 76 h 89"/>
              <a:gd name="T58" fmla="*/ 20 w 89"/>
              <a:gd name="T59" fmla="*/ 82 h 89"/>
              <a:gd name="T60" fmla="*/ 27 w 89"/>
              <a:gd name="T61" fmla="*/ 86 h 89"/>
              <a:gd name="T62" fmla="*/ 35 w 89"/>
              <a:gd name="T63" fmla="*/ 89 h 89"/>
              <a:gd name="T64" fmla="*/ 45 w 89"/>
              <a:gd name="T65" fmla="*/ 89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</a:cxnLst>
            <a:rect l="0" t="0" r="r" b="b"/>
            <a:pathLst>
              <a:path w="89" h="89">
                <a:moveTo>
                  <a:pt x="45" y="89"/>
                </a:moveTo>
                <a:lnTo>
                  <a:pt x="53" y="89"/>
                </a:lnTo>
                <a:lnTo>
                  <a:pt x="61" y="86"/>
                </a:lnTo>
                <a:lnTo>
                  <a:pt x="70" y="82"/>
                </a:lnTo>
                <a:lnTo>
                  <a:pt x="76" y="76"/>
                </a:lnTo>
                <a:lnTo>
                  <a:pt x="82" y="70"/>
                </a:lnTo>
                <a:lnTo>
                  <a:pt x="86" y="61"/>
                </a:lnTo>
                <a:lnTo>
                  <a:pt x="89" y="53"/>
                </a:lnTo>
                <a:lnTo>
                  <a:pt x="89" y="45"/>
                </a:lnTo>
                <a:lnTo>
                  <a:pt x="89" y="35"/>
                </a:lnTo>
                <a:lnTo>
                  <a:pt x="86" y="27"/>
                </a:lnTo>
                <a:lnTo>
                  <a:pt x="82" y="20"/>
                </a:lnTo>
                <a:lnTo>
                  <a:pt x="76" y="14"/>
                </a:lnTo>
                <a:lnTo>
                  <a:pt x="70" y="8"/>
                </a:lnTo>
                <a:lnTo>
                  <a:pt x="61" y="4"/>
                </a:lnTo>
                <a:lnTo>
                  <a:pt x="53" y="1"/>
                </a:lnTo>
                <a:lnTo>
                  <a:pt x="45" y="0"/>
                </a:lnTo>
                <a:lnTo>
                  <a:pt x="35" y="1"/>
                </a:lnTo>
                <a:lnTo>
                  <a:pt x="27" y="4"/>
                </a:lnTo>
                <a:lnTo>
                  <a:pt x="20" y="8"/>
                </a:lnTo>
                <a:lnTo>
                  <a:pt x="14" y="14"/>
                </a:lnTo>
                <a:lnTo>
                  <a:pt x="8" y="20"/>
                </a:lnTo>
                <a:lnTo>
                  <a:pt x="4" y="27"/>
                </a:lnTo>
                <a:lnTo>
                  <a:pt x="1" y="35"/>
                </a:lnTo>
                <a:lnTo>
                  <a:pt x="0" y="45"/>
                </a:lnTo>
                <a:lnTo>
                  <a:pt x="1" y="53"/>
                </a:lnTo>
                <a:lnTo>
                  <a:pt x="4" y="61"/>
                </a:lnTo>
                <a:lnTo>
                  <a:pt x="8" y="70"/>
                </a:lnTo>
                <a:lnTo>
                  <a:pt x="14" y="76"/>
                </a:lnTo>
                <a:lnTo>
                  <a:pt x="20" y="82"/>
                </a:lnTo>
                <a:lnTo>
                  <a:pt x="27" y="86"/>
                </a:lnTo>
                <a:lnTo>
                  <a:pt x="35" y="89"/>
                </a:lnTo>
                <a:lnTo>
                  <a:pt x="45" y="89"/>
                </a:lnTo>
                <a:close/>
              </a:path>
            </a:pathLst>
          </a:custGeom>
          <a:solidFill>
            <a:srgbClr val="FFCC99"/>
          </a:solidFill>
          <a:ln w="12700" cmpd="sng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60" name="Rectangle 117">
            <a:extLst>
              <a:ext uri="{FF2B5EF4-FFF2-40B4-BE49-F238E27FC236}">
                <a16:creationId xmlns:a16="http://schemas.microsoft.com/office/drawing/2014/main" id="{F4AF7220-C3F8-401D-9F4D-5CA516F41F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7016" y="4464050"/>
            <a:ext cx="927100" cy="4508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161" name="Rectangle 119">
            <a:extLst>
              <a:ext uri="{FF2B5EF4-FFF2-40B4-BE49-F238E27FC236}">
                <a16:creationId xmlns:a16="http://schemas.microsoft.com/office/drawing/2014/main" id="{F6DE53C8-93F6-4121-8A1D-7C5699A775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1" y="5323013"/>
            <a:ext cx="1133475" cy="4508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162" name="Rectangle 147">
            <a:extLst>
              <a:ext uri="{FF2B5EF4-FFF2-40B4-BE49-F238E27FC236}">
                <a16:creationId xmlns:a16="http://schemas.microsoft.com/office/drawing/2014/main" id="{09D7E515-756A-4677-9E42-3CAACF0693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47030" y="4625975"/>
            <a:ext cx="736600" cy="27305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163" name="Rectangle 148">
            <a:extLst>
              <a:ext uri="{FF2B5EF4-FFF2-40B4-BE49-F238E27FC236}">
                <a16:creationId xmlns:a16="http://schemas.microsoft.com/office/drawing/2014/main" id="{1E95AC81-3EF5-49AA-86A3-815D2DA6E1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01993" y="4871554"/>
            <a:ext cx="620712" cy="28733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164" name="Rectangle 149">
            <a:extLst>
              <a:ext uri="{FF2B5EF4-FFF2-40B4-BE49-F238E27FC236}">
                <a16:creationId xmlns:a16="http://schemas.microsoft.com/office/drawing/2014/main" id="{119B862B-BDA8-40AE-A3C4-EA2F576C19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67190" y="5286375"/>
            <a:ext cx="647700" cy="28733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902B2A71-A114-4335-9AF2-6E11FFFE3D36}"/>
              </a:ext>
            </a:extLst>
          </p:cNvPr>
          <p:cNvSpPr/>
          <p:nvPr/>
        </p:nvSpPr>
        <p:spPr>
          <a:xfrm>
            <a:off x="-1130300" y="4638358"/>
            <a:ext cx="3273425" cy="9271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dirty="0"/>
          </a:p>
        </p:txBody>
      </p:sp>
      <p:sp>
        <p:nvSpPr>
          <p:cNvPr id="156" name="Title 1">
            <a:extLst>
              <a:ext uri="{FF2B5EF4-FFF2-40B4-BE49-F238E27FC236}">
                <a16:creationId xmlns:a16="http://schemas.microsoft.com/office/drawing/2014/main" id="{ED80BBFB-3AD9-458F-A0BD-98784FBE8CA4}"/>
              </a:ext>
            </a:extLst>
          </p:cNvPr>
          <p:cNvSpPr txBox="1">
            <a:spLocks/>
          </p:cNvSpPr>
          <p:nvPr/>
        </p:nvSpPr>
        <p:spPr>
          <a:xfrm>
            <a:off x="8997444" y="616898"/>
            <a:ext cx="3019506" cy="1438675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The motor unit and </a:t>
            </a:r>
          </a:p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the motor unit action potential (MUAP) propagation.</a:t>
            </a:r>
            <a:endParaRPr lang="sv-SE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79980E3E-2C3E-471D-B5CD-6BDF8B0D7330}"/>
              </a:ext>
            </a:extLst>
          </p:cNvPr>
          <p:cNvSpPr txBox="1"/>
          <p:nvPr/>
        </p:nvSpPr>
        <p:spPr>
          <a:xfrm>
            <a:off x="2639956" y="6554590"/>
            <a:ext cx="70756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Modified from : https://www.robertomerletti.it/en/emg/material/teaching/module5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4C2F4492-ADE6-4492-B962-B1F80ABF51C5}"/>
              </a:ext>
            </a:extLst>
          </p:cNvPr>
          <p:cNvGrpSpPr/>
          <p:nvPr/>
        </p:nvGrpSpPr>
        <p:grpSpPr>
          <a:xfrm>
            <a:off x="1048055" y="794959"/>
            <a:ext cx="3029683" cy="1976924"/>
            <a:chOff x="1684318" y="1753412"/>
            <a:chExt cx="3956968" cy="2444702"/>
          </a:xfrm>
        </p:grpSpPr>
        <p:sp>
          <p:nvSpPr>
            <p:cNvPr id="71784" name="Line 104"/>
            <p:cNvSpPr>
              <a:spLocks noChangeShapeType="1"/>
            </p:cNvSpPr>
            <p:nvPr/>
          </p:nvSpPr>
          <p:spPr bwMode="auto">
            <a:xfrm>
              <a:off x="2171666" y="2015350"/>
              <a:ext cx="3427412" cy="0"/>
            </a:xfrm>
            <a:prstGeom prst="line">
              <a:avLst/>
            </a:prstGeom>
            <a:noFill/>
            <a:ln w="19050">
              <a:solidFill>
                <a:schemeClr val="accent2">
                  <a:lumMod val="60000"/>
                  <a:lumOff val="40000"/>
                </a:schemeClr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it-IT"/>
            </a:p>
          </p:txBody>
        </p:sp>
        <p:sp>
          <p:nvSpPr>
            <p:cNvPr id="71785" name="Line 105"/>
            <p:cNvSpPr>
              <a:spLocks noChangeShapeType="1"/>
            </p:cNvSpPr>
            <p:nvPr/>
          </p:nvSpPr>
          <p:spPr bwMode="auto">
            <a:xfrm>
              <a:off x="2171666" y="3082150"/>
              <a:ext cx="342741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it-IT"/>
            </a:p>
          </p:txBody>
        </p:sp>
        <p:sp>
          <p:nvSpPr>
            <p:cNvPr id="71786" name="Freeform 106"/>
            <p:cNvSpPr>
              <a:spLocks/>
            </p:cNvSpPr>
            <p:nvPr/>
          </p:nvSpPr>
          <p:spPr bwMode="auto">
            <a:xfrm>
              <a:off x="2171666" y="1774050"/>
              <a:ext cx="2674937" cy="1511300"/>
            </a:xfrm>
            <a:custGeom>
              <a:avLst/>
              <a:gdLst>
                <a:gd name="T0" fmla="*/ 0 w 1536"/>
                <a:gd name="T1" fmla="*/ 824 h 952"/>
                <a:gd name="T2" fmla="*/ 192 w 1536"/>
                <a:gd name="T3" fmla="*/ 776 h 952"/>
                <a:gd name="T4" fmla="*/ 288 w 1536"/>
                <a:gd name="T5" fmla="*/ 632 h 952"/>
                <a:gd name="T6" fmla="*/ 336 w 1536"/>
                <a:gd name="T7" fmla="*/ 200 h 952"/>
                <a:gd name="T8" fmla="*/ 384 w 1536"/>
                <a:gd name="T9" fmla="*/ 8 h 952"/>
                <a:gd name="T10" fmla="*/ 480 w 1536"/>
                <a:gd name="T11" fmla="*/ 248 h 952"/>
                <a:gd name="T12" fmla="*/ 576 w 1536"/>
                <a:gd name="T13" fmla="*/ 680 h 952"/>
                <a:gd name="T14" fmla="*/ 720 w 1536"/>
                <a:gd name="T15" fmla="*/ 920 h 952"/>
                <a:gd name="T16" fmla="*/ 1152 w 1536"/>
                <a:gd name="T17" fmla="*/ 872 h 952"/>
                <a:gd name="T18" fmla="*/ 1536 w 1536"/>
                <a:gd name="T19" fmla="*/ 824 h 9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536" h="952">
                  <a:moveTo>
                    <a:pt x="0" y="824"/>
                  </a:moveTo>
                  <a:cubicBezTo>
                    <a:pt x="72" y="816"/>
                    <a:pt x="144" y="808"/>
                    <a:pt x="192" y="776"/>
                  </a:cubicBezTo>
                  <a:cubicBezTo>
                    <a:pt x="240" y="744"/>
                    <a:pt x="264" y="728"/>
                    <a:pt x="288" y="632"/>
                  </a:cubicBezTo>
                  <a:cubicBezTo>
                    <a:pt x="312" y="536"/>
                    <a:pt x="320" y="304"/>
                    <a:pt x="336" y="200"/>
                  </a:cubicBezTo>
                  <a:cubicBezTo>
                    <a:pt x="352" y="96"/>
                    <a:pt x="360" y="0"/>
                    <a:pt x="384" y="8"/>
                  </a:cubicBezTo>
                  <a:cubicBezTo>
                    <a:pt x="408" y="16"/>
                    <a:pt x="448" y="136"/>
                    <a:pt x="480" y="248"/>
                  </a:cubicBezTo>
                  <a:cubicBezTo>
                    <a:pt x="512" y="360"/>
                    <a:pt x="536" y="568"/>
                    <a:pt x="576" y="680"/>
                  </a:cubicBezTo>
                  <a:cubicBezTo>
                    <a:pt x="616" y="792"/>
                    <a:pt x="624" y="888"/>
                    <a:pt x="720" y="920"/>
                  </a:cubicBezTo>
                  <a:cubicBezTo>
                    <a:pt x="816" y="952"/>
                    <a:pt x="1016" y="888"/>
                    <a:pt x="1152" y="872"/>
                  </a:cubicBezTo>
                  <a:cubicBezTo>
                    <a:pt x="1288" y="856"/>
                    <a:pt x="1472" y="832"/>
                    <a:pt x="1536" y="824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it-IT"/>
            </a:p>
          </p:txBody>
        </p:sp>
        <p:sp>
          <p:nvSpPr>
            <p:cNvPr id="71787" name="Text Box 107"/>
            <p:cNvSpPr txBox="1">
              <a:spLocks noChangeArrowheads="1"/>
            </p:cNvSpPr>
            <p:nvPr/>
          </p:nvSpPr>
          <p:spPr bwMode="auto">
            <a:xfrm>
              <a:off x="1903378" y="1815325"/>
              <a:ext cx="282575" cy="30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altLang="en-US" sz="1400" b="1"/>
                <a:t>0</a:t>
              </a:r>
            </a:p>
          </p:txBody>
        </p:sp>
        <p:sp>
          <p:nvSpPr>
            <p:cNvPr id="71788" name="Text Box 108"/>
            <p:cNvSpPr txBox="1">
              <a:spLocks noChangeArrowheads="1"/>
            </p:cNvSpPr>
            <p:nvPr/>
          </p:nvSpPr>
          <p:spPr bwMode="auto">
            <a:xfrm>
              <a:off x="1693828" y="2993250"/>
              <a:ext cx="461986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altLang="en-US" sz="1400" b="1"/>
                <a:t>- 70</a:t>
              </a:r>
            </a:p>
          </p:txBody>
        </p:sp>
        <p:sp>
          <p:nvSpPr>
            <p:cNvPr id="71789" name="Text Box 109"/>
            <p:cNvSpPr txBox="1">
              <a:spLocks noChangeArrowheads="1"/>
            </p:cNvSpPr>
            <p:nvPr/>
          </p:nvSpPr>
          <p:spPr bwMode="auto">
            <a:xfrm>
              <a:off x="3704883" y="2039556"/>
              <a:ext cx="1936403" cy="1027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 eaLnBrk="0" hangingPunct="0"/>
              <a:r>
                <a:rPr lang="en-US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ransmembrane action potential of a single </a:t>
              </a:r>
              <a:r>
                <a:rPr lang="en-US" alt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ibe</a:t>
              </a:r>
              <a:endPara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0" hangingPunct="0"/>
              <a:r>
                <a:rPr lang="en-US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90-100 </a:t>
              </a:r>
              <a:r>
                <a:rPr lang="en-US" alt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V</a:t>
              </a:r>
              <a:r>
                <a:rPr lang="en-US" alt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p</a:t>
              </a:r>
              <a:r>
                <a:rPr lang="en-US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71790" name="Text Box 110"/>
            <p:cNvSpPr txBox="1">
              <a:spLocks noChangeArrowheads="1"/>
            </p:cNvSpPr>
            <p:nvPr/>
          </p:nvSpPr>
          <p:spPr bwMode="auto">
            <a:xfrm rot="16245353">
              <a:off x="1366460" y="2221811"/>
              <a:ext cx="997495" cy="36177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alt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alt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alt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mV)</a:t>
              </a:r>
              <a:r>
                <a:rPr lang="en-US" alt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71791" name="Line 111"/>
            <p:cNvSpPr>
              <a:spLocks noChangeShapeType="1"/>
            </p:cNvSpPr>
            <p:nvPr/>
          </p:nvSpPr>
          <p:spPr bwMode="auto">
            <a:xfrm flipH="1">
              <a:off x="3189107" y="2255064"/>
              <a:ext cx="501183" cy="21748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it-IT"/>
            </a:p>
          </p:txBody>
        </p:sp>
        <p:sp>
          <p:nvSpPr>
            <p:cNvPr id="71792" name="Line 112"/>
            <p:cNvSpPr>
              <a:spLocks noChangeShapeType="1"/>
            </p:cNvSpPr>
            <p:nvPr/>
          </p:nvSpPr>
          <p:spPr bwMode="auto">
            <a:xfrm>
              <a:off x="4468778" y="3382187"/>
              <a:ext cx="952500" cy="0"/>
            </a:xfrm>
            <a:prstGeom prst="line">
              <a:avLst/>
            </a:prstGeom>
            <a:noFill/>
            <a:ln w="38100">
              <a:solidFill>
                <a:schemeClr val="bg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it-IT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793" name="Text Box 113"/>
            <p:cNvSpPr txBox="1">
              <a:spLocks noChangeArrowheads="1"/>
            </p:cNvSpPr>
            <p:nvPr/>
          </p:nvSpPr>
          <p:spPr bwMode="auto">
            <a:xfrm>
              <a:off x="4026926" y="3556817"/>
              <a:ext cx="1197765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folHlink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folHlink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>
              <a:spAutoFit/>
            </a:bodyPr>
            <a:lstStyle/>
            <a:p>
              <a:pPr algn="ctr" eaLnBrk="0" hangingPunct="0"/>
              <a:r>
                <a:rPr lang="it-IT" altLang="en-US" sz="1400" b="1" dirty="0"/>
                <a:t>1 ms or 4 mm</a:t>
              </a:r>
              <a:endParaRPr lang="it-IT" altLang="en-US" sz="2400" dirty="0">
                <a:latin typeface="Times New Roman" pitchFamily="18" charset="0"/>
              </a:endParaRPr>
            </a:p>
          </p:txBody>
        </p:sp>
        <p:sp>
          <p:nvSpPr>
            <p:cNvPr id="71794" name="Line 114"/>
            <p:cNvSpPr>
              <a:spLocks noChangeShapeType="1"/>
            </p:cNvSpPr>
            <p:nvPr/>
          </p:nvSpPr>
          <p:spPr bwMode="auto">
            <a:xfrm>
              <a:off x="2171666" y="1753412"/>
              <a:ext cx="0" cy="1498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it-IT"/>
            </a:p>
          </p:txBody>
        </p:sp>
        <p:sp>
          <p:nvSpPr>
            <p:cNvPr id="71800" name="Rectangle 120"/>
            <p:cNvSpPr>
              <a:spLocks noChangeArrowheads="1"/>
            </p:cNvSpPr>
            <p:nvPr/>
          </p:nvSpPr>
          <p:spPr bwMode="auto">
            <a:xfrm>
              <a:off x="2354229" y="3471087"/>
              <a:ext cx="1035050" cy="134937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it-IT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903878" y="3627210"/>
              <a:ext cx="2052174" cy="5709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epolarized region</a:t>
              </a:r>
              <a:b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moving source)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B2A94A25-B56F-470D-8D5A-E0AABE74279B}"/>
                </a:ext>
              </a:extLst>
            </p:cNvPr>
            <p:cNvCxnSpPr>
              <a:cxnSpLocks/>
            </p:cNvCxnSpPr>
            <p:nvPr/>
          </p:nvCxnSpPr>
          <p:spPr>
            <a:xfrm rot="-60000" flipH="1" flipV="1">
              <a:off x="4176610" y="3511332"/>
              <a:ext cx="870158" cy="1627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D85E22A8-4166-4B73-98AA-6CF70FB39EF4}"/>
                </a:ext>
              </a:extLst>
            </p:cNvPr>
            <p:cNvCxnSpPr>
              <a:cxnSpLocks/>
            </p:cNvCxnSpPr>
            <p:nvPr/>
          </p:nvCxnSpPr>
          <p:spPr>
            <a:xfrm rot="180000">
              <a:off x="4190139" y="3451164"/>
              <a:ext cx="0" cy="11684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338A0072-2084-4C06-9CA9-44F996A24AC2}"/>
                </a:ext>
              </a:extLst>
            </p:cNvPr>
            <p:cNvCxnSpPr>
              <a:cxnSpLocks/>
            </p:cNvCxnSpPr>
            <p:nvPr/>
          </p:nvCxnSpPr>
          <p:spPr>
            <a:xfrm rot="180000">
              <a:off x="5033108" y="3455923"/>
              <a:ext cx="0" cy="11684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0170EB1C-2863-480A-A833-656022062557}"/>
              </a:ext>
            </a:extLst>
          </p:cNvPr>
          <p:cNvGrpSpPr/>
          <p:nvPr/>
        </p:nvGrpSpPr>
        <p:grpSpPr>
          <a:xfrm>
            <a:off x="1233843" y="2989336"/>
            <a:ext cx="4781771" cy="1583435"/>
            <a:chOff x="1236481" y="3087795"/>
            <a:chExt cx="4781771" cy="1583435"/>
          </a:xfrm>
        </p:grpSpPr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7929A921-D1EB-469A-92DF-D593CB26F6C2}"/>
                </a:ext>
              </a:extLst>
            </p:cNvPr>
            <p:cNvGrpSpPr/>
            <p:nvPr/>
          </p:nvGrpSpPr>
          <p:grpSpPr>
            <a:xfrm flipH="1">
              <a:off x="2793066" y="3087795"/>
              <a:ext cx="3009431" cy="1103980"/>
              <a:chOff x="7604125" y="2278344"/>
              <a:chExt cx="3128981" cy="1189876"/>
            </a:xfrm>
          </p:grpSpPr>
          <p:pic>
            <p:nvPicPr>
              <p:cNvPr id="182" name="Picture 5">
                <a:extLst>
                  <a:ext uri="{FF2B5EF4-FFF2-40B4-BE49-F238E27FC236}">
                    <a16:creationId xmlns:a16="http://schemas.microsoft.com/office/drawing/2014/main" id="{9C93ECA8-1F48-431A-A075-5A12A2D09CA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>
                <a:lum bright="-28000" contrast="48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97" t="4918" r="15296" b="74483"/>
              <a:stretch/>
            </p:blipFill>
            <p:spPr bwMode="auto">
              <a:xfrm>
                <a:off x="7604125" y="2278344"/>
                <a:ext cx="3128981" cy="11898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83" name="Oval 182">
                <a:extLst>
                  <a:ext uri="{FF2B5EF4-FFF2-40B4-BE49-F238E27FC236}">
                    <a16:creationId xmlns:a16="http://schemas.microsoft.com/office/drawing/2014/main" id="{EFA223E1-F08E-4C27-8E27-01AA7ED84CDF}"/>
                  </a:ext>
                </a:extLst>
              </p:cNvPr>
              <p:cNvSpPr/>
              <p:nvPr/>
            </p:nvSpPr>
            <p:spPr>
              <a:xfrm>
                <a:off x="10656321" y="2341042"/>
                <a:ext cx="62608" cy="63873"/>
              </a:xfrm>
              <a:prstGeom prst="ellipse">
                <a:avLst/>
              </a:prstGeom>
              <a:noFill/>
              <a:ln w="9525">
                <a:solidFill>
                  <a:srgbClr val="0066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</p:grp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EA918D66-DEC6-4930-9EF0-6A8E796431EF}"/>
                </a:ext>
              </a:extLst>
            </p:cNvPr>
            <p:cNvSpPr txBox="1"/>
            <p:nvPr/>
          </p:nvSpPr>
          <p:spPr>
            <a:xfrm>
              <a:off x="1982045" y="4148010"/>
              <a:ext cx="403620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Instantaneous distribution of voltage on the skin moving left under the fixed electrode grid.</a:t>
              </a:r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0E5D17CA-51AB-4828-A4CD-AB17E80F8933}"/>
                </a:ext>
              </a:extLst>
            </p:cNvPr>
            <p:cNvSpPr/>
            <p:nvPr/>
          </p:nvSpPr>
          <p:spPr>
            <a:xfrm>
              <a:off x="1240976" y="3355794"/>
              <a:ext cx="106096" cy="111308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7" name="Oval 186">
              <a:extLst>
                <a:ext uri="{FF2B5EF4-FFF2-40B4-BE49-F238E27FC236}">
                  <a16:creationId xmlns:a16="http://schemas.microsoft.com/office/drawing/2014/main" id="{E4C5D4CA-5696-46AC-9AEC-8B16B5DDD68F}"/>
                </a:ext>
              </a:extLst>
            </p:cNvPr>
            <p:cNvSpPr/>
            <p:nvPr/>
          </p:nvSpPr>
          <p:spPr>
            <a:xfrm>
              <a:off x="1240976" y="3679996"/>
              <a:ext cx="106096" cy="111308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F2D4A91-79AE-47B8-96F0-BD05C2F65BEC}"/>
                </a:ext>
              </a:extLst>
            </p:cNvPr>
            <p:cNvSpPr txBox="1"/>
            <p:nvPr/>
          </p:nvSpPr>
          <p:spPr>
            <a:xfrm>
              <a:off x="1377813" y="3267976"/>
              <a:ext cx="1457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negative voltage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419932C0-DAD7-4040-98DA-4CB5CBCBAA73}"/>
                </a:ext>
              </a:extLst>
            </p:cNvPr>
            <p:cNvSpPr txBox="1"/>
            <p:nvPr/>
          </p:nvSpPr>
          <p:spPr>
            <a:xfrm>
              <a:off x="1368924" y="3594460"/>
              <a:ext cx="1457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positive voltage</a:t>
              </a:r>
            </a:p>
          </p:txBody>
        </p:sp>
        <p:sp>
          <p:nvSpPr>
            <p:cNvPr id="190" name="Oval 189">
              <a:extLst>
                <a:ext uri="{FF2B5EF4-FFF2-40B4-BE49-F238E27FC236}">
                  <a16:creationId xmlns:a16="http://schemas.microsoft.com/office/drawing/2014/main" id="{F614D0DA-1F68-4F57-9684-547969390E9F}"/>
                </a:ext>
              </a:extLst>
            </p:cNvPr>
            <p:cNvSpPr/>
            <p:nvPr/>
          </p:nvSpPr>
          <p:spPr>
            <a:xfrm>
              <a:off x="1236481" y="4013860"/>
              <a:ext cx="106096" cy="111308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46C07E4A-EF22-4A2E-91D0-F522A466DADD}"/>
                </a:ext>
              </a:extLst>
            </p:cNvPr>
            <p:cNvSpPr txBox="1"/>
            <p:nvPr/>
          </p:nvSpPr>
          <p:spPr>
            <a:xfrm>
              <a:off x="1385194" y="3926742"/>
              <a:ext cx="1457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electrode</a:t>
              </a:r>
            </a:p>
          </p:txBody>
        </p:sp>
      </p:grpSp>
      <p:sp>
        <p:nvSpPr>
          <p:cNvPr id="165" name="Rectangle 164">
            <a:extLst>
              <a:ext uri="{FF2B5EF4-FFF2-40B4-BE49-F238E27FC236}">
                <a16:creationId xmlns:a16="http://schemas.microsoft.com/office/drawing/2014/main" id="{F5B54547-BEAB-4DF5-BF78-EEC5F1F8B54B}"/>
              </a:ext>
            </a:extLst>
          </p:cNvPr>
          <p:cNvSpPr/>
          <p:nvPr/>
        </p:nvSpPr>
        <p:spPr>
          <a:xfrm>
            <a:off x="10116202" y="4596039"/>
            <a:ext cx="3273425" cy="11239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4B12AE12-2018-499C-AFE1-49AB810CDB0D}"/>
              </a:ext>
            </a:extLst>
          </p:cNvPr>
          <p:cNvGrpSpPr/>
          <p:nvPr/>
        </p:nvGrpSpPr>
        <p:grpSpPr>
          <a:xfrm>
            <a:off x="7662061" y="2232024"/>
            <a:ext cx="4025766" cy="2375917"/>
            <a:chOff x="7662061" y="2232024"/>
            <a:chExt cx="4025766" cy="2375917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D299F853-2B4F-47CB-9192-A052876CF989}"/>
                </a:ext>
              </a:extLst>
            </p:cNvPr>
            <p:cNvGrpSpPr/>
            <p:nvPr/>
          </p:nvGrpSpPr>
          <p:grpSpPr>
            <a:xfrm>
              <a:off x="7662061" y="3064554"/>
              <a:ext cx="4025766" cy="1543387"/>
              <a:chOff x="7651834" y="3120699"/>
              <a:chExt cx="4012332" cy="1582316"/>
            </a:xfrm>
          </p:grpSpPr>
          <p:sp>
            <p:nvSpPr>
              <p:cNvPr id="71804" name="Line 124"/>
              <p:cNvSpPr>
                <a:spLocks noChangeShapeType="1"/>
              </p:cNvSpPr>
              <p:nvPr/>
            </p:nvSpPr>
            <p:spPr bwMode="auto">
              <a:xfrm>
                <a:off x="8840788" y="4103688"/>
                <a:ext cx="0" cy="450850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674755BB-8635-4B2D-BCED-424C4A733CF7}"/>
                  </a:ext>
                </a:extLst>
              </p:cNvPr>
              <p:cNvGrpSpPr/>
              <p:nvPr/>
            </p:nvGrpSpPr>
            <p:grpSpPr>
              <a:xfrm>
                <a:off x="7789476" y="3120699"/>
                <a:ext cx="3009431" cy="1103980"/>
                <a:chOff x="7604125" y="2278344"/>
                <a:chExt cx="3128981" cy="1189876"/>
              </a:xfrm>
            </p:grpSpPr>
            <p:pic>
              <p:nvPicPr>
                <p:cNvPr id="171" name="Picture 5">
                  <a:extLst>
                    <a:ext uri="{FF2B5EF4-FFF2-40B4-BE49-F238E27FC236}">
                      <a16:creationId xmlns:a16="http://schemas.microsoft.com/office/drawing/2014/main" id="{15503E26-E179-41F6-91C9-6093A8355D31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lum bright="-28000" contrast="48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197" t="4918" r="15296" b="74483"/>
                <a:stretch/>
              </p:blipFill>
              <p:spPr bwMode="auto">
                <a:xfrm>
                  <a:off x="7604125" y="2278344"/>
                  <a:ext cx="3128981" cy="118987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72" name="Oval 171">
                  <a:extLst>
                    <a:ext uri="{FF2B5EF4-FFF2-40B4-BE49-F238E27FC236}">
                      <a16:creationId xmlns:a16="http://schemas.microsoft.com/office/drawing/2014/main" id="{9DC518F9-4988-4D1B-9BE7-2BEB49978D1D}"/>
                    </a:ext>
                  </a:extLst>
                </p:cNvPr>
                <p:cNvSpPr/>
                <p:nvPr/>
              </p:nvSpPr>
              <p:spPr>
                <a:xfrm>
                  <a:off x="10656321" y="2341042"/>
                  <a:ext cx="62608" cy="63873"/>
                </a:xfrm>
                <a:prstGeom prst="ellipse">
                  <a:avLst/>
                </a:prstGeom>
                <a:noFill/>
                <a:ln w="9525">
                  <a:solidFill>
                    <a:srgbClr val="0066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</p:grp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9201FC9-1C15-4804-9D12-F5A1AA39228C}"/>
                  </a:ext>
                </a:extLst>
              </p:cNvPr>
              <p:cNvSpPr txBox="1"/>
              <p:nvPr/>
            </p:nvSpPr>
            <p:spPr>
              <a:xfrm>
                <a:off x="7651834" y="4166598"/>
                <a:ext cx="4012332" cy="5364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nstantaneous distribution of voltage on the skin moving right under the fixed electrode grid.</a:t>
                </a: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D768793-DF26-4E65-A347-750FB99360F7}"/>
                </a:ext>
              </a:extLst>
            </p:cNvPr>
            <p:cNvSpPr txBox="1"/>
            <p:nvPr/>
          </p:nvSpPr>
          <p:spPr>
            <a:xfrm>
              <a:off x="7837114" y="2232024"/>
              <a:ext cx="320434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MUAP in space and electrode grid:</a:t>
              </a:r>
            </a:p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Interelectrode distance = 8 mm</a:t>
              </a:r>
            </a:p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Electrode diameter = 3 mm</a:t>
              </a: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C529914A-3958-4901-9732-CA6744714358}"/>
              </a:ext>
            </a:extLst>
          </p:cNvPr>
          <p:cNvSpPr txBox="1"/>
          <p:nvPr/>
        </p:nvSpPr>
        <p:spPr>
          <a:xfrm>
            <a:off x="1155928" y="252580"/>
            <a:ext cx="32330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en-GB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iber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 action potential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0E6C528E-377B-4CC2-ADD5-0E52ECB9FB3D}"/>
              </a:ext>
            </a:extLst>
          </p:cNvPr>
          <p:cNvSpPr txBox="1"/>
          <p:nvPr/>
        </p:nvSpPr>
        <p:spPr>
          <a:xfrm>
            <a:off x="11089537" y="6339146"/>
            <a:ext cx="1153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. 2</a:t>
            </a:r>
          </a:p>
        </p:txBody>
      </p:sp>
      <p:sp>
        <p:nvSpPr>
          <p:cNvPr id="175" name="Freeform 84">
            <a:extLst>
              <a:ext uri="{FF2B5EF4-FFF2-40B4-BE49-F238E27FC236}">
                <a16:creationId xmlns:a16="http://schemas.microsoft.com/office/drawing/2014/main" id="{07F9D677-17EF-4251-8ECB-F75FB6C918E8}"/>
              </a:ext>
            </a:extLst>
          </p:cNvPr>
          <p:cNvSpPr>
            <a:spLocks/>
          </p:cNvSpPr>
          <p:nvPr/>
        </p:nvSpPr>
        <p:spPr bwMode="auto">
          <a:xfrm>
            <a:off x="1155928" y="5717419"/>
            <a:ext cx="371475" cy="90487"/>
          </a:xfrm>
          <a:custGeom>
            <a:avLst/>
            <a:gdLst>
              <a:gd name="T0" fmla="*/ 89 w 178"/>
              <a:gd name="T1" fmla="*/ 66 h 66"/>
              <a:gd name="T2" fmla="*/ 107 w 178"/>
              <a:gd name="T3" fmla="*/ 65 h 66"/>
              <a:gd name="T4" fmla="*/ 123 w 178"/>
              <a:gd name="T5" fmla="*/ 64 h 66"/>
              <a:gd name="T6" fmla="*/ 138 w 178"/>
              <a:gd name="T7" fmla="*/ 60 h 66"/>
              <a:gd name="T8" fmla="*/ 152 w 178"/>
              <a:gd name="T9" fmla="*/ 55 h 66"/>
              <a:gd name="T10" fmla="*/ 163 w 178"/>
              <a:gd name="T11" fmla="*/ 51 h 66"/>
              <a:gd name="T12" fmla="*/ 171 w 178"/>
              <a:gd name="T13" fmla="*/ 46 h 66"/>
              <a:gd name="T14" fmla="*/ 174 w 178"/>
              <a:gd name="T15" fmla="*/ 43 h 66"/>
              <a:gd name="T16" fmla="*/ 176 w 178"/>
              <a:gd name="T17" fmla="*/ 39 h 66"/>
              <a:gd name="T18" fmla="*/ 178 w 178"/>
              <a:gd name="T19" fmla="*/ 36 h 66"/>
              <a:gd name="T20" fmla="*/ 178 w 178"/>
              <a:gd name="T21" fmla="*/ 32 h 66"/>
              <a:gd name="T22" fmla="*/ 178 w 178"/>
              <a:gd name="T23" fmla="*/ 30 h 66"/>
              <a:gd name="T24" fmla="*/ 176 w 178"/>
              <a:gd name="T25" fmla="*/ 25 h 66"/>
              <a:gd name="T26" fmla="*/ 174 w 178"/>
              <a:gd name="T27" fmla="*/ 23 h 66"/>
              <a:gd name="T28" fmla="*/ 171 w 178"/>
              <a:gd name="T29" fmla="*/ 20 h 66"/>
              <a:gd name="T30" fmla="*/ 163 w 178"/>
              <a:gd name="T31" fmla="*/ 15 h 66"/>
              <a:gd name="T32" fmla="*/ 152 w 178"/>
              <a:gd name="T33" fmla="*/ 9 h 66"/>
              <a:gd name="T34" fmla="*/ 138 w 178"/>
              <a:gd name="T35" fmla="*/ 5 h 66"/>
              <a:gd name="T36" fmla="*/ 123 w 178"/>
              <a:gd name="T37" fmla="*/ 2 h 66"/>
              <a:gd name="T38" fmla="*/ 107 w 178"/>
              <a:gd name="T39" fmla="*/ 1 h 66"/>
              <a:gd name="T40" fmla="*/ 89 w 178"/>
              <a:gd name="T41" fmla="*/ 0 h 66"/>
              <a:gd name="T42" fmla="*/ 71 w 178"/>
              <a:gd name="T43" fmla="*/ 1 h 66"/>
              <a:gd name="T44" fmla="*/ 55 w 178"/>
              <a:gd name="T45" fmla="*/ 2 h 66"/>
              <a:gd name="T46" fmla="*/ 40 w 178"/>
              <a:gd name="T47" fmla="*/ 5 h 66"/>
              <a:gd name="T48" fmla="*/ 26 w 178"/>
              <a:gd name="T49" fmla="*/ 9 h 66"/>
              <a:gd name="T50" fmla="*/ 15 w 178"/>
              <a:gd name="T51" fmla="*/ 15 h 66"/>
              <a:gd name="T52" fmla="*/ 7 w 178"/>
              <a:gd name="T53" fmla="*/ 20 h 66"/>
              <a:gd name="T54" fmla="*/ 5 w 178"/>
              <a:gd name="T55" fmla="*/ 23 h 66"/>
              <a:gd name="T56" fmla="*/ 3 w 178"/>
              <a:gd name="T57" fmla="*/ 25 h 66"/>
              <a:gd name="T58" fmla="*/ 2 w 178"/>
              <a:gd name="T59" fmla="*/ 30 h 66"/>
              <a:gd name="T60" fmla="*/ 0 w 178"/>
              <a:gd name="T61" fmla="*/ 32 h 66"/>
              <a:gd name="T62" fmla="*/ 2 w 178"/>
              <a:gd name="T63" fmla="*/ 36 h 66"/>
              <a:gd name="T64" fmla="*/ 3 w 178"/>
              <a:gd name="T65" fmla="*/ 39 h 66"/>
              <a:gd name="T66" fmla="*/ 5 w 178"/>
              <a:gd name="T67" fmla="*/ 43 h 66"/>
              <a:gd name="T68" fmla="*/ 7 w 178"/>
              <a:gd name="T69" fmla="*/ 46 h 66"/>
              <a:gd name="T70" fmla="*/ 15 w 178"/>
              <a:gd name="T71" fmla="*/ 51 h 66"/>
              <a:gd name="T72" fmla="*/ 26 w 178"/>
              <a:gd name="T73" fmla="*/ 55 h 66"/>
              <a:gd name="T74" fmla="*/ 40 w 178"/>
              <a:gd name="T75" fmla="*/ 60 h 66"/>
              <a:gd name="T76" fmla="*/ 55 w 178"/>
              <a:gd name="T77" fmla="*/ 64 h 66"/>
              <a:gd name="T78" fmla="*/ 71 w 178"/>
              <a:gd name="T79" fmla="*/ 65 h 66"/>
              <a:gd name="T80" fmla="*/ 89 w 178"/>
              <a:gd name="T81" fmla="*/ 66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78" h="66">
                <a:moveTo>
                  <a:pt x="89" y="66"/>
                </a:moveTo>
                <a:lnTo>
                  <a:pt x="107" y="65"/>
                </a:lnTo>
                <a:lnTo>
                  <a:pt x="123" y="64"/>
                </a:lnTo>
                <a:lnTo>
                  <a:pt x="138" y="60"/>
                </a:lnTo>
                <a:lnTo>
                  <a:pt x="152" y="55"/>
                </a:lnTo>
                <a:lnTo>
                  <a:pt x="163" y="51"/>
                </a:lnTo>
                <a:lnTo>
                  <a:pt x="171" y="46"/>
                </a:lnTo>
                <a:lnTo>
                  <a:pt x="174" y="43"/>
                </a:lnTo>
                <a:lnTo>
                  <a:pt x="176" y="39"/>
                </a:lnTo>
                <a:lnTo>
                  <a:pt x="178" y="36"/>
                </a:lnTo>
                <a:lnTo>
                  <a:pt x="178" y="32"/>
                </a:lnTo>
                <a:lnTo>
                  <a:pt x="178" y="30"/>
                </a:lnTo>
                <a:lnTo>
                  <a:pt x="176" y="25"/>
                </a:lnTo>
                <a:lnTo>
                  <a:pt x="174" y="23"/>
                </a:lnTo>
                <a:lnTo>
                  <a:pt x="171" y="20"/>
                </a:lnTo>
                <a:lnTo>
                  <a:pt x="163" y="15"/>
                </a:lnTo>
                <a:lnTo>
                  <a:pt x="152" y="9"/>
                </a:lnTo>
                <a:lnTo>
                  <a:pt x="138" y="5"/>
                </a:lnTo>
                <a:lnTo>
                  <a:pt x="123" y="2"/>
                </a:lnTo>
                <a:lnTo>
                  <a:pt x="107" y="1"/>
                </a:lnTo>
                <a:lnTo>
                  <a:pt x="89" y="0"/>
                </a:lnTo>
                <a:lnTo>
                  <a:pt x="71" y="1"/>
                </a:lnTo>
                <a:lnTo>
                  <a:pt x="55" y="2"/>
                </a:lnTo>
                <a:lnTo>
                  <a:pt x="40" y="5"/>
                </a:lnTo>
                <a:lnTo>
                  <a:pt x="26" y="9"/>
                </a:lnTo>
                <a:lnTo>
                  <a:pt x="15" y="15"/>
                </a:lnTo>
                <a:lnTo>
                  <a:pt x="7" y="20"/>
                </a:lnTo>
                <a:lnTo>
                  <a:pt x="5" y="23"/>
                </a:lnTo>
                <a:lnTo>
                  <a:pt x="3" y="25"/>
                </a:lnTo>
                <a:lnTo>
                  <a:pt x="2" y="30"/>
                </a:lnTo>
                <a:lnTo>
                  <a:pt x="0" y="32"/>
                </a:lnTo>
                <a:lnTo>
                  <a:pt x="2" y="36"/>
                </a:lnTo>
                <a:lnTo>
                  <a:pt x="3" y="39"/>
                </a:lnTo>
                <a:lnTo>
                  <a:pt x="5" y="43"/>
                </a:lnTo>
                <a:lnTo>
                  <a:pt x="7" y="46"/>
                </a:lnTo>
                <a:lnTo>
                  <a:pt x="15" y="51"/>
                </a:lnTo>
                <a:lnTo>
                  <a:pt x="26" y="55"/>
                </a:lnTo>
                <a:lnTo>
                  <a:pt x="40" y="60"/>
                </a:lnTo>
                <a:lnTo>
                  <a:pt x="55" y="64"/>
                </a:lnTo>
                <a:lnTo>
                  <a:pt x="71" y="65"/>
                </a:lnTo>
                <a:lnTo>
                  <a:pt x="89" y="66"/>
                </a:lnTo>
                <a:close/>
              </a:path>
            </a:pathLst>
          </a:custGeom>
          <a:solidFill>
            <a:srgbClr val="FF993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815B2E8-7F28-4E15-84BA-32A0C4B6E4B0}"/>
              </a:ext>
            </a:extLst>
          </p:cNvPr>
          <p:cNvSpPr txBox="1"/>
          <p:nvPr/>
        </p:nvSpPr>
        <p:spPr>
          <a:xfrm>
            <a:off x="1573020" y="5543536"/>
            <a:ext cx="246960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Neuromuscular junction (end-plate)</a:t>
            </a:r>
          </a:p>
        </p:txBody>
      </p:sp>
    </p:spTree>
    <p:extLst>
      <p:ext uri="{BB962C8B-B14F-4D97-AF65-F5344CB8AC3E}">
        <p14:creationId xmlns:p14="http://schemas.microsoft.com/office/powerpoint/2010/main" val="15256587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0" presetClass="path" presetSubtype="0" accel="50000" decel="5000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2.29167E-6 2.22222E-6 C -0.00469 0.00509 -0.00911 0.01018 -0.01784 0.02222 C -0.02643 0.03426 -0.04127 0.05532 -0.05182 0.07245 C -0.06237 0.08935 -0.07487 0.09815 -0.08138 0.1243 C -0.08815 0.15069 -0.09127 0.20162 -0.0914 0.23032 C -0.09153 0.25879 -0.08476 0.27916 -0.08268 0.29537 C -0.08047 0.31134 -0.07721 0.31759 -0.07812 0.32685 C -0.07929 0.33611 -0.0858 0.33819 -0.08919 0.35116 C -0.09258 0.36389 -0.09987 0.3875 -0.09909 0.40301 C -0.0983 0.41875 -0.08815 0.43541 -0.08476 0.44398 C -0.08138 0.45254 -0.07929 0.44838 -0.07929 0.45509 C -0.07929 0.4618 -0.08385 0.47986 -0.08476 0.48495 " pathEditMode="relative" rAng="0" ptsTypes="AAAAAAAAAAAA">
                                      <p:cBhvr>
                                        <p:cTn id="6" dur="2000" fill="hold"/>
                                        <p:tgtEl>
                                          <p:spTgt spid="7182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4961" y="24236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0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1094 -7.40741E-7 C -0.00052 0.01111 -0.01185 0.02222 -0.02513 0.03704 C -0.03854 0.05185 -0.05768 0.07222 -0.06966 0.08889 C -0.08164 0.10556 -0.09206 0.11482 -0.0974 0.13704 C -0.10273 0.15926 -0.10169 0.19838 -0.10156 0.22222 C -0.10143 0.24607 -0.09896 0.26366 -0.09596 0.27963 C -0.0931 0.2956 -0.08711 0.30463 -0.08346 0.31852 C -0.07982 0.33241 -0.07878 0.34653 -0.07383 0.36296 C -0.06875 0.3794 -0.05846 0.39907 -0.053 0.41667 C -0.0474 0.43426 -0.04232 0.44838 -0.0405 0.46852 C -0.03854 0.48866 -0.04115 0.52593 -0.0418 0.53704 " pathEditMode="relative" rAng="0" ptsTypes="AAAAAAAAAAA">
                                      <p:cBhvr>
                                        <p:cTn id="8" dur="2000" fill="hold"/>
                                        <p:tgtEl>
                                          <p:spTgt spid="7182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638" y="26852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0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2.91667E-6 -1.85185E-6 C -0.00794 0.01042 -0.01575 0.02107 -0.02721 0.03704 C -0.03854 0.05301 -0.05846 0.0794 -0.06797 0.0963 C -0.07734 0.1132 -0.08034 0.11921 -0.08372 0.13889 C -0.08711 0.15857 -0.08919 0.1882 -0.08841 0.21482 C -0.08737 0.24144 -0.08099 0.27986 -0.07812 0.29815 C -0.07513 0.31644 -0.07604 0.31227 -0.07018 0.32408 C -0.06432 0.33588 -0.05169 0.35 -0.04297 0.36852 C -0.03437 0.38704 -0.025 0.41574 -0.0181 0.43519 C -0.01146 0.45463 -0.00846 0.46366 -0.00221 0.48519 C 0.00378 0.50671 0.01407 0.54746 0.01823 0.56482 C 0.02227 0.58218 0.02201 0.58496 0.02279 0.58889 " pathEditMode="relative" rAng="0" ptsTypes="AAAAAAAAAAAA">
                                      <p:cBhvr>
                                        <p:cTn id="10" dur="2000" fill="hold"/>
                                        <p:tgtEl>
                                          <p:spTgt spid="7182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3294" y="29444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" fill="hold" nodeType="afterGroup">
                            <p:stCondLst>
                              <p:cond delay="2000"/>
                            </p:stCondLst>
                            <p:childTnLst>
                              <p:par>
                                <p:cTn id="12" presetID="0" presetClass="path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95833E-6 -1.48148E-6 L -0.62591 0.00417 " pathEditMode="relative" rAng="0" ptsTypes="AA">
                                      <p:cBhvr>
                                        <p:cTn id="13" dur="8000" fill="hold"/>
                                        <p:tgtEl>
                                          <p:spTgt spid="7178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31302" y="208"/>
                                    </p:animMotion>
                                  </p:childTnLst>
                                </p:cTn>
                              </p:par>
                              <p:par>
                                <p:cTn id="14" presetID="0" presetClass="pat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6.25E-7 -4.44444E-6 L -0.67865 -0.00439 " pathEditMode="relative" rAng="0" ptsTypes="AA">
                                      <p:cBhvr>
                                        <p:cTn id="15" dur="8000" fill="hold"/>
                                        <p:tgtEl>
                                          <p:spTgt spid="7179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33932" y="-231"/>
                                    </p:animMotion>
                                  </p:childTnLst>
                                </p:cTn>
                              </p:par>
                              <p:par>
                                <p:cTn id="16" presetID="0" presetClass="pat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2.5E-6 -7.40741E-7 L -0.7125 0.00324 " pathEditMode="relative" rAng="0" ptsTypes="AA">
                                      <p:cBhvr>
                                        <p:cTn id="17" dur="8000" fill="hold"/>
                                        <p:tgtEl>
                                          <p:spTgt spid="7179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35625" y="162"/>
                                    </p:animMotion>
                                  </p:childTnLst>
                                </p:cTn>
                              </p:par>
                              <p:par>
                                <p:cTn id="18" presetID="0" presetClass="pat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5156 0.05694 L 0.77031 0.05046 " pathEditMode="relative" rAng="0" ptsTypes="AA">
                                      <p:cBhvr>
                                        <p:cTn id="19" dur="8000" fill="hold"/>
                                        <p:tgtEl>
                                          <p:spTgt spid="718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35938" y="-324"/>
                                    </p:animMotion>
                                  </p:childTnLst>
                                </p:cTn>
                              </p:par>
                              <p:par>
                                <p:cTn id="20" presetID="0" presetClass="path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4.16667E-6 -6.66667E-6 L 0.76285 -6.66667E-6 " pathEditMode="relative" ptsTypes="AA">
                                      <p:cBhvr>
                                        <p:cTn id="21" dur="8000" fill="hold"/>
                                        <p:tgtEl>
                                          <p:spTgt spid="718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2" presetID="0" presetClass="pat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4.16667E-6 1.85185E-6 L 0.6349 1.85185E-6 " pathEditMode="relative" ptsTypes="AA">
                                      <p:cBhvr>
                                        <p:cTn id="23" dur="8000" fill="hold"/>
                                        <p:tgtEl>
                                          <p:spTgt spid="7182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4" presetID="0" presetClass="pat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.27778E-6 3.7037E-7 L 0.70886 -0.00648 " pathEditMode="relative" ptsTypes="AA">
                                      <p:cBhvr>
                                        <p:cTn id="25" dur="8000" fill="hold"/>
                                        <p:tgtEl>
                                          <p:spTgt spid="7182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" fill="hold">
                            <p:stCondLst>
                              <p:cond delay="10000"/>
                            </p:stCondLst>
                            <p:childTnLst>
                              <p:par>
                                <p:cTn id="27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1783" grpId="0" animBg="1"/>
      <p:bldP spid="71795" grpId="0" animBg="1"/>
      <p:bldP spid="71796" grpId="0" animBg="1"/>
      <p:bldP spid="71820" grpId="0" animBg="1"/>
      <p:bldP spid="71821" grpId="0" animBg="1"/>
      <p:bldP spid="71822" grpId="0" animBg="1"/>
      <p:bldP spid="71824" grpId="0" animBg="1"/>
      <p:bldP spid="71825" grpId="0" animBg="1"/>
      <p:bldP spid="71826" grpId="0" animBg="1"/>
      <p:bldP spid="71826" grpId="1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</Words>
  <Application>Microsoft Office PowerPoint</Application>
  <PresentationFormat>Widescreen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Merletti</dc:creator>
  <cp:lastModifiedBy>Roberto Merletti</cp:lastModifiedBy>
  <cp:revision>1</cp:revision>
  <dcterms:created xsi:type="dcterms:W3CDTF">2022-03-09T17:53:21Z</dcterms:created>
  <dcterms:modified xsi:type="dcterms:W3CDTF">2022-03-09T18:00:23Z</dcterms:modified>
</cp:coreProperties>
</file>